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71" d="100"/>
          <a:sy n="71" d="100"/>
        </p:scale>
        <p:origin x="976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76E46-EA6E-460C-A80E-DBD75314AA41}" type="datetimeFigureOut">
              <a:rPr kumimoji="1" lang="ja-JP" altLang="en-US" smtClean="0"/>
              <a:t>2017/9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5409A-BFFE-447A-9316-2A6B0A9045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153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76E46-EA6E-460C-A80E-DBD75314AA41}" type="datetimeFigureOut">
              <a:rPr kumimoji="1" lang="ja-JP" altLang="en-US" smtClean="0"/>
              <a:t>2017/9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5409A-BFFE-447A-9316-2A6B0A9045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8441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76E46-EA6E-460C-A80E-DBD75314AA41}" type="datetimeFigureOut">
              <a:rPr kumimoji="1" lang="ja-JP" altLang="en-US" smtClean="0"/>
              <a:t>2017/9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5409A-BFFE-447A-9316-2A6B0A9045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75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76E46-EA6E-460C-A80E-DBD75314AA41}" type="datetimeFigureOut">
              <a:rPr kumimoji="1" lang="ja-JP" altLang="en-US" smtClean="0"/>
              <a:t>2017/9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5409A-BFFE-447A-9316-2A6B0A9045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34539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76E46-EA6E-460C-A80E-DBD75314AA41}" type="datetimeFigureOut">
              <a:rPr kumimoji="1" lang="ja-JP" altLang="en-US" smtClean="0"/>
              <a:t>2017/9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5409A-BFFE-447A-9316-2A6B0A9045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75531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76E46-EA6E-460C-A80E-DBD75314AA41}" type="datetimeFigureOut">
              <a:rPr kumimoji="1" lang="ja-JP" altLang="en-US" smtClean="0"/>
              <a:t>2017/9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5409A-BFFE-447A-9316-2A6B0A9045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2462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76E46-EA6E-460C-A80E-DBD75314AA41}" type="datetimeFigureOut">
              <a:rPr kumimoji="1" lang="ja-JP" altLang="en-US" smtClean="0"/>
              <a:t>2017/9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5409A-BFFE-447A-9316-2A6B0A9045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52471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76E46-EA6E-460C-A80E-DBD75314AA41}" type="datetimeFigureOut">
              <a:rPr kumimoji="1" lang="ja-JP" altLang="en-US" smtClean="0"/>
              <a:t>2017/9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5409A-BFFE-447A-9316-2A6B0A9045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3020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76E46-EA6E-460C-A80E-DBD75314AA41}" type="datetimeFigureOut">
              <a:rPr kumimoji="1" lang="ja-JP" altLang="en-US" smtClean="0"/>
              <a:t>2017/9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5409A-BFFE-447A-9316-2A6B0A9045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0287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76E46-EA6E-460C-A80E-DBD75314AA41}" type="datetimeFigureOut">
              <a:rPr kumimoji="1" lang="ja-JP" altLang="en-US" smtClean="0"/>
              <a:t>2017/9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5409A-BFFE-447A-9316-2A6B0A9045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0676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76E46-EA6E-460C-A80E-DBD75314AA41}" type="datetimeFigureOut">
              <a:rPr kumimoji="1" lang="ja-JP" altLang="en-US" smtClean="0"/>
              <a:t>2017/9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5409A-BFFE-447A-9316-2A6B0A9045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6880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076E46-EA6E-460C-A80E-DBD75314AA41}" type="datetimeFigureOut">
              <a:rPr kumimoji="1" lang="ja-JP" altLang="en-US" smtClean="0"/>
              <a:t>2017/9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25409A-BFFE-447A-9316-2A6B0A9045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6290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E2E05202-0839-4BFD-A51C-D94520AB2E08}"/>
              </a:ext>
            </a:extLst>
          </p:cNvPr>
          <p:cNvGrpSpPr/>
          <p:nvPr/>
        </p:nvGrpSpPr>
        <p:grpSpPr>
          <a:xfrm>
            <a:off x="574146" y="202254"/>
            <a:ext cx="3401953" cy="3152489"/>
            <a:chOff x="991610" y="825501"/>
            <a:chExt cx="4163003" cy="4154991"/>
          </a:xfrm>
        </p:grpSpPr>
        <p:sp>
          <p:nvSpPr>
            <p:cNvPr id="5" name="Rectangle 5">
              <a:extLst>
                <a:ext uri="{FF2B5EF4-FFF2-40B4-BE49-F238E27FC236}">
                  <a16:creationId xmlns:a16="http://schemas.microsoft.com/office/drawing/2014/main" id="{C9B05EB8-004E-4D55-8FC4-8E8F7808F4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3401" y="4737102"/>
              <a:ext cx="819953" cy="2433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ecificity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ectangle 6">
              <a:extLst>
                <a:ext uri="{FF2B5EF4-FFF2-40B4-BE49-F238E27FC236}">
                  <a16:creationId xmlns:a16="http://schemas.microsoft.com/office/drawing/2014/main" id="{A53FCF25-3A99-4969-948C-2E7CC2F46F3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69370" y="2506389"/>
              <a:ext cx="870458" cy="2259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ensitivity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7">
              <a:extLst>
                <a:ext uri="{FF2B5EF4-FFF2-40B4-BE49-F238E27FC236}">
                  <a16:creationId xmlns:a16="http://schemas.microsoft.com/office/drawing/2014/main" id="{8A0F5BA5-E0B4-4E69-84BD-125597162E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6863" y="825501"/>
              <a:ext cx="3587750" cy="3587750"/>
            </a:xfrm>
            <a:prstGeom prst="rect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Line 8">
              <a:extLst>
                <a:ext uri="{FF2B5EF4-FFF2-40B4-BE49-F238E27FC236}">
                  <a16:creationId xmlns:a16="http://schemas.microsoft.com/office/drawing/2014/main" id="{2E0A8DBB-2DCD-4576-AF18-D8AA7C84FC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66863" y="955676"/>
              <a:ext cx="0" cy="33210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Line 9">
              <a:extLst>
                <a:ext uri="{FF2B5EF4-FFF2-40B4-BE49-F238E27FC236}">
                  <a16:creationId xmlns:a16="http://schemas.microsoft.com/office/drawing/2014/main" id="{4E38CD78-02CB-44A1-BD45-5E9001E544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08126" y="4276726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Line 10">
              <a:extLst>
                <a:ext uri="{FF2B5EF4-FFF2-40B4-BE49-F238E27FC236}">
                  <a16:creationId xmlns:a16="http://schemas.microsoft.com/office/drawing/2014/main" id="{7E5DE4B0-C970-494B-B36E-AC70BFCBDC9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08126" y="3616326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Line 11">
              <a:extLst>
                <a:ext uri="{FF2B5EF4-FFF2-40B4-BE49-F238E27FC236}">
                  <a16:creationId xmlns:a16="http://schemas.microsoft.com/office/drawing/2014/main" id="{55D2F172-EA88-431F-8417-3741A510AF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08126" y="2949576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Line 12">
              <a:extLst>
                <a:ext uri="{FF2B5EF4-FFF2-40B4-BE49-F238E27FC236}">
                  <a16:creationId xmlns:a16="http://schemas.microsoft.com/office/drawing/2014/main" id="{B05D3A9F-EDEA-4783-A95F-D77C6A48A0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08126" y="2289176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Line 13">
              <a:extLst>
                <a:ext uri="{FF2B5EF4-FFF2-40B4-BE49-F238E27FC236}">
                  <a16:creationId xmlns:a16="http://schemas.microsoft.com/office/drawing/2014/main" id="{0E9A345A-1393-44D3-A635-6C056A5A3A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08126" y="1622426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Line 14">
              <a:extLst>
                <a:ext uri="{FF2B5EF4-FFF2-40B4-BE49-F238E27FC236}">
                  <a16:creationId xmlns:a16="http://schemas.microsoft.com/office/drawing/2014/main" id="{B8E2A2EE-49DB-42B5-BA36-F0D86967BC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08126" y="955676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Rectangle 15">
              <a:extLst>
                <a:ext uri="{FF2B5EF4-FFF2-40B4-BE49-F238E27FC236}">
                  <a16:creationId xmlns:a16="http://schemas.microsoft.com/office/drawing/2014/main" id="{6F844591-5B31-486D-B8C6-CC5E06F42E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0313" y="4238626"/>
              <a:ext cx="235393" cy="2433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6">
              <a:extLst>
                <a:ext uri="{FF2B5EF4-FFF2-40B4-BE49-F238E27FC236}">
                  <a16:creationId xmlns:a16="http://schemas.microsoft.com/office/drawing/2014/main" id="{9F9BD5FD-112C-4412-959F-4CCE7EBA88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0313" y="3571876"/>
              <a:ext cx="235393" cy="2433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7">
              <a:extLst>
                <a:ext uri="{FF2B5EF4-FFF2-40B4-BE49-F238E27FC236}">
                  <a16:creationId xmlns:a16="http://schemas.microsoft.com/office/drawing/2014/main" id="{3021FF10-1906-4369-8D19-B9D593FF49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0313" y="2911476"/>
              <a:ext cx="235393" cy="2433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18">
              <a:extLst>
                <a:ext uri="{FF2B5EF4-FFF2-40B4-BE49-F238E27FC236}">
                  <a16:creationId xmlns:a16="http://schemas.microsoft.com/office/drawing/2014/main" id="{AC4AC051-87AB-4A49-AAFF-BAE06BFF78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0313" y="2244726"/>
              <a:ext cx="235393" cy="2433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19">
              <a:extLst>
                <a:ext uri="{FF2B5EF4-FFF2-40B4-BE49-F238E27FC236}">
                  <a16:creationId xmlns:a16="http://schemas.microsoft.com/office/drawing/2014/main" id="{CC028700-8B8F-45AD-A027-C366F30759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0313" y="1576389"/>
              <a:ext cx="235393" cy="2433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20">
              <a:extLst>
                <a:ext uri="{FF2B5EF4-FFF2-40B4-BE49-F238E27FC236}">
                  <a16:creationId xmlns:a16="http://schemas.microsoft.com/office/drawing/2014/main" id="{8CF553EA-5F6B-46CC-AAD6-E3BC8BB604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0313" y="915989"/>
              <a:ext cx="235393" cy="2433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Line 21">
              <a:extLst>
                <a:ext uri="{FF2B5EF4-FFF2-40B4-BE49-F238E27FC236}">
                  <a16:creationId xmlns:a16="http://schemas.microsoft.com/office/drawing/2014/main" id="{B9821188-5DE8-4866-8B96-9DE4C9BC78F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03388" y="4413251"/>
              <a:ext cx="33210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Line 22">
              <a:extLst>
                <a:ext uri="{FF2B5EF4-FFF2-40B4-BE49-F238E27FC236}">
                  <a16:creationId xmlns:a16="http://schemas.microsoft.com/office/drawing/2014/main" id="{EC234C55-F9D5-4994-BE70-7D8F60AADE3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24438" y="4413251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Line 23">
              <a:extLst>
                <a:ext uri="{FF2B5EF4-FFF2-40B4-BE49-F238E27FC236}">
                  <a16:creationId xmlns:a16="http://schemas.microsoft.com/office/drawing/2014/main" id="{2D247F99-D945-46B9-B95E-797412711E1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57688" y="4413251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Line 24">
              <a:extLst>
                <a:ext uri="{FF2B5EF4-FFF2-40B4-BE49-F238E27FC236}">
                  <a16:creationId xmlns:a16="http://schemas.microsoft.com/office/drawing/2014/main" id="{1C5C9176-3C71-4F69-B66C-BA5B9B1F92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90938" y="4413251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Line 25">
              <a:extLst>
                <a:ext uri="{FF2B5EF4-FFF2-40B4-BE49-F238E27FC236}">
                  <a16:creationId xmlns:a16="http://schemas.microsoft.com/office/drawing/2014/main" id="{31C1C80A-269D-4BA2-BB0A-78D760E900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30538" y="4413251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Line 26">
              <a:extLst>
                <a:ext uri="{FF2B5EF4-FFF2-40B4-BE49-F238E27FC236}">
                  <a16:creationId xmlns:a16="http://schemas.microsoft.com/office/drawing/2014/main" id="{900C981B-8235-4B5C-8465-513DECBF2FD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63788" y="4413251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Line 27">
              <a:extLst>
                <a:ext uri="{FF2B5EF4-FFF2-40B4-BE49-F238E27FC236}">
                  <a16:creationId xmlns:a16="http://schemas.microsoft.com/office/drawing/2014/main" id="{507A0B84-54F9-4CCC-9552-D45A276A9C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03388" y="4413251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28">
              <a:extLst>
                <a:ext uri="{FF2B5EF4-FFF2-40B4-BE49-F238E27FC236}">
                  <a16:creationId xmlns:a16="http://schemas.microsoft.com/office/drawing/2014/main" id="{A06C6096-8ECA-4E88-A817-D4AADAD4DF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97026" y="4549776"/>
              <a:ext cx="235393" cy="2433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29">
              <a:extLst>
                <a:ext uri="{FF2B5EF4-FFF2-40B4-BE49-F238E27FC236}">
                  <a16:creationId xmlns:a16="http://schemas.microsoft.com/office/drawing/2014/main" id="{BC3268F1-7BE9-400C-BC98-BD9451A4C2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7426" y="4549776"/>
              <a:ext cx="235393" cy="2433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30">
              <a:extLst>
                <a:ext uri="{FF2B5EF4-FFF2-40B4-BE49-F238E27FC236}">
                  <a16:creationId xmlns:a16="http://schemas.microsoft.com/office/drawing/2014/main" id="{F74F37E2-623B-4306-AD3A-A3C0529471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4176" y="4549776"/>
              <a:ext cx="235393" cy="2433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31">
              <a:extLst>
                <a:ext uri="{FF2B5EF4-FFF2-40B4-BE49-F238E27FC236}">
                  <a16:creationId xmlns:a16="http://schemas.microsoft.com/office/drawing/2014/main" id="{A1B6A827-356F-4AB8-A60A-DD174CA0AC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84576" y="4549776"/>
              <a:ext cx="235393" cy="2433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ectangle 32">
              <a:extLst>
                <a:ext uri="{FF2B5EF4-FFF2-40B4-BE49-F238E27FC236}">
                  <a16:creationId xmlns:a16="http://schemas.microsoft.com/office/drawing/2014/main" id="{91CE8C3E-12D1-49B0-A9BE-DCE1348C3F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51326" y="4549776"/>
              <a:ext cx="235393" cy="2433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33">
              <a:extLst>
                <a:ext uri="{FF2B5EF4-FFF2-40B4-BE49-F238E27FC236}">
                  <a16:creationId xmlns:a16="http://schemas.microsoft.com/office/drawing/2014/main" id="{C58AE3B3-998D-4001-BF09-1A6101E0D4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8076" y="4549776"/>
              <a:ext cx="235393" cy="2433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Freeform 34">
              <a:extLst>
                <a:ext uri="{FF2B5EF4-FFF2-40B4-BE49-F238E27FC236}">
                  <a16:creationId xmlns:a16="http://schemas.microsoft.com/office/drawing/2014/main" id="{4490A62C-AD3D-4787-AE9D-7F40D1180F4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024438" y="825501"/>
              <a:ext cx="0" cy="3581400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Freeform 35">
              <a:extLst>
                <a:ext uri="{FF2B5EF4-FFF2-40B4-BE49-F238E27FC236}">
                  <a16:creationId xmlns:a16="http://schemas.microsoft.com/office/drawing/2014/main" id="{BFCA5C64-1551-48E9-9A3C-A089E90D4F9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687888" y="825501"/>
              <a:ext cx="0" cy="3581400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Freeform 36">
              <a:extLst>
                <a:ext uri="{FF2B5EF4-FFF2-40B4-BE49-F238E27FC236}">
                  <a16:creationId xmlns:a16="http://schemas.microsoft.com/office/drawing/2014/main" id="{A2BDC925-666E-42D1-BC62-D90BE3ED346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357688" y="825501"/>
              <a:ext cx="0" cy="3581400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Freeform 37">
              <a:extLst>
                <a:ext uri="{FF2B5EF4-FFF2-40B4-BE49-F238E27FC236}">
                  <a16:creationId xmlns:a16="http://schemas.microsoft.com/office/drawing/2014/main" id="{C6FE0901-0131-44EA-BEC0-E7FAE5BEA82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027488" y="825501"/>
              <a:ext cx="0" cy="3581400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Freeform 38">
              <a:extLst>
                <a:ext uri="{FF2B5EF4-FFF2-40B4-BE49-F238E27FC236}">
                  <a16:creationId xmlns:a16="http://schemas.microsoft.com/office/drawing/2014/main" id="{64A8577F-19DE-4327-827B-96981A6542D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690938" y="825501"/>
              <a:ext cx="0" cy="3581400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Freeform 39">
              <a:extLst>
                <a:ext uri="{FF2B5EF4-FFF2-40B4-BE49-F238E27FC236}">
                  <a16:creationId xmlns:a16="http://schemas.microsoft.com/office/drawing/2014/main" id="{605613EE-18C1-40BB-B402-1BB2932CE1F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360738" y="825501"/>
              <a:ext cx="0" cy="3581400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Freeform 40">
              <a:extLst>
                <a:ext uri="{FF2B5EF4-FFF2-40B4-BE49-F238E27FC236}">
                  <a16:creationId xmlns:a16="http://schemas.microsoft.com/office/drawing/2014/main" id="{EC8EA0E9-ACE7-49AA-97F1-6A4F31E15F9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030538" y="825501"/>
              <a:ext cx="0" cy="3581400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Freeform 41">
              <a:extLst>
                <a:ext uri="{FF2B5EF4-FFF2-40B4-BE49-F238E27FC236}">
                  <a16:creationId xmlns:a16="http://schemas.microsoft.com/office/drawing/2014/main" id="{C4B688C2-9DCF-40EE-800A-3AB41ABF76F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700338" y="825501"/>
              <a:ext cx="0" cy="3581400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Freeform 42">
              <a:extLst>
                <a:ext uri="{FF2B5EF4-FFF2-40B4-BE49-F238E27FC236}">
                  <a16:creationId xmlns:a16="http://schemas.microsoft.com/office/drawing/2014/main" id="{FBCE7252-166E-41A0-AE0D-4C9F9AB0F34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363788" y="825501"/>
              <a:ext cx="0" cy="3581400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Freeform 43">
              <a:extLst>
                <a:ext uri="{FF2B5EF4-FFF2-40B4-BE49-F238E27FC236}">
                  <a16:creationId xmlns:a16="http://schemas.microsoft.com/office/drawing/2014/main" id="{DF965DB5-9576-4E59-B031-49FE2BC19BF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033588" y="825501"/>
              <a:ext cx="0" cy="3581400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Freeform 44">
              <a:extLst>
                <a:ext uri="{FF2B5EF4-FFF2-40B4-BE49-F238E27FC236}">
                  <a16:creationId xmlns:a16="http://schemas.microsoft.com/office/drawing/2014/main" id="{E7420677-6478-45D7-95BB-1FF3B223D30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703388" y="825501"/>
              <a:ext cx="0" cy="3581400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Freeform 45">
              <a:extLst>
                <a:ext uri="{FF2B5EF4-FFF2-40B4-BE49-F238E27FC236}">
                  <a16:creationId xmlns:a16="http://schemas.microsoft.com/office/drawing/2014/main" id="{BE937E08-BB1F-4093-9AE3-AA1C15AEEB4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73213" y="4276726"/>
              <a:ext cx="358140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Freeform 46">
              <a:extLst>
                <a:ext uri="{FF2B5EF4-FFF2-40B4-BE49-F238E27FC236}">
                  <a16:creationId xmlns:a16="http://schemas.microsoft.com/office/drawing/2014/main" id="{B2467CB3-260E-4041-851C-6283DAD3482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73213" y="3946526"/>
              <a:ext cx="358140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Freeform 47">
              <a:extLst>
                <a:ext uri="{FF2B5EF4-FFF2-40B4-BE49-F238E27FC236}">
                  <a16:creationId xmlns:a16="http://schemas.microsoft.com/office/drawing/2014/main" id="{936CDD5D-6177-4D7C-849F-73807CA9676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73213" y="3616326"/>
              <a:ext cx="358140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Freeform 48">
              <a:extLst>
                <a:ext uri="{FF2B5EF4-FFF2-40B4-BE49-F238E27FC236}">
                  <a16:creationId xmlns:a16="http://schemas.microsoft.com/office/drawing/2014/main" id="{12BBA14A-3B1B-4428-9099-194B2EB6D0C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73213" y="3279776"/>
              <a:ext cx="358140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Freeform 49">
              <a:extLst>
                <a:ext uri="{FF2B5EF4-FFF2-40B4-BE49-F238E27FC236}">
                  <a16:creationId xmlns:a16="http://schemas.microsoft.com/office/drawing/2014/main" id="{1B0E6769-6114-4CAB-AD3E-F5FABD0BAE2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73213" y="2949576"/>
              <a:ext cx="358140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Freeform 50">
              <a:extLst>
                <a:ext uri="{FF2B5EF4-FFF2-40B4-BE49-F238E27FC236}">
                  <a16:creationId xmlns:a16="http://schemas.microsoft.com/office/drawing/2014/main" id="{F39C2D84-8C53-46E8-AFB9-3FFEE44D512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73213" y="2619376"/>
              <a:ext cx="358140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Freeform 51">
              <a:extLst>
                <a:ext uri="{FF2B5EF4-FFF2-40B4-BE49-F238E27FC236}">
                  <a16:creationId xmlns:a16="http://schemas.microsoft.com/office/drawing/2014/main" id="{AD17FE9B-9C7C-4552-ACC6-BE950BFFB0C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73213" y="2289176"/>
              <a:ext cx="358140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Freeform 52">
              <a:extLst>
                <a:ext uri="{FF2B5EF4-FFF2-40B4-BE49-F238E27FC236}">
                  <a16:creationId xmlns:a16="http://schemas.microsoft.com/office/drawing/2014/main" id="{59E3B682-9AEB-4DD3-834A-DB66A1CD5C6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73213" y="1952626"/>
              <a:ext cx="358140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Freeform 53">
              <a:extLst>
                <a:ext uri="{FF2B5EF4-FFF2-40B4-BE49-F238E27FC236}">
                  <a16:creationId xmlns:a16="http://schemas.microsoft.com/office/drawing/2014/main" id="{8877B764-D87C-4424-B8A5-D0714E2B7F4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73213" y="1622426"/>
              <a:ext cx="358140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Freeform 54">
              <a:extLst>
                <a:ext uri="{FF2B5EF4-FFF2-40B4-BE49-F238E27FC236}">
                  <a16:creationId xmlns:a16="http://schemas.microsoft.com/office/drawing/2014/main" id="{EEBFC92D-B879-451E-8418-F235CE94ACE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73213" y="1292226"/>
              <a:ext cx="358140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Freeform 55">
              <a:extLst>
                <a:ext uri="{FF2B5EF4-FFF2-40B4-BE49-F238E27FC236}">
                  <a16:creationId xmlns:a16="http://schemas.microsoft.com/office/drawing/2014/main" id="{9C0E4EFD-C772-4F16-ABC6-0EF033A7573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573213" y="955676"/>
              <a:ext cx="358140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Line 56">
              <a:extLst>
                <a:ext uri="{FF2B5EF4-FFF2-40B4-BE49-F238E27FC236}">
                  <a16:creationId xmlns:a16="http://schemas.microsoft.com/office/drawing/2014/main" id="{B080F991-20BB-475A-8C26-A0CA079024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66863" y="825501"/>
              <a:ext cx="3587750" cy="3587750"/>
            </a:xfrm>
            <a:prstGeom prst="line">
              <a:avLst/>
            </a:prstGeom>
            <a:noFill/>
            <a:ln w="6350" cap="rnd">
              <a:solidFill>
                <a:srgbClr val="A9A9A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Freeform 57">
              <a:extLst>
                <a:ext uri="{FF2B5EF4-FFF2-40B4-BE49-F238E27FC236}">
                  <a16:creationId xmlns:a16="http://schemas.microsoft.com/office/drawing/2014/main" id="{0719F0AB-9006-41B6-81B3-482FB284DD83}"/>
                </a:ext>
              </a:extLst>
            </p:cNvPr>
            <p:cNvSpPr>
              <a:spLocks/>
            </p:cNvSpPr>
            <p:nvPr/>
          </p:nvSpPr>
          <p:spPr bwMode="auto">
            <a:xfrm>
              <a:off x="1703388" y="955676"/>
              <a:ext cx="3321050" cy="3321050"/>
            </a:xfrm>
            <a:custGeom>
              <a:avLst/>
              <a:gdLst>
                <a:gd name="T0" fmla="*/ 513 w 513"/>
                <a:gd name="T1" fmla="*/ 0 h 513"/>
                <a:gd name="T2" fmla="*/ 445 w 513"/>
                <a:gd name="T3" fmla="*/ 0 h 513"/>
                <a:gd name="T4" fmla="*/ 391 w 513"/>
                <a:gd name="T5" fmla="*/ 0 h 513"/>
                <a:gd name="T6" fmla="*/ 378 w 513"/>
                <a:gd name="T7" fmla="*/ 0 h 513"/>
                <a:gd name="T8" fmla="*/ 351 w 513"/>
                <a:gd name="T9" fmla="*/ 21 h 513"/>
                <a:gd name="T10" fmla="*/ 324 w 513"/>
                <a:gd name="T11" fmla="*/ 21 h 513"/>
                <a:gd name="T12" fmla="*/ 297 w 513"/>
                <a:gd name="T13" fmla="*/ 21 h 513"/>
                <a:gd name="T14" fmla="*/ 243 w 513"/>
                <a:gd name="T15" fmla="*/ 41 h 513"/>
                <a:gd name="T16" fmla="*/ 202 w 513"/>
                <a:gd name="T17" fmla="*/ 82 h 513"/>
                <a:gd name="T18" fmla="*/ 148 w 513"/>
                <a:gd name="T19" fmla="*/ 82 h 513"/>
                <a:gd name="T20" fmla="*/ 148 w 513"/>
                <a:gd name="T21" fmla="*/ 103 h 513"/>
                <a:gd name="T22" fmla="*/ 94 w 513"/>
                <a:gd name="T23" fmla="*/ 144 h 513"/>
                <a:gd name="T24" fmla="*/ 94 w 513"/>
                <a:gd name="T25" fmla="*/ 206 h 513"/>
                <a:gd name="T26" fmla="*/ 67 w 513"/>
                <a:gd name="T27" fmla="*/ 206 h 513"/>
                <a:gd name="T28" fmla="*/ 40 w 513"/>
                <a:gd name="T29" fmla="*/ 206 h 513"/>
                <a:gd name="T30" fmla="*/ 27 w 513"/>
                <a:gd name="T31" fmla="*/ 247 h 513"/>
                <a:gd name="T32" fmla="*/ 0 w 513"/>
                <a:gd name="T33" fmla="*/ 267 h 513"/>
                <a:gd name="T34" fmla="*/ 0 w 513"/>
                <a:gd name="T35" fmla="*/ 288 h 513"/>
                <a:gd name="T36" fmla="*/ 0 w 513"/>
                <a:gd name="T37" fmla="*/ 390 h 513"/>
                <a:gd name="T38" fmla="*/ 0 w 513"/>
                <a:gd name="T39" fmla="*/ 411 h 513"/>
                <a:gd name="T40" fmla="*/ 0 w 513"/>
                <a:gd name="T41" fmla="*/ 431 h 513"/>
                <a:gd name="T42" fmla="*/ 0 w 513"/>
                <a:gd name="T43" fmla="*/ 452 h 513"/>
                <a:gd name="T44" fmla="*/ 0 w 513"/>
                <a:gd name="T45" fmla="*/ 513 h 5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</a:cxnLst>
              <a:rect l="0" t="0" r="r" b="b"/>
              <a:pathLst>
                <a:path w="513" h="513">
                  <a:moveTo>
                    <a:pt x="513" y="0"/>
                  </a:moveTo>
                  <a:lnTo>
                    <a:pt x="445" y="0"/>
                  </a:lnTo>
                  <a:lnTo>
                    <a:pt x="391" y="0"/>
                  </a:lnTo>
                  <a:lnTo>
                    <a:pt x="378" y="0"/>
                  </a:lnTo>
                  <a:lnTo>
                    <a:pt x="351" y="21"/>
                  </a:lnTo>
                  <a:lnTo>
                    <a:pt x="324" y="21"/>
                  </a:lnTo>
                  <a:lnTo>
                    <a:pt x="297" y="21"/>
                  </a:lnTo>
                  <a:lnTo>
                    <a:pt x="243" y="41"/>
                  </a:lnTo>
                  <a:lnTo>
                    <a:pt x="202" y="82"/>
                  </a:lnTo>
                  <a:lnTo>
                    <a:pt x="148" y="82"/>
                  </a:lnTo>
                  <a:lnTo>
                    <a:pt x="148" y="103"/>
                  </a:lnTo>
                  <a:lnTo>
                    <a:pt x="94" y="144"/>
                  </a:lnTo>
                  <a:lnTo>
                    <a:pt x="94" y="206"/>
                  </a:lnTo>
                  <a:lnTo>
                    <a:pt x="67" y="206"/>
                  </a:lnTo>
                  <a:lnTo>
                    <a:pt x="40" y="206"/>
                  </a:lnTo>
                  <a:lnTo>
                    <a:pt x="27" y="247"/>
                  </a:lnTo>
                  <a:lnTo>
                    <a:pt x="0" y="267"/>
                  </a:lnTo>
                  <a:lnTo>
                    <a:pt x="0" y="288"/>
                  </a:lnTo>
                  <a:lnTo>
                    <a:pt x="0" y="390"/>
                  </a:lnTo>
                  <a:lnTo>
                    <a:pt x="0" y="411"/>
                  </a:lnTo>
                  <a:lnTo>
                    <a:pt x="0" y="431"/>
                  </a:lnTo>
                  <a:lnTo>
                    <a:pt x="0" y="452"/>
                  </a:lnTo>
                  <a:lnTo>
                    <a:pt x="0" y="513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Rectangle 58">
              <a:extLst>
                <a:ext uri="{FF2B5EF4-FFF2-40B4-BE49-F238E27FC236}">
                  <a16:creationId xmlns:a16="http://schemas.microsoft.com/office/drawing/2014/main" id="{A97751A7-6BEE-4C50-AAC7-AAC081D0FC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4301" y="1473201"/>
              <a:ext cx="20638" cy="63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Rectangle 59">
              <a:extLst>
                <a:ext uri="{FF2B5EF4-FFF2-40B4-BE49-F238E27FC236}">
                  <a16:creationId xmlns:a16="http://schemas.microsoft.com/office/drawing/2014/main" id="{AEBA8228-C8CC-4E3B-9DC2-1F4C82A971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4301" y="1498601"/>
              <a:ext cx="20638" cy="63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Rectangle 60">
              <a:extLst>
                <a:ext uri="{FF2B5EF4-FFF2-40B4-BE49-F238E27FC236}">
                  <a16:creationId xmlns:a16="http://schemas.microsoft.com/office/drawing/2014/main" id="{E3722162-0236-4C93-BF3D-EC24F2B41E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7951" y="1479551"/>
              <a:ext cx="33338" cy="63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Rectangle 61">
              <a:extLst>
                <a:ext uri="{FF2B5EF4-FFF2-40B4-BE49-F238E27FC236}">
                  <a16:creationId xmlns:a16="http://schemas.microsoft.com/office/drawing/2014/main" id="{6F22A3FB-2988-4F80-81B8-50C65E6987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7951" y="1492251"/>
              <a:ext cx="33338" cy="63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Rectangle 62">
              <a:extLst>
                <a:ext uri="{FF2B5EF4-FFF2-40B4-BE49-F238E27FC236}">
                  <a16:creationId xmlns:a16="http://schemas.microsoft.com/office/drawing/2014/main" id="{FFA448CB-68AA-43F1-8F3B-5816B67E64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7951" y="1485901"/>
              <a:ext cx="33338" cy="63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Rectangle 63">
              <a:extLst>
                <a:ext uri="{FF2B5EF4-FFF2-40B4-BE49-F238E27FC236}">
                  <a16:creationId xmlns:a16="http://schemas.microsoft.com/office/drawing/2014/main" id="{7F8E2A44-D1E2-42FE-B31C-C03749C68C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7951" y="1485901"/>
              <a:ext cx="33338" cy="63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Oval 64">
              <a:extLst>
                <a:ext uri="{FF2B5EF4-FFF2-40B4-BE49-F238E27FC236}">
                  <a16:creationId xmlns:a16="http://schemas.microsoft.com/office/drawing/2014/main" id="{4D27DFB2-2857-4F3D-BB6A-AA83E58B32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7951" y="1473201"/>
              <a:ext cx="26988" cy="25400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Rectangle 65">
              <a:extLst>
                <a:ext uri="{FF2B5EF4-FFF2-40B4-BE49-F238E27FC236}">
                  <a16:creationId xmlns:a16="http://schemas.microsoft.com/office/drawing/2014/main" id="{1E9B61C3-6308-461A-8805-9EA5D9778B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6688" y="1512889"/>
              <a:ext cx="1530920" cy="2433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.100 (0.711, 0.840)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6" name="グループ化 65">
            <a:extLst>
              <a:ext uri="{FF2B5EF4-FFF2-40B4-BE49-F238E27FC236}">
                <a16:creationId xmlns:a16="http://schemas.microsoft.com/office/drawing/2014/main" id="{F24CE482-90C4-4BAD-889D-A0EE962583B6}"/>
              </a:ext>
            </a:extLst>
          </p:cNvPr>
          <p:cNvGrpSpPr/>
          <p:nvPr/>
        </p:nvGrpSpPr>
        <p:grpSpPr>
          <a:xfrm>
            <a:off x="4448618" y="204588"/>
            <a:ext cx="3639228" cy="3177150"/>
            <a:chOff x="6623804" y="1071563"/>
            <a:chExt cx="4424385" cy="3749441"/>
          </a:xfrm>
        </p:grpSpPr>
        <p:sp>
          <p:nvSpPr>
            <p:cNvPr id="67" name="Rectangle 129">
              <a:extLst>
                <a:ext uri="{FF2B5EF4-FFF2-40B4-BE49-F238E27FC236}">
                  <a16:creationId xmlns:a16="http://schemas.microsoft.com/office/drawing/2014/main" id="{F9506E39-3688-4129-9479-D6B4895A7F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83636" y="4024152"/>
              <a:ext cx="802925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ensitivity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Freeform 69">
              <a:extLst>
                <a:ext uri="{FF2B5EF4-FFF2-40B4-BE49-F238E27FC236}">
                  <a16:creationId xmlns:a16="http://schemas.microsoft.com/office/drawing/2014/main" id="{CC0BE053-B3C2-42D6-8AAA-F79F1D51898E}"/>
                </a:ext>
              </a:extLst>
            </p:cNvPr>
            <p:cNvSpPr>
              <a:spLocks/>
            </p:cNvSpPr>
            <p:nvPr/>
          </p:nvSpPr>
          <p:spPr bwMode="auto">
            <a:xfrm>
              <a:off x="7392988" y="1195388"/>
              <a:ext cx="3322637" cy="2614613"/>
            </a:xfrm>
            <a:custGeom>
              <a:avLst/>
              <a:gdLst>
                <a:gd name="T0" fmla="*/ 513 w 513"/>
                <a:gd name="T1" fmla="*/ 0 h 404"/>
                <a:gd name="T2" fmla="*/ 473 w 513"/>
                <a:gd name="T3" fmla="*/ 0 h 404"/>
                <a:gd name="T4" fmla="*/ 453 w 513"/>
                <a:gd name="T5" fmla="*/ 0 h 404"/>
                <a:gd name="T6" fmla="*/ 414 w 513"/>
                <a:gd name="T7" fmla="*/ 0 h 404"/>
                <a:gd name="T8" fmla="*/ 394 w 513"/>
                <a:gd name="T9" fmla="*/ 18 h 404"/>
                <a:gd name="T10" fmla="*/ 375 w 513"/>
                <a:gd name="T11" fmla="*/ 18 h 404"/>
                <a:gd name="T12" fmla="*/ 355 w 513"/>
                <a:gd name="T13" fmla="*/ 18 h 404"/>
                <a:gd name="T14" fmla="*/ 335 w 513"/>
                <a:gd name="T15" fmla="*/ 36 h 404"/>
                <a:gd name="T16" fmla="*/ 315 w 513"/>
                <a:gd name="T17" fmla="*/ 73 h 404"/>
                <a:gd name="T18" fmla="*/ 296 w 513"/>
                <a:gd name="T19" fmla="*/ 73 h 404"/>
                <a:gd name="T20" fmla="*/ 276 w 513"/>
                <a:gd name="T21" fmla="*/ 92 h 404"/>
                <a:gd name="T22" fmla="*/ 256 w 513"/>
                <a:gd name="T23" fmla="*/ 128 h 404"/>
                <a:gd name="T24" fmla="*/ 236 w 513"/>
                <a:gd name="T25" fmla="*/ 183 h 404"/>
                <a:gd name="T26" fmla="*/ 217 w 513"/>
                <a:gd name="T27" fmla="*/ 183 h 404"/>
                <a:gd name="T28" fmla="*/ 197 w 513"/>
                <a:gd name="T29" fmla="*/ 183 h 404"/>
                <a:gd name="T30" fmla="*/ 177 w 513"/>
                <a:gd name="T31" fmla="*/ 220 h 404"/>
                <a:gd name="T32" fmla="*/ 158 w 513"/>
                <a:gd name="T33" fmla="*/ 239 h 404"/>
                <a:gd name="T34" fmla="*/ 138 w 513"/>
                <a:gd name="T35" fmla="*/ 257 h 404"/>
                <a:gd name="T36" fmla="*/ 98 w 513"/>
                <a:gd name="T37" fmla="*/ 349 h 404"/>
                <a:gd name="T38" fmla="*/ 79 w 513"/>
                <a:gd name="T39" fmla="*/ 367 h 404"/>
                <a:gd name="T40" fmla="*/ 59 w 513"/>
                <a:gd name="T41" fmla="*/ 386 h 404"/>
                <a:gd name="T42" fmla="*/ 0 w 513"/>
                <a:gd name="T43" fmla="*/ 404 h 4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513" h="404">
                  <a:moveTo>
                    <a:pt x="513" y="0"/>
                  </a:moveTo>
                  <a:lnTo>
                    <a:pt x="473" y="0"/>
                  </a:lnTo>
                  <a:lnTo>
                    <a:pt x="453" y="0"/>
                  </a:lnTo>
                  <a:lnTo>
                    <a:pt x="414" y="0"/>
                  </a:lnTo>
                  <a:lnTo>
                    <a:pt x="394" y="18"/>
                  </a:lnTo>
                  <a:lnTo>
                    <a:pt x="375" y="18"/>
                  </a:lnTo>
                  <a:lnTo>
                    <a:pt x="355" y="18"/>
                  </a:lnTo>
                  <a:lnTo>
                    <a:pt x="335" y="36"/>
                  </a:lnTo>
                  <a:lnTo>
                    <a:pt x="315" y="73"/>
                  </a:lnTo>
                  <a:lnTo>
                    <a:pt x="296" y="73"/>
                  </a:lnTo>
                  <a:lnTo>
                    <a:pt x="276" y="92"/>
                  </a:lnTo>
                  <a:lnTo>
                    <a:pt x="256" y="128"/>
                  </a:lnTo>
                  <a:lnTo>
                    <a:pt x="236" y="183"/>
                  </a:lnTo>
                  <a:lnTo>
                    <a:pt x="217" y="183"/>
                  </a:lnTo>
                  <a:lnTo>
                    <a:pt x="197" y="183"/>
                  </a:lnTo>
                  <a:lnTo>
                    <a:pt x="177" y="220"/>
                  </a:lnTo>
                  <a:lnTo>
                    <a:pt x="158" y="239"/>
                  </a:lnTo>
                  <a:lnTo>
                    <a:pt x="138" y="257"/>
                  </a:lnTo>
                  <a:lnTo>
                    <a:pt x="98" y="349"/>
                  </a:lnTo>
                  <a:lnTo>
                    <a:pt x="79" y="367"/>
                  </a:lnTo>
                  <a:lnTo>
                    <a:pt x="59" y="386"/>
                  </a:lnTo>
                  <a:lnTo>
                    <a:pt x="0" y="404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Line 70">
              <a:extLst>
                <a:ext uri="{FF2B5EF4-FFF2-40B4-BE49-F238E27FC236}">
                  <a16:creationId xmlns:a16="http://schemas.microsoft.com/office/drawing/2014/main" id="{A5E8217E-ADA7-47B4-B3EA-7B43765F51A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62813" y="4289426"/>
              <a:ext cx="31940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Line 71">
              <a:extLst>
                <a:ext uri="{FF2B5EF4-FFF2-40B4-BE49-F238E27FC236}">
                  <a16:creationId xmlns:a16="http://schemas.microsoft.com/office/drawing/2014/main" id="{26F03ECD-FAAC-4A88-AD19-EDF92C86BB7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62813" y="4289426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Line 72">
              <a:extLst>
                <a:ext uri="{FF2B5EF4-FFF2-40B4-BE49-F238E27FC236}">
                  <a16:creationId xmlns:a16="http://schemas.microsoft.com/office/drawing/2014/main" id="{CF58DB14-697F-4EDF-ABC4-57499DE078A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04163" y="4289426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Line 73">
              <a:extLst>
                <a:ext uri="{FF2B5EF4-FFF2-40B4-BE49-F238E27FC236}">
                  <a16:creationId xmlns:a16="http://schemas.microsoft.com/office/drawing/2014/main" id="{A2E023A6-9AA6-44D0-BED4-63C52E4F13D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539163" y="4289426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Line 74">
              <a:extLst>
                <a:ext uri="{FF2B5EF4-FFF2-40B4-BE49-F238E27FC236}">
                  <a16:creationId xmlns:a16="http://schemas.microsoft.com/office/drawing/2014/main" id="{987BD241-97FE-4E10-AE99-77A86F39C8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180513" y="4289426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Line 75">
              <a:extLst>
                <a:ext uri="{FF2B5EF4-FFF2-40B4-BE49-F238E27FC236}">
                  <a16:creationId xmlns:a16="http://schemas.microsoft.com/office/drawing/2014/main" id="{0FC321E8-B9B6-407E-BD4C-CB8AD47D71C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821863" y="4289426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Line 76">
              <a:extLst>
                <a:ext uri="{FF2B5EF4-FFF2-40B4-BE49-F238E27FC236}">
                  <a16:creationId xmlns:a16="http://schemas.microsoft.com/office/drawing/2014/main" id="{9CCF3EF1-BD03-4B73-9370-4D3075DFA96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56863" y="4289426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Rectangle 77">
              <a:extLst>
                <a:ext uri="{FF2B5EF4-FFF2-40B4-BE49-F238E27FC236}">
                  <a16:creationId xmlns:a16="http://schemas.microsoft.com/office/drawing/2014/main" id="{B74460C0-3DE3-45E5-975F-3A00CA953A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56450" y="4425951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Rectangle 78">
              <a:extLst>
                <a:ext uri="{FF2B5EF4-FFF2-40B4-BE49-F238E27FC236}">
                  <a16:creationId xmlns:a16="http://schemas.microsoft.com/office/drawing/2014/main" id="{5CB53C0B-2763-480F-8C26-FCF0396CBF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97800" y="4425951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Rectangle 79">
              <a:extLst>
                <a:ext uri="{FF2B5EF4-FFF2-40B4-BE49-F238E27FC236}">
                  <a16:creationId xmlns:a16="http://schemas.microsoft.com/office/drawing/2014/main" id="{24DF80C5-7C95-44B4-9FB1-FD6AA6CFF5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32800" y="4425951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.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Rectangle 80">
              <a:extLst>
                <a:ext uri="{FF2B5EF4-FFF2-40B4-BE49-F238E27FC236}">
                  <a16:creationId xmlns:a16="http://schemas.microsoft.com/office/drawing/2014/main" id="{82F8673B-12D9-4EDB-A68F-B752D77FFC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74151" y="4425951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Rectangle 81">
              <a:extLst>
                <a:ext uri="{FF2B5EF4-FFF2-40B4-BE49-F238E27FC236}">
                  <a16:creationId xmlns:a16="http://schemas.microsoft.com/office/drawing/2014/main" id="{193C1574-2A9E-4B34-ACC5-A715EA3247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15500" y="4425951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.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Rectangle 82">
              <a:extLst>
                <a:ext uri="{FF2B5EF4-FFF2-40B4-BE49-F238E27FC236}">
                  <a16:creationId xmlns:a16="http://schemas.microsoft.com/office/drawing/2014/main" id="{0FC559DF-00E0-4616-A7CA-1585E42C6C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50500" y="4425951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Line 83">
              <a:extLst>
                <a:ext uri="{FF2B5EF4-FFF2-40B4-BE49-F238E27FC236}">
                  <a16:creationId xmlns:a16="http://schemas.microsoft.com/office/drawing/2014/main" id="{ED71C257-5E0D-4F8D-91C7-12F4A513D2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256463" y="1195388"/>
              <a:ext cx="0" cy="297180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Line 84">
              <a:extLst>
                <a:ext uri="{FF2B5EF4-FFF2-40B4-BE49-F238E27FC236}">
                  <a16:creationId xmlns:a16="http://schemas.microsoft.com/office/drawing/2014/main" id="{06C0BAA0-821C-4402-845C-C4C8ED6F1D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199313" y="4167188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Line 85">
              <a:extLst>
                <a:ext uri="{FF2B5EF4-FFF2-40B4-BE49-F238E27FC236}">
                  <a16:creationId xmlns:a16="http://schemas.microsoft.com/office/drawing/2014/main" id="{3B1C8B96-F1B2-4FEF-AF1D-2338773F95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199313" y="3571876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Line 86">
              <a:extLst>
                <a:ext uri="{FF2B5EF4-FFF2-40B4-BE49-F238E27FC236}">
                  <a16:creationId xmlns:a16="http://schemas.microsoft.com/office/drawing/2014/main" id="{8D53C61F-91BC-443F-A2A7-A2CCFC7FF02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199313" y="2974976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Line 87">
              <a:extLst>
                <a:ext uri="{FF2B5EF4-FFF2-40B4-BE49-F238E27FC236}">
                  <a16:creationId xmlns:a16="http://schemas.microsoft.com/office/drawing/2014/main" id="{4A79352B-61FE-4C41-9769-9EBFD68AC3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199313" y="2379663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Line 88">
              <a:extLst>
                <a:ext uri="{FF2B5EF4-FFF2-40B4-BE49-F238E27FC236}">
                  <a16:creationId xmlns:a16="http://schemas.microsoft.com/office/drawing/2014/main" id="{AE6B8806-319C-415B-8444-1E2D01CD66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199313" y="1790701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Line 89">
              <a:extLst>
                <a:ext uri="{FF2B5EF4-FFF2-40B4-BE49-F238E27FC236}">
                  <a16:creationId xmlns:a16="http://schemas.microsoft.com/office/drawing/2014/main" id="{F5B135D2-44E2-447F-BD35-4306B17E17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199313" y="1195388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Rectangle 90">
              <a:extLst>
                <a:ext uri="{FF2B5EF4-FFF2-40B4-BE49-F238E27FC236}">
                  <a16:creationId xmlns:a16="http://schemas.microsoft.com/office/drawing/2014/main" id="{04EF9EC3-2657-414C-990E-5FE1FD1604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19912" y="4127501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Rectangle 91">
              <a:extLst>
                <a:ext uri="{FF2B5EF4-FFF2-40B4-BE49-F238E27FC236}">
                  <a16:creationId xmlns:a16="http://schemas.microsoft.com/office/drawing/2014/main" id="{F5B09795-58F9-4C0B-A4A3-C7B35623AB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19912" y="3532188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Rectangle 92">
              <a:extLst>
                <a:ext uri="{FF2B5EF4-FFF2-40B4-BE49-F238E27FC236}">
                  <a16:creationId xmlns:a16="http://schemas.microsoft.com/office/drawing/2014/main" id="{277B25F5-F631-416E-B8B9-2816219F82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19912" y="2936876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Rectangle 93">
              <a:extLst>
                <a:ext uri="{FF2B5EF4-FFF2-40B4-BE49-F238E27FC236}">
                  <a16:creationId xmlns:a16="http://schemas.microsoft.com/office/drawing/2014/main" id="{6F4D2669-002B-4238-9777-2F53224699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19912" y="2341563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Rectangle 94">
              <a:extLst>
                <a:ext uri="{FF2B5EF4-FFF2-40B4-BE49-F238E27FC236}">
                  <a16:creationId xmlns:a16="http://schemas.microsoft.com/office/drawing/2014/main" id="{0A2CD5EC-F4A9-4973-AEC0-59C3D4D2DF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19912" y="1744663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Rectangle 95">
              <a:extLst>
                <a:ext uri="{FF2B5EF4-FFF2-40B4-BE49-F238E27FC236}">
                  <a16:creationId xmlns:a16="http://schemas.microsoft.com/office/drawing/2014/main" id="{2DE76F3B-AFD9-4001-AFAF-5C384F7730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19912" y="1149351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Rectangle 96">
              <a:extLst>
                <a:ext uri="{FF2B5EF4-FFF2-40B4-BE49-F238E27FC236}">
                  <a16:creationId xmlns:a16="http://schemas.microsoft.com/office/drawing/2014/main" id="{B1B9B39F-8B51-4919-B431-49204CFA6C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56463" y="1071563"/>
              <a:ext cx="3589337" cy="3217863"/>
            </a:xfrm>
            <a:prstGeom prst="rect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Rectangle 97">
              <a:extLst>
                <a:ext uri="{FF2B5EF4-FFF2-40B4-BE49-F238E27FC236}">
                  <a16:creationId xmlns:a16="http://schemas.microsoft.com/office/drawing/2014/main" id="{F1AE436F-6427-47B1-8F77-34FDE5D2C4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88616" y="4603075"/>
              <a:ext cx="76005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hreshold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Rectangle 98">
              <a:extLst>
                <a:ext uri="{FF2B5EF4-FFF2-40B4-BE49-F238E27FC236}">
                  <a16:creationId xmlns:a16="http://schemas.microsoft.com/office/drawing/2014/main" id="{8D40227D-BE15-4BC3-B3A2-30F5257BAEC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925444" y="2687110"/>
              <a:ext cx="1621228" cy="2245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ensitivity/Specificity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Freeform 99">
              <a:extLst>
                <a:ext uri="{FF2B5EF4-FFF2-40B4-BE49-F238E27FC236}">
                  <a16:creationId xmlns:a16="http://schemas.microsoft.com/office/drawing/2014/main" id="{E5D19E90-4E53-484A-832A-060E5CD87CD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392988" y="1195388"/>
              <a:ext cx="3303587" cy="2946400"/>
            </a:xfrm>
            <a:custGeom>
              <a:avLst/>
              <a:gdLst>
                <a:gd name="T0" fmla="*/ 505 w 510"/>
                <a:gd name="T1" fmla="*/ 447 h 455"/>
                <a:gd name="T2" fmla="*/ 497 w 510"/>
                <a:gd name="T3" fmla="*/ 435 h 455"/>
                <a:gd name="T4" fmla="*/ 489 w 510"/>
                <a:gd name="T5" fmla="*/ 423 h 455"/>
                <a:gd name="T6" fmla="*/ 481 w 510"/>
                <a:gd name="T7" fmla="*/ 411 h 455"/>
                <a:gd name="T8" fmla="*/ 473 w 510"/>
                <a:gd name="T9" fmla="*/ 399 h 455"/>
                <a:gd name="T10" fmla="*/ 469 w 510"/>
                <a:gd name="T11" fmla="*/ 390 h 455"/>
                <a:gd name="T12" fmla="*/ 464 w 510"/>
                <a:gd name="T13" fmla="*/ 378 h 455"/>
                <a:gd name="T14" fmla="*/ 460 w 510"/>
                <a:gd name="T15" fmla="*/ 366 h 455"/>
                <a:gd name="T16" fmla="*/ 455 w 510"/>
                <a:gd name="T17" fmla="*/ 354 h 455"/>
                <a:gd name="T18" fmla="*/ 449 w 510"/>
                <a:gd name="T19" fmla="*/ 349 h 455"/>
                <a:gd name="T20" fmla="*/ 437 w 510"/>
                <a:gd name="T21" fmla="*/ 345 h 455"/>
                <a:gd name="T22" fmla="*/ 425 w 510"/>
                <a:gd name="T23" fmla="*/ 341 h 455"/>
                <a:gd name="T24" fmla="*/ 414 w 510"/>
                <a:gd name="T25" fmla="*/ 338 h 455"/>
                <a:gd name="T26" fmla="*/ 408 w 510"/>
                <a:gd name="T27" fmla="*/ 331 h 455"/>
                <a:gd name="T28" fmla="*/ 399 w 510"/>
                <a:gd name="T29" fmla="*/ 320 h 455"/>
                <a:gd name="T30" fmla="*/ 390 w 510"/>
                <a:gd name="T31" fmla="*/ 309 h 455"/>
                <a:gd name="T32" fmla="*/ 381 w 510"/>
                <a:gd name="T33" fmla="*/ 298 h 455"/>
                <a:gd name="T34" fmla="*/ 371 w 510"/>
                <a:gd name="T35" fmla="*/ 285 h 455"/>
                <a:gd name="T36" fmla="*/ 362 w 510"/>
                <a:gd name="T37" fmla="*/ 274 h 455"/>
                <a:gd name="T38" fmla="*/ 355 w 510"/>
                <a:gd name="T39" fmla="*/ 266 h 455"/>
                <a:gd name="T40" fmla="*/ 351 w 510"/>
                <a:gd name="T41" fmla="*/ 255 h 455"/>
                <a:gd name="T42" fmla="*/ 346 w 510"/>
                <a:gd name="T43" fmla="*/ 243 h 455"/>
                <a:gd name="T44" fmla="*/ 341 w 510"/>
                <a:gd name="T45" fmla="*/ 231 h 455"/>
                <a:gd name="T46" fmla="*/ 336 w 510"/>
                <a:gd name="T47" fmla="*/ 219 h 455"/>
                <a:gd name="T48" fmla="*/ 332 w 510"/>
                <a:gd name="T49" fmla="*/ 211 h 455"/>
                <a:gd name="T50" fmla="*/ 325 w 510"/>
                <a:gd name="T51" fmla="*/ 199 h 455"/>
                <a:gd name="T52" fmla="*/ 318 w 510"/>
                <a:gd name="T53" fmla="*/ 187 h 455"/>
                <a:gd name="T54" fmla="*/ 313 w 510"/>
                <a:gd name="T55" fmla="*/ 175 h 455"/>
                <a:gd name="T56" fmla="*/ 308 w 510"/>
                <a:gd name="T57" fmla="*/ 163 h 455"/>
                <a:gd name="T58" fmla="*/ 303 w 510"/>
                <a:gd name="T59" fmla="*/ 151 h 455"/>
                <a:gd name="T60" fmla="*/ 298 w 510"/>
                <a:gd name="T61" fmla="*/ 139 h 455"/>
                <a:gd name="T62" fmla="*/ 290 w 510"/>
                <a:gd name="T63" fmla="*/ 133 h 455"/>
                <a:gd name="T64" fmla="*/ 278 w 510"/>
                <a:gd name="T65" fmla="*/ 133 h 455"/>
                <a:gd name="T66" fmla="*/ 274 w 510"/>
                <a:gd name="T67" fmla="*/ 127 h 455"/>
                <a:gd name="T68" fmla="*/ 269 w 510"/>
                <a:gd name="T69" fmla="*/ 115 h 455"/>
                <a:gd name="T70" fmla="*/ 264 w 510"/>
                <a:gd name="T71" fmla="*/ 103 h 455"/>
                <a:gd name="T72" fmla="*/ 259 w 510"/>
                <a:gd name="T73" fmla="*/ 91 h 455"/>
                <a:gd name="T74" fmla="*/ 256 w 510"/>
                <a:gd name="T75" fmla="*/ 84 h 455"/>
                <a:gd name="T76" fmla="*/ 244 w 510"/>
                <a:gd name="T77" fmla="*/ 84 h 455"/>
                <a:gd name="T78" fmla="*/ 233 w 510"/>
                <a:gd name="T79" fmla="*/ 80 h 455"/>
                <a:gd name="T80" fmla="*/ 224 w 510"/>
                <a:gd name="T81" fmla="*/ 69 h 455"/>
                <a:gd name="T82" fmla="*/ 217 w 510"/>
                <a:gd name="T83" fmla="*/ 60 h 455"/>
                <a:gd name="T84" fmla="*/ 209 w 510"/>
                <a:gd name="T85" fmla="*/ 50 h 455"/>
                <a:gd name="T86" fmla="*/ 200 w 510"/>
                <a:gd name="T87" fmla="*/ 40 h 455"/>
                <a:gd name="T88" fmla="*/ 192 w 510"/>
                <a:gd name="T89" fmla="*/ 33 h 455"/>
                <a:gd name="T90" fmla="*/ 180 w 510"/>
                <a:gd name="T91" fmla="*/ 26 h 455"/>
                <a:gd name="T92" fmla="*/ 171 w 510"/>
                <a:gd name="T93" fmla="*/ 17 h 455"/>
                <a:gd name="T94" fmla="*/ 162 w 510"/>
                <a:gd name="T95" fmla="*/ 5 h 455"/>
                <a:gd name="T96" fmla="*/ 155 w 510"/>
                <a:gd name="T97" fmla="*/ 0 h 455"/>
                <a:gd name="T98" fmla="*/ 143 w 510"/>
                <a:gd name="T99" fmla="*/ 0 h 455"/>
                <a:gd name="T100" fmla="*/ 131 w 510"/>
                <a:gd name="T101" fmla="*/ 0 h 455"/>
                <a:gd name="T102" fmla="*/ 119 w 510"/>
                <a:gd name="T103" fmla="*/ 0 h 455"/>
                <a:gd name="T104" fmla="*/ 107 w 510"/>
                <a:gd name="T105" fmla="*/ 0 h 455"/>
                <a:gd name="T106" fmla="*/ 95 w 510"/>
                <a:gd name="T107" fmla="*/ 0 h 455"/>
                <a:gd name="T108" fmla="*/ 83 w 510"/>
                <a:gd name="T109" fmla="*/ 0 h 455"/>
                <a:gd name="T110" fmla="*/ 71 w 510"/>
                <a:gd name="T111" fmla="*/ 0 h 455"/>
                <a:gd name="T112" fmla="*/ 59 w 510"/>
                <a:gd name="T113" fmla="*/ 0 h 455"/>
                <a:gd name="T114" fmla="*/ 51 w 510"/>
                <a:gd name="T115" fmla="*/ 0 h 455"/>
                <a:gd name="T116" fmla="*/ 39 w 510"/>
                <a:gd name="T117" fmla="*/ 0 h 455"/>
                <a:gd name="T118" fmla="*/ 27 w 510"/>
                <a:gd name="T119" fmla="*/ 0 h 455"/>
                <a:gd name="T120" fmla="*/ 15 w 510"/>
                <a:gd name="T121" fmla="*/ 0 h 455"/>
                <a:gd name="T122" fmla="*/ 3 w 510"/>
                <a:gd name="T123" fmla="*/ 0 h 4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510" h="455">
                  <a:moveTo>
                    <a:pt x="508" y="451"/>
                  </a:moveTo>
                  <a:lnTo>
                    <a:pt x="505" y="447"/>
                  </a:lnTo>
                  <a:moveTo>
                    <a:pt x="502" y="443"/>
                  </a:moveTo>
                  <a:lnTo>
                    <a:pt x="500" y="439"/>
                  </a:lnTo>
                  <a:moveTo>
                    <a:pt x="497" y="435"/>
                  </a:moveTo>
                  <a:lnTo>
                    <a:pt x="494" y="431"/>
                  </a:lnTo>
                  <a:moveTo>
                    <a:pt x="492" y="427"/>
                  </a:moveTo>
                  <a:lnTo>
                    <a:pt x="489" y="423"/>
                  </a:lnTo>
                  <a:moveTo>
                    <a:pt x="486" y="419"/>
                  </a:moveTo>
                  <a:lnTo>
                    <a:pt x="484" y="415"/>
                  </a:lnTo>
                  <a:moveTo>
                    <a:pt x="481" y="411"/>
                  </a:moveTo>
                  <a:lnTo>
                    <a:pt x="478" y="407"/>
                  </a:lnTo>
                  <a:moveTo>
                    <a:pt x="476" y="403"/>
                  </a:moveTo>
                  <a:lnTo>
                    <a:pt x="473" y="399"/>
                  </a:lnTo>
                  <a:lnTo>
                    <a:pt x="473" y="398"/>
                  </a:lnTo>
                  <a:moveTo>
                    <a:pt x="471" y="394"/>
                  </a:moveTo>
                  <a:lnTo>
                    <a:pt x="469" y="390"/>
                  </a:lnTo>
                  <a:moveTo>
                    <a:pt x="468" y="386"/>
                  </a:moveTo>
                  <a:lnTo>
                    <a:pt x="466" y="382"/>
                  </a:lnTo>
                  <a:moveTo>
                    <a:pt x="464" y="378"/>
                  </a:moveTo>
                  <a:lnTo>
                    <a:pt x="463" y="374"/>
                  </a:lnTo>
                  <a:moveTo>
                    <a:pt x="461" y="370"/>
                  </a:moveTo>
                  <a:lnTo>
                    <a:pt x="460" y="366"/>
                  </a:lnTo>
                  <a:moveTo>
                    <a:pt x="458" y="362"/>
                  </a:moveTo>
                  <a:lnTo>
                    <a:pt x="456" y="358"/>
                  </a:lnTo>
                  <a:moveTo>
                    <a:pt x="455" y="354"/>
                  </a:moveTo>
                  <a:lnTo>
                    <a:pt x="453" y="350"/>
                  </a:lnTo>
                  <a:lnTo>
                    <a:pt x="453" y="350"/>
                  </a:lnTo>
                  <a:moveTo>
                    <a:pt x="449" y="349"/>
                  </a:moveTo>
                  <a:lnTo>
                    <a:pt x="445" y="348"/>
                  </a:lnTo>
                  <a:moveTo>
                    <a:pt x="441" y="346"/>
                  </a:moveTo>
                  <a:lnTo>
                    <a:pt x="437" y="345"/>
                  </a:lnTo>
                  <a:moveTo>
                    <a:pt x="433" y="344"/>
                  </a:moveTo>
                  <a:lnTo>
                    <a:pt x="429" y="343"/>
                  </a:lnTo>
                  <a:moveTo>
                    <a:pt x="425" y="341"/>
                  </a:moveTo>
                  <a:lnTo>
                    <a:pt x="421" y="340"/>
                  </a:lnTo>
                  <a:moveTo>
                    <a:pt x="417" y="339"/>
                  </a:moveTo>
                  <a:lnTo>
                    <a:pt x="414" y="338"/>
                  </a:lnTo>
                  <a:lnTo>
                    <a:pt x="414" y="338"/>
                  </a:lnTo>
                  <a:moveTo>
                    <a:pt x="411" y="334"/>
                  </a:moveTo>
                  <a:lnTo>
                    <a:pt x="408" y="331"/>
                  </a:lnTo>
                  <a:moveTo>
                    <a:pt x="405" y="327"/>
                  </a:moveTo>
                  <a:lnTo>
                    <a:pt x="402" y="324"/>
                  </a:lnTo>
                  <a:moveTo>
                    <a:pt x="399" y="320"/>
                  </a:moveTo>
                  <a:lnTo>
                    <a:pt x="396" y="316"/>
                  </a:lnTo>
                  <a:moveTo>
                    <a:pt x="393" y="313"/>
                  </a:moveTo>
                  <a:lnTo>
                    <a:pt x="390" y="309"/>
                  </a:lnTo>
                  <a:moveTo>
                    <a:pt x="387" y="305"/>
                  </a:moveTo>
                  <a:lnTo>
                    <a:pt x="384" y="301"/>
                  </a:lnTo>
                  <a:moveTo>
                    <a:pt x="381" y="298"/>
                  </a:moveTo>
                  <a:lnTo>
                    <a:pt x="378" y="294"/>
                  </a:lnTo>
                  <a:moveTo>
                    <a:pt x="374" y="289"/>
                  </a:moveTo>
                  <a:lnTo>
                    <a:pt x="371" y="285"/>
                  </a:lnTo>
                  <a:moveTo>
                    <a:pt x="368" y="282"/>
                  </a:moveTo>
                  <a:lnTo>
                    <a:pt x="365" y="278"/>
                  </a:lnTo>
                  <a:moveTo>
                    <a:pt x="362" y="274"/>
                  </a:moveTo>
                  <a:lnTo>
                    <a:pt x="359" y="271"/>
                  </a:lnTo>
                  <a:moveTo>
                    <a:pt x="356" y="267"/>
                  </a:moveTo>
                  <a:lnTo>
                    <a:pt x="355" y="266"/>
                  </a:lnTo>
                  <a:lnTo>
                    <a:pt x="354" y="263"/>
                  </a:lnTo>
                  <a:moveTo>
                    <a:pt x="352" y="259"/>
                  </a:moveTo>
                  <a:lnTo>
                    <a:pt x="351" y="255"/>
                  </a:lnTo>
                  <a:moveTo>
                    <a:pt x="349" y="251"/>
                  </a:moveTo>
                  <a:lnTo>
                    <a:pt x="347" y="247"/>
                  </a:lnTo>
                  <a:moveTo>
                    <a:pt x="346" y="243"/>
                  </a:moveTo>
                  <a:lnTo>
                    <a:pt x="344" y="239"/>
                  </a:lnTo>
                  <a:moveTo>
                    <a:pt x="342" y="235"/>
                  </a:moveTo>
                  <a:lnTo>
                    <a:pt x="341" y="231"/>
                  </a:lnTo>
                  <a:moveTo>
                    <a:pt x="339" y="227"/>
                  </a:moveTo>
                  <a:lnTo>
                    <a:pt x="337" y="223"/>
                  </a:lnTo>
                  <a:moveTo>
                    <a:pt x="336" y="219"/>
                  </a:moveTo>
                  <a:lnTo>
                    <a:pt x="335" y="217"/>
                  </a:lnTo>
                  <a:lnTo>
                    <a:pt x="334" y="215"/>
                  </a:lnTo>
                  <a:moveTo>
                    <a:pt x="332" y="211"/>
                  </a:moveTo>
                  <a:lnTo>
                    <a:pt x="329" y="207"/>
                  </a:lnTo>
                  <a:moveTo>
                    <a:pt x="327" y="203"/>
                  </a:moveTo>
                  <a:lnTo>
                    <a:pt x="325" y="199"/>
                  </a:lnTo>
                  <a:moveTo>
                    <a:pt x="323" y="195"/>
                  </a:moveTo>
                  <a:lnTo>
                    <a:pt x="321" y="191"/>
                  </a:lnTo>
                  <a:moveTo>
                    <a:pt x="318" y="187"/>
                  </a:moveTo>
                  <a:lnTo>
                    <a:pt x="316" y="183"/>
                  </a:lnTo>
                  <a:moveTo>
                    <a:pt x="314" y="179"/>
                  </a:moveTo>
                  <a:lnTo>
                    <a:pt x="313" y="175"/>
                  </a:lnTo>
                  <a:moveTo>
                    <a:pt x="311" y="171"/>
                  </a:moveTo>
                  <a:lnTo>
                    <a:pt x="309" y="167"/>
                  </a:lnTo>
                  <a:moveTo>
                    <a:pt x="308" y="163"/>
                  </a:moveTo>
                  <a:lnTo>
                    <a:pt x="306" y="159"/>
                  </a:lnTo>
                  <a:moveTo>
                    <a:pt x="305" y="155"/>
                  </a:moveTo>
                  <a:lnTo>
                    <a:pt x="303" y="151"/>
                  </a:lnTo>
                  <a:moveTo>
                    <a:pt x="302" y="147"/>
                  </a:moveTo>
                  <a:lnTo>
                    <a:pt x="300" y="143"/>
                  </a:lnTo>
                  <a:moveTo>
                    <a:pt x="298" y="139"/>
                  </a:moveTo>
                  <a:lnTo>
                    <a:pt x="297" y="135"/>
                  </a:lnTo>
                  <a:moveTo>
                    <a:pt x="294" y="133"/>
                  </a:moveTo>
                  <a:lnTo>
                    <a:pt x="290" y="133"/>
                  </a:lnTo>
                  <a:moveTo>
                    <a:pt x="286" y="133"/>
                  </a:moveTo>
                  <a:lnTo>
                    <a:pt x="282" y="133"/>
                  </a:lnTo>
                  <a:moveTo>
                    <a:pt x="278" y="133"/>
                  </a:moveTo>
                  <a:lnTo>
                    <a:pt x="276" y="133"/>
                  </a:lnTo>
                  <a:lnTo>
                    <a:pt x="275" y="131"/>
                  </a:lnTo>
                  <a:moveTo>
                    <a:pt x="274" y="127"/>
                  </a:moveTo>
                  <a:lnTo>
                    <a:pt x="272" y="123"/>
                  </a:lnTo>
                  <a:moveTo>
                    <a:pt x="270" y="119"/>
                  </a:moveTo>
                  <a:lnTo>
                    <a:pt x="269" y="115"/>
                  </a:lnTo>
                  <a:moveTo>
                    <a:pt x="267" y="111"/>
                  </a:moveTo>
                  <a:lnTo>
                    <a:pt x="265" y="107"/>
                  </a:lnTo>
                  <a:moveTo>
                    <a:pt x="264" y="103"/>
                  </a:moveTo>
                  <a:lnTo>
                    <a:pt x="262" y="99"/>
                  </a:lnTo>
                  <a:moveTo>
                    <a:pt x="260" y="95"/>
                  </a:moveTo>
                  <a:lnTo>
                    <a:pt x="259" y="91"/>
                  </a:lnTo>
                  <a:moveTo>
                    <a:pt x="257" y="87"/>
                  </a:moveTo>
                  <a:lnTo>
                    <a:pt x="256" y="84"/>
                  </a:lnTo>
                  <a:lnTo>
                    <a:pt x="256" y="84"/>
                  </a:lnTo>
                  <a:moveTo>
                    <a:pt x="252" y="84"/>
                  </a:moveTo>
                  <a:lnTo>
                    <a:pt x="248" y="84"/>
                  </a:lnTo>
                  <a:moveTo>
                    <a:pt x="244" y="84"/>
                  </a:moveTo>
                  <a:lnTo>
                    <a:pt x="240" y="84"/>
                  </a:lnTo>
                  <a:moveTo>
                    <a:pt x="236" y="84"/>
                  </a:moveTo>
                  <a:lnTo>
                    <a:pt x="233" y="80"/>
                  </a:lnTo>
                  <a:moveTo>
                    <a:pt x="230" y="77"/>
                  </a:moveTo>
                  <a:lnTo>
                    <a:pt x="227" y="73"/>
                  </a:lnTo>
                  <a:moveTo>
                    <a:pt x="224" y="69"/>
                  </a:moveTo>
                  <a:lnTo>
                    <a:pt x="221" y="65"/>
                  </a:lnTo>
                  <a:moveTo>
                    <a:pt x="218" y="61"/>
                  </a:moveTo>
                  <a:lnTo>
                    <a:pt x="217" y="60"/>
                  </a:lnTo>
                  <a:lnTo>
                    <a:pt x="215" y="58"/>
                  </a:lnTo>
                  <a:moveTo>
                    <a:pt x="212" y="54"/>
                  </a:moveTo>
                  <a:lnTo>
                    <a:pt x="209" y="50"/>
                  </a:lnTo>
                  <a:moveTo>
                    <a:pt x="206" y="47"/>
                  </a:moveTo>
                  <a:lnTo>
                    <a:pt x="203" y="43"/>
                  </a:lnTo>
                  <a:moveTo>
                    <a:pt x="200" y="40"/>
                  </a:moveTo>
                  <a:lnTo>
                    <a:pt x="197" y="36"/>
                  </a:lnTo>
                  <a:lnTo>
                    <a:pt x="196" y="35"/>
                  </a:lnTo>
                  <a:moveTo>
                    <a:pt x="192" y="33"/>
                  </a:moveTo>
                  <a:lnTo>
                    <a:pt x="188" y="31"/>
                  </a:lnTo>
                  <a:moveTo>
                    <a:pt x="184" y="28"/>
                  </a:moveTo>
                  <a:lnTo>
                    <a:pt x="180" y="26"/>
                  </a:lnTo>
                  <a:moveTo>
                    <a:pt x="177" y="24"/>
                  </a:moveTo>
                  <a:lnTo>
                    <a:pt x="174" y="20"/>
                  </a:lnTo>
                  <a:moveTo>
                    <a:pt x="171" y="17"/>
                  </a:moveTo>
                  <a:lnTo>
                    <a:pt x="168" y="13"/>
                  </a:lnTo>
                  <a:moveTo>
                    <a:pt x="165" y="9"/>
                  </a:moveTo>
                  <a:lnTo>
                    <a:pt x="162" y="5"/>
                  </a:lnTo>
                  <a:moveTo>
                    <a:pt x="159" y="1"/>
                  </a:moveTo>
                  <a:lnTo>
                    <a:pt x="158" y="0"/>
                  </a:lnTo>
                  <a:lnTo>
                    <a:pt x="155" y="0"/>
                  </a:lnTo>
                  <a:moveTo>
                    <a:pt x="151" y="0"/>
                  </a:moveTo>
                  <a:lnTo>
                    <a:pt x="147" y="0"/>
                  </a:lnTo>
                  <a:moveTo>
                    <a:pt x="143" y="0"/>
                  </a:moveTo>
                  <a:lnTo>
                    <a:pt x="139" y="0"/>
                  </a:lnTo>
                  <a:moveTo>
                    <a:pt x="135" y="0"/>
                  </a:moveTo>
                  <a:lnTo>
                    <a:pt x="131" y="0"/>
                  </a:lnTo>
                  <a:moveTo>
                    <a:pt x="127" y="0"/>
                  </a:moveTo>
                  <a:lnTo>
                    <a:pt x="123" y="0"/>
                  </a:lnTo>
                  <a:moveTo>
                    <a:pt x="119" y="0"/>
                  </a:moveTo>
                  <a:lnTo>
                    <a:pt x="115" y="0"/>
                  </a:lnTo>
                  <a:moveTo>
                    <a:pt x="111" y="0"/>
                  </a:moveTo>
                  <a:lnTo>
                    <a:pt x="107" y="0"/>
                  </a:lnTo>
                  <a:moveTo>
                    <a:pt x="103" y="0"/>
                  </a:moveTo>
                  <a:lnTo>
                    <a:pt x="99" y="0"/>
                  </a:lnTo>
                  <a:moveTo>
                    <a:pt x="95" y="0"/>
                  </a:moveTo>
                  <a:lnTo>
                    <a:pt x="91" y="0"/>
                  </a:lnTo>
                  <a:moveTo>
                    <a:pt x="87" y="0"/>
                  </a:moveTo>
                  <a:lnTo>
                    <a:pt x="83" y="0"/>
                  </a:lnTo>
                  <a:moveTo>
                    <a:pt x="79" y="0"/>
                  </a:moveTo>
                  <a:lnTo>
                    <a:pt x="75" y="0"/>
                  </a:lnTo>
                  <a:moveTo>
                    <a:pt x="71" y="0"/>
                  </a:moveTo>
                  <a:lnTo>
                    <a:pt x="67" y="0"/>
                  </a:lnTo>
                  <a:moveTo>
                    <a:pt x="63" y="0"/>
                  </a:moveTo>
                  <a:lnTo>
                    <a:pt x="59" y="0"/>
                  </a:lnTo>
                  <a:lnTo>
                    <a:pt x="59" y="0"/>
                  </a:lnTo>
                  <a:moveTo>
                    <a:pt x="55" y="0"/>
                  </a:moveTo>
                  <a:lnTo>
                    <a:pt x="51" y="0"/>
                  </a:lnTo>
                  <a:moveTo>
                    <a:pt x="47" y="0"/>
                  </a:moveTo>
                  <a:lnTo>
                    <a:pt x="43" y="0"/>
                  </a:lnTo>
                  <a:moveTo>
                    <a:pt x="39" y="0"/>
                  </a:moveTo>
                  <a:lnTo>
                    <a:pt x="35" y="0"/>
                  </a:lnTo>
                  <a:moveTo>
                    <a:pt x="31" y="0"/>
                  </a:moveTo>
                  <a:lnTo>
                    <a:pt x="27" y="0"/>
                  </a:lnTo>
                  <a:moveTo>
                    <a:pt x="23" y="0"/>
                  </a:moveTo>
                  <a:lnTo>
                    <a:pt x="19" y="0"/>
                  </a:lnTo>
                  <a:moveTo>
                    <a:pt x="15" y="0"/>
                  </a:moveTo>
                  <a:lnTo>
                    <a:pt x="11" y="0"/>
                  </a:lnTo>
                  <a:moveTo>
                    <a:pt x="7" y="0"/>
                  </a:moveTo>
                  <a:lnTo>
                    <a:pt x="3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Line 100">
              <a:extLst>
                <a:ext uri="{FF2B5EF4-FFF2-40B4-BE49-F238E27FC236}">
                  <a16:creationId xmlns:a16="http://schemas.microsoft.com/office/drawing/2014/main" id="{0FFD3844-7B59-4AB0-B5C9-65F000A864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62813" y="4289426"/>
              <a:ext cx="31940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Line 101">
              <a:extLst>
                <a:ext uri="{FF2B5EF4-FFF2-40B4-BE49-F238E27FC236}">
                  <a16:creationId xmlns:a16="http://schemas.microsoft.com/office/drawing/2014/main" id="{CFE33448-2E99-4F8C-9D81-20E564E3C3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62813" y="4289426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Line 102">
              <a:extLst>
                <a:ext uri="{FF2B5EF4-FFF2-40B4-BE49-F238E27FC236}">
                  <a16:creationId xmlns:a16="http://schemas.microsoft.com/office/drawing/2014/main" id="{72A86A45-0F6C-4588-9593-992A384EDAF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04163" y="4289426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Line 103">
              <a:extLst>
                <a:ext uri="{FF2B5EF4-FFF2-40B4-BE49-F238E27FC236}">
                  <a16:creationId xmlns:a16="http://schemas.microsoft.com/office/drawing/2014/main" id="{BF0BC46A-BA78-4DBF-969C-9DC95F1C6C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539163" y="4289426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Line 104">
              <a:extLst>
                <a:ext uri="{FF2B5EF4-FFF2-40B4-BE49-F238E27FC236}">
                  <a16:creationId xmlns:a16="http://schemas.microsoft.com/office/drawing/2014/main" id="{3903BAB3-A50D-4A88-A17E-85F94719DD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180513" y="4289426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Line 105">
              <a:extLst>
                <a:ext uri="{FF2B5EF4-FFF2-40B4-BE49-F238E27FC236}">
                  <a16:creationId xmlns:a16="http://schemas.microsoft.com/office/drawing/2014/main" id="{52EE39FC-905C-44FF-829C-DF9C22B874B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821863" y="4289426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Line 106">
              <a:extLst>
                <a:ext uri="{FF2B5EF4-FFF2-40B4-BE49-F238E27FC236}">
                  <a16:creationId xmlns:a16="http://schemas.microsoft.com/office/drawing/2014/main" id="{A0DECFB4-D808-4AFA-ADC9-A648DB9BF7C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56863" y="4289426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Rectangle 107">
              <a:extLst>
                <a:ext uri="{FF2B5EF4-FFF2-40B4-BE49-F238E27FC236}">
                  <a16:creationId xmlns:a16="http://schemas.microsoft.com/office/drawing/2014/main" id="{039DAB6A-16BE-4DF1-8DF7-1B623AE6B9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56450" y="4425951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Rectangle 108">
              <a:extLst>
                <a:ext uri="{FF2B5EF4-FFF2-40B4-BE49-F238E27FC236}">
                  <a16:creationId xmlns:a16="http://schemas.microsoft.com/office/drawing/2014/main" id="{DCCCC684-B899-4F0C-8D50-E445875779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97800" y="4425951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Rectangle 109">
              <a:extLst>
                <a:ext uri="{FF2B5EF4-FFF2-40B4-BE49-F238E27FC236}">
                  <a16:creationId xmlns:a16="http://schemas.microsoft.com/office/drawing/2014/main" id="{4D9D63D8-AB4F-4531-807D-CCC04297F0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32800" y="4425951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.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Rectangle 110">
              <a:extLst>
                <a:ext uri="{FF2B5EF4-FFF2-40B4-BE49-F238E27FC236}">
                  <a16:creationId xmlns:a16="http://schemas.microsoft.com/office/drawing/2014/main" id="{DA274023-8C65-4B7C-9D77-E5D6CE896D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74150" y="4425951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Rectangle 111">
              <a:extLst>
                <a:ext uri="{FF2B5EF4-FFF2-40B4-BE49-F238E27FC236}">
                  <a16:creationId xmlns:a16="http://schemas.microsoft.com/office/drawing/2014/main" id="{10A8642E-3F9E-4191-9B48-00D34A3E21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15501" y="4425951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.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Rectangle 112">
              <a:extLst>
                <a:ext uri="{FF2B5EF4-FFF2-40B4-BE49-F238E27FC236}">
                  <a16:creationId xmlns:a16="http://schemas.microsoft.com/office/drawing/2014/main" id="{ECDF76E6-4970-48AE-ABCA-A8661AF984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50501" y="4425951"/>
              <a:ext cx="697688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.0</a:t>
              </a: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g/dl)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Line 113">
              <a:extLst>
                <a:ext uri="{FF2B5EF4-FFF2-40B4-BE49-F238E27FC236}">
                  <a16:creationId xmlns:a16="http://schemas.microsoft.com/office/drawing/2014/main" id="{3A74FB2A-0552-45C3-A4DB-6B17FD6A3D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256463" y="1195388"/>
              <a:ext cx="0" cy="297180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Line 114">
              <a:extLst>
                <a:ext uri="{FF2B5EF4-FFF2-40B4-BE49-F238E27FC236}">
                  <a16:creationId xmlns:a16="http://schemas.microsoft.com/office/drawing/2014/main" id="{C8FE552E-540F-481B-B428-DF9F67DDE2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199313" y="4167188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Line 115">
              <a:extLst>
                <a:ext uri="{FF2B5EF4-FFF2-40B4-BE49-F238E27FC236}">
                  <a16:creationId xmlns:a16="http://schemas.microsoft.com/office/drawing/2014/main" id="{79AE51F3-BB31-4642-BB67-E33A30DA32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199313" y="3571876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Line 116">
              <a:extLst>
                <a:ext uri="{FF2B5EF4-FFF2-40B4-BE49-F238E27FC236}">
                  <a16:creationId xmlns:a16="http://schemas.microsoft.com/office/drawing/2014/main" id="{10A74E14-48DA-4947-BD23-D3EBA5A95D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199313" y="2974976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Line 117">
              <a:extLst>
                <a:ext uri="{FF2B5EF4-FFF2-40B4-BE49-F238E27FC236}">
                  <a16:creationId xmlns:a16="http://schemas.microsoft.com/office/drawing/2014/main" id="{36EAB01B-4315-4289-8D4F-7DD1DE447D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199313" y="2379663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Line 118">
              <a:extLst>
                <a:ext uri="{FF2B5EF4-FFF2-40B4-BE49-F238E27FC236}">
                  <a16:creationId xmlns:a16="http://schemas.microsoft.com/office/drawing/2014/main" id="{AE92CD45-BBE9-43DE-B036-B67FEEB47D2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199313" y="1790701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Line 119">
              <a:extLst>
                <a:ext uri="{FF2B5EF4-FFF2-40B4-BE49-F238E27FC236}">
                  <a16:creationId xmlns:a16="http://schemas.microsoft.com/office/drawing/2014/main" id="{BE20E9DD-20B5-4679-AE4B-72F94042EFF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199313" y="1195388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Rectangle 120">
              <a:extLst>
                <a:ext uri="{FF2B5EF4-FFF2-40B4-BE49-F238E27FC236}">
                  <a16:creationId xmlns:a16="http://schemas.microsoft.com/office/drawing/2014/main" id="{C23D10E2-ECB4-4422-9522-305DB17C34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19913" y="4127501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Rectangle 121">
              <a:extLst>
                <a:ext uri="{FF2B5EF4-FFF2-40B4-BE49-F238E27FC236}">
                  <a16:creationId xmlns:a16="http://schemas.microsoft.com/office/drawing/2014/main" id="{42E36D05-1B45-4AC6-84D5-E376E0F581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19913" y="3532188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Rectangle 122">
              <a:extLst>
                <a:ext uri="{FF2B5EF4-FFF2-40B4-BE49-F238E27FC236}">
                  <a16:creationId xmlns:a16="http://schemas.microsoft.com/office/drawing/2014/main" id="{D989DA02-58AB-44E7-A7E1-8F67779BE9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19913" y="2936876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Rectangle 123">
              <a:extLst>
                <a:ext uri="{FF2B5EF4-FFF2-40B4-BE49-F238E27FC236}">
                  <a16:creationId xmlns:a16="http://schemas.microsoft.com/office/drawing/2014/main" id="{4DE22FF8-5EBE-4E4C-B30B-3E8B40FC44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19913" y="2341563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Rectangle 124">
              <a:extLst>
                <a:ext uri="{FF2B5EF4-FFF2-40B4-BE49-F238E27FC236}">
                  <a16:creationId xmlns:a16="http://schemas.microsoft.com/office/drawing/2014/main" id="{CAEE1084-C340-4CA8-9470-E2FC2B12EE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19913" y="1744663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" name="Rectangle 125">
              <a:extLst>
                <a:ext uri="{FF2B5EF4-FFF2-40B4-BE49-F238E27FC236}">
                  <a16:creationId xmlns:a16="http://schemas.microsoft.com/office/drawing/2014/main" id="{11FA24AF-23AD-4467-B2ED-174CEB8646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19913" y="1149351"/>
              <a:ext cx="233861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" name="Rectangle 126">
              <a:extLst>
                <a:ext uri="{FF2B5EF4-FFF2-40B4-BE49-F238E27FC236}">
                  <a16:creationId xmlns:a16="http://schemas.microsoft.com/office/drawing/2014/main" id="{984D41DF-CD94-49B6-8A66-713C838D31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56463" y="1071563"/>
              <a:ext cx="3589337" cy="3217863"/>
            </a:xfrm>
            <a:prstGeom prst="rect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Line 127">
              <a:extLst>
                <a:ext uri="{FF2B5EF4-FFF2-40B4-BE49-F238E27FC236}">
                  <a16:creationId xmlns:a16="http://schemas.microsoft.com/office/drawing/2014/main" id="{019DE979-13F3-4086-A218-2055647FB59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29271" y="4151693"/>
              <a:ext cx="187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Freeform 128">
              <a:extLst>
                <a:ext uri="{FF2B5EF4-FFF2-40B4-BE49-F238E27FC236}">
                  <a16:creationId xmlns:a16="http://schemas.microsoft.com/office/drawing/2014/main" id="{0862DE70-EA08-4942-ABC0-AC4FCB86E7D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998873" y="4148713"/>
              <a:ext cx="161925" cy="0"/>
            </a:xfrm>
            <a:custGeom>
              <a:avLst/>
              <a:gdLst>
                <a:gd name="T0" fmla="*/ 0 w 25"/>
                <a:gd name="T1" fmla="*/ 4 w 25"/>
                <a:gd name="T2" fmla="*/ 8 w 25"/>
                <a:gd name="T3" fmla="*/ 12 w 25"/>
                <a:gd name="T4" fmla="*/ 16 w 25"/>
                <a:gd name="T5" fmla="*/ 20 w 25"/>
                <a:gd name="T6" fmla="*/ 24 w 2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</a:cxnLst>
              <a:rect l="0" t="0" r="r" b="b"/>
              <a:pathLst>
                <a:path w="25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Rectangle 130">
              <a:extLst>
                <a:ext uri="{FF2B5EF4-FFF2-40B4-BE49-F238E27FC236}">
                  <a16:creationId xmlns:a16="http://schemas.microsoft.com/office/drawing/2014/main" id="{F2624A76-55F6-4F09-B08F-05EACD9C23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38795" y="4036277"/>
              <a:ext cx="814618" cy="2179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ecificity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9" name="グループ化 128">
            <a:extLst>
              <a:ext uri="{FF2B5EF4-FFF2-40B4-BE49-F238E27FC236}">
                <a16:creationId xmlns:a16="http://schemas.microsoft.com/office/drawing/2014/main" id="{00393878-E6F0-44E1-8EB5-66A24C8399BD}"/>
              </a:ext>
            </a:extLst>
          </p:cNvPr>
          <p:cNvGrpSpPr/>
          <p:nvPr/>
        </p:nvGrpSpPr>
        <p:grpSpPr>
          <a:xfrm>
            <a:off x="554551" y="3635616"/>
            <a:ext cx="3411275" cy="3149574"/>
            <a:chOff x="6160380" y="1232775"/>
            <a:chExt cx="4183805" cy="4196240"/>
          </a:xfrm>
        </p:grpSpPr>
        <p:sp>
          <p:nvSpPr>
            <p:cNvPr id="130" name="Rectangle 5">
              <a:extLst>
                <a:ext uri="{FF2B5EF4-FFF2-40B4-BE49-F238E27FC236}">
                  <a16:creationId xmlns:a16="http://schemas.microsoft.com/office/drawing/2014/main" id="{0520D7F7-8383-4DCF-94BD-2108DA3827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72898" y="5182981"/>
              <a:ext cx="821798" cy="2460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ecificity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Rectangle 6">
              <a:extLst>
                <a:ext uri="{FF2B5EF4-FFF2-40B4-BE49-F238E27FC236}">
                  <a16:creationId xmlns:a16="http://schemas.microsoft.com/office/drawing/2014/main" id="{1A39B1F9-C010-47A4-8234-7C95D0603F4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833666" y="3026423"/>
              <a:ext cx="879913" cy="2264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ensitivity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Rectangle 7">
              <a:extLst>
                <a:ext uri="{FF2B5EF4-FFF2-40B4-BE49-F238E27FC236}">
                  <a16:creationId xmlns:a16="http://schemas.microsoft.com/office/drawing/2014/main" id="{5373E014-6961-4B51-B85E-1125891707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56435" y="1232775"/>
              <a:ext cx="3587750" cy="3587750"/>
            </a:xfrm>
            <a:prstGeom prst="rect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Line 8">
              <a:extLst>
                <a:ext uri="{FF2B5EF4-FFF2-40B4-BE49-F238E27FC236}">
                  <a16:creationId xmlns:a16="http://schemas.microsoft.com/office/drawing/2014/main" id="{93AF3CA9-9B59-43BD-A3C3-E390893529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56435" y="1362950"/>
              <a:ext cx="0" cy="33210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Line 9">
              <a:extLst>
                <a:ext uri="{FF2B5EF4-FFF2-40B4-BE49-F238E27FC236}">
                  <a16:creationId xmlns:a16="http://schemas.microsoft.com/office/drawing/2014/main" id="{74ECF782-2CEE-4C5D-BB8D-55D98D7572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697698" y="4684000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Line 10">
              <a:extLst>
                <a:ext uri="{FF2B5EF4-FFF2-40B4-BE49-F238E27FC236}">
                  <a16:creationId xmlns:a16="http://schemas.microsoft.com/office/drawing/2014/main" id="{C0E2BD69-978C-4233-8233-FC0CAA388A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697698" y="4023600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Line 11">
              <a:extLst>
                <a:ext uri="{FF2B5EF4-FFF2-40B4-BE49-F238E27FC236}">
                  <a16:creationId xmlns:a16="http://schemas.microsoft.com/office/drawing/2014/main" id="{B44AFC6C-2AEC-40CC-9035-FFC13A2FF6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697698" y="3356850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Line 12">
              <a:extLst>
                <a:ext uri="{FF2B5EF4-FFF2-40B4-BE49-F238E27FC236}">
                  <a16:creationId xmlns:a16="http://schemas.microsoft.com/office/drawing/2014/main" id="{F4594967-1D47-4BAA-8370-660AC828A7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697698" y="2696450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Line 13">
              <a:extLst>
                <a:ext uri="{FF2B5EF4-FFF2-40B4-BE49-F238E27FC236}">
                  <a16:creationId xmlns:a16="http://schemas.microsoft.com/office/drawing/2014/main" id="{1D897BF1-73D8-471D-B39F-A5447422B7C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697698" y="2029700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Line 14">
              <a:extLst>
                <a:ext uri="{FF2B5EF4-FFF2-40B4-BE49-F238E27FC236}">
                  <a16:creationId xmlns:a16="http://schemas.microsoft.com/office/drawing/2014/main" id="{FEB04DAE-8907-467C-9DFE-B949975A9C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697698" y="1362950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Rectangle 15">
              <a:extLst>
                <a:ext uri="{FF2B5EF4-FFF2-40B4-BE49-F238E27FC236}">
                  <a16:creationId xmlns:a16="http://schemas.microsoft.com/office/drawing/2014/main" id="{069BDB17-7387-4CDC-A136-0489C6B7B6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19885" y="4645900"/>
              <a:ext cx="235923" cy="2460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Rectangle 16">
              <a:extLst>
                <a:ext uri="{FF2B5EF4-FFF2-40B4-BE49-F238E27FC236}">
                  <a16:creationId xmlns:a16="http://schemas.microsoft.com/office/drawing/2014/main" id="{EB4A8E4E-45BE-4999-91B0-715F461705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19885" y="3979150"/>
              <a:ext cx="235923" cy="2460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Rectangle 17">
              <a:extLst>
                <a:ext uri="{FF2B5EF4-FFF2-40B4-BE49-F238E27FC236}">
                  <a16:creationId xmlns:a16="http://schemas.microsoft.com/office/drawing/2014/main" id="{54E0E31E-ABA3-4718-A1CD-7FFBFF8632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19885" y="3318750"/>
              <a:ext cx="235923" cy="2460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Rectangle 18">
              <a:extLst>
                <a:ext uri="{FF2B5EF4-FFF2-40B4-BE49-F238E27FC236}">
                  <a16:creationId xmlns:a16="http://schemas.microsoft.com/office/drawing/2014/main" id="{8FEEE00F-51E2-4358-917B-4A7F189844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19885" y="2651999"/>
              <a:ext cx="235923" cy="2460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Rectangle 19">
              <a:extLst>
                <a:ext uri="{FF2B5EF4-FFF2-40B4-BE49-F238E27FC236}">
                  <a16:creationId xmlns:a16="http://schemas.microsoft.com/office/drawing/2014/main" id="{1D97DCC4-4FB8-49C8-AF58-599D606BC8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19885" y="1983662"/>
              <a:ext cx="235923" cy="2460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Rectangle 20">
              <a:extLst>
                <a:ext uri="{FF2B5EF4-FFF2-40B4-BE49-F238E27FC236}">
                  <a16:creationId xmlns:a16="http://schemas.microsoft.com/office/drawing/2014/main" id="{C253A488-7732-4056-A34F-DA1CFF92B2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19885" y="1323262"/>
              <a:ext cx="235923" cy="2460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Line 21">
              <a:extLst>
                <a:ext uri="{FF2B5EF4-FFF2-40B4-BE49-F238E27FC236}">
                  <a16:creationId xmlns:a16="http://schemas.microsoft.com/office/drawing/2014/main" id="{0F55119A-69D9-4329-B620-C5C81C7E11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892960" y="4820525"/>
              <a:ext cx="33210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Line 22">
              <a:extLst>
                <a:ext uri="{FF2B5EF4-FFF2-40B4-BE49-F238E27FC236}">
                  <a16:creationId xmlns:a16="http://schemas.microsoft.com/office/drawing/2014/main" id="{AE9070E5-1ECE-4851-885C-52ED4D7184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14010" y="4820525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Line 23">
              <a:extLst>
                <a:ext uri="{FF2B5EF4-FFF2-40B4-BE49-F238E27FC236}">
                  <a16:creationId xmlns:a16="http://schemas.microsoft.com/office/drawing/2014/main" id="{6932466A-4D7D-4E57-AB8B-6DF05A1766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547260" y="4820525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Line 24">
              <a:extLst>
                <a:ext uri="{FF2B5EF4-FFF2-40B4-BE49-F238E27FC236}">
                  <a16:creationId xmlns:a16="http://schemas.microsoft.com/office/drawing/2014/main" id="{9DB3A029-1EBA-4C3C-8AA5-10048874849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880510" y="4820525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Line 25">
              <a:extLst>
                <a:ext uri="{FF2B5EF4-FFF2-40B4-BE49-F238E27FC236}">
                  <a16:creationId xmlns:a16="http://schemas.microsoft.com/office/drawing/2014/main" id="{0E45B1EF-9286-40E9-B3BA-5F3FC3C0F82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20110" y="4820525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Line 26">
              <a:extLst>
                <a:ext uri="{FF2B5EF4-FFF2-40B4-BE49-F238E27FC236}">
                  <a16:creationId xmlns:a16="http://schemas.microsoft.com/office/drawing/2014/main" id="{BAFFB0E0-B3EB-4EBE-A71D-184EF052D7B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53360" y="4820525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Line 27">
              <a:extLst>
                <a:ext uri="{FF2B5EF4-FFF2-40B4-BE49-F238E27FC236}">
                  <a16:creationId xmlns:a16="http://schemas.microsoft.com/office/drawing/2014/main" id="{D69AB119-A40D-4DC0-96F3-52BD2CFF34A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92960" y="4820525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Rectangle 28">
              <a:extLst>
                <a:ext uri="{FF2B5EF4-FFF2-40B4-BE49-F238E27FC236}">
                  <a16:creationId xmlns:a16="http://schemas.microsoft.com/office/drawing/2014/main" id="{7F9DA8B8-6238-48FD-ACEF-4B733CB197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86598" y="4957050"/>
              <a:ext cx="235923" cy="2460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Rectangle 29">
              <a:extLst>
                <a:ext uri="{FF2B5EF4-FFF2-40B4-BE49-F238E27FC236}">
                  <a16:creationId xmlns:a16="http://schemas.microsoft.com/office/drawing/2014/main" id="{E216FD8D-987A-4FDD-B16A-6920A86FEA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46998" y="4957050"/>
              <a:ext cx="235923" cy="2460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Rectangle 30">
              <a:extLst>
                <a:ext uri="{FF2B5EF4-FFF2-40B4-BE49-F238E27FC236}">
                  <a16:creationId xmlns:a16="http://schemas.microsoft.com/office/drawing/2014/main" id="{28D736BD-34A8-4867-9A91-CAC197676E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13748" y="4957050"/>
              <a:ext cx="235923" cy="2460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Rectangle 31">
              <a:extLst>
                <a:ext uri="{FF2B5EF4-FFF2-40B4-BE49-F238E27FC236}">
                  <a16:creationId xmlns:a16="http://schemas.microsoft.com/office/drawing/2014/main" id="{F9177519-A557-4955-99D8-9A425606E1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74148" y="4957050"/>
              <a:ext cx="235923" cy="2460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Rectangle 32">
              <a:extLst>
                <a:ext uri="{FF2B5EF4-FFF2-40B4-BE49-F238E27FC236}">
                  <a16:creationId xmlns:a16="http://schemas.microsoft.com/office/drawing/2014/main" id="{CF9261B1-E255-46A5-B9B4-514FC02982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440898" y="4957050"/>
              <a:ext cx="235923" cy="2460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Rectangle 33">
              <a:extLst>
                <a:ext uri="{FF2B5EF4-FFF2-40B4-BE49-F238E27FC236}">
                  <a16:creationId xmlns:a16="http://schemas.microsoft.com/office/drawing/2014/main" id="{FD5BA454-ED30-4BFE-AAAE-AA0A3F4663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07648" y="4957050"/>
              <a:ext cx="235923" cy="2460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Freeform 34">
              <a:extLst>
                <a:ext uri="{FF2B5EF4-FFF2-40B4-BE49-F238E27FC236}">
                  <a16:creationId xmlns:a16="http://schemas.microsoft.com/office/drawing/2014/main" id="{E069ED98-1A4D-483F-A863-BB7E75200DC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0214010" y="1232775"/>
              <a:ext cx="0" cy="3581400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Freeform 35">
              <a:extLst>
                <a:ext uri="{FF2B5EF4-FFF2-40B4-BE49-F238E27FC236}">
                  <a16:creationId xmlns:a16="http://schemas.microsoft.com/office/drawing/2014/main" id="{E021BB26-6ABE-40CA-B5A9-D468BE0D91F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877460" y="1232775"/>
              <a:ext cx="0" cy="3581400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Freeform 36">
              <a:extLst>
                <a:ext uri="{FF2B5EF4-FFF2-40B4-BE49-F238E27FC236}">
                  <a16:creationId xmlns:a16="http://schemas.microsoft.com/office/drawing/2014/main" id="{9C76C970-DE49-4FE9-9B68-DAA7191C122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547260" y="1232775"/>
              <a:ext cx="0" cy="3581400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Freeform 37">
              <a:extLst>
                <a:ext uri="{FF2B5EF4-FFF2-40B4-BE49-F238E27FC236}">
                  <a16:creationId xmlns:a16="http://schemas.microsoft.com/office/drawing/2014/main" id="{7DC2B8E6-2A3E-4E06-B76A-3C34DE848E3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217060" y="1232775"/>
              <a:ext cx="0" cy="3581400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Freeform 38">
              <a:extLst>
                <a:ext uri="{FF2B5EF4-FFF2-40B4-BE49-F238E27FC236}">
                  <a16:creationId xmlns:a16="http://schemas.microsoft.com/office/drawing/2014/main" id="{76608CC1-A7E0-48F3-B061-2C8F8C8710F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880510" y="1232775"/>
              <a:ext cx="0" cy="3581400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Freeform 39">
              <a:extLst>
                <a:ext uri="{FF2B5EF4-FFF2-40B4-BE49-F238E27FC236}">
                  <a16:creationId xmlns:a16="http://schemas.microsoft.com/office/drawing/2014/main" id="{55CCB75D-960D-4DB3-AA5A-B0316AA0D65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550310" y="1232775"/>
              <a:ext cx="0" cy="3581400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Freeform 40">
              <a:extLst>
                <a:ext uri="{FF2B5EF4-FFF2-40B4-BE49-F238E27FC236}">
                  <a16:creationId xmlns:a16="http://schemas.microsoft.com/office/drawing/2014/main" id="{CC0FC5ED-5EB0-49D4-B94C-E29900D15C9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220110" y="1232775"/>
              <a:ext cx="0" cy="3581400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Freeform 41">
              <a:extLst>
                <a:ext uri="{FF2B5EF4-FFF2-40B4-BE49-F238E27FC236}">
                  <a16:creationId xmlns:a16="http://schemas.microsoft.com/office/drawing/2014/main" id="{1AC51BEE-9F82-4880-B25B-66B80AE8773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889910" y="1232775"/>
              <a:ext cx="0" cy="3581400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Freeform 42">
              <a:extLst>
                <a:ext uri="{FF2B5EF4-FFF2-40B4-BE49-F238E27FC236}">
                  <a16:creationId xmlns:a16="http://schemas.microsoft.com/office/drawing/2014/main" id="{E83B4A8B-A162-4DCD-8318-3C6273D244B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553360" y="1232775"/>
              <a:ext cx="0" cy="3581400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Freeform 43">
              <a:extLst>
                <a:ext uri="{FF2B5EF4-FFF2-40B4-BE49-F238E27FC236}">
                  <a16:creationId xmlns:a16="http://schemas.microsoft.com/office/drawing/2014/main" id="{598169DE-E7DF-419E-839C-3FE30BD72D9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223160" y="1232775"/>
              <a:ext cx="0" cy="3581400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Freeform 44">
              <a:extLst>
                <a:ext uri="{FF2B5EF4-FFF2-40B4-BE49-F238E27FC236}">
                  <a16:creationId xmlns:a16="http://schemas.microsoft.com/office/drawing/2014/main" id="{B968A24D-6317-4AF0-AABB-5E36ACE4F38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892960" y="1232775"/>
              <a:ext cx="0" cy="3581400"/>
            </a:xfrm>
            <a:custGeom>
              <a:avLst/>
              <a:gdLst>
                <a:gd name="T0" fmla="*/ 545 h 553"/>
                <a:gd name="T1" fmla="*/ 534 h 553"/>
                <a:gd name="T2" fmla="*/ 525 h 553"/>
                <a:gd name="T3" fmla="*/ 514 h 553"/>
                <a:gd name="T4" fmla="*/ 505 h 553"/>
                <a:gd name="T5" fmla="*/ 494 h 553"/>
                <a:gd name="T6" fmla="*/ 485 h 553"/>
                <a:gd name="T7" fmla="*/ 474 h 553"/>
                <a:gd name="T8" fmla="*/ 465 h 553"/>
                <a:gd name="T9" fmla="*/ 454 h 553"/>
                <a:gd name="T10" fmla="*/ 445 h 553"/>
                <a:gd name="T11" fmla="*/ 434 h 553"/>
                <a:gd name="T12" fmla="*/ 425 h 553"/>
                <a:gd name="T13" fmla="*/ 414 h 553"/>
                <a:gd name="T14" fmla="*/ 405 h 553"/>
                <a:gd name="T15" fmla="*/ 394 h 553"/>
                <a:gd name="T16" fmla="*/ 385 h 553"/>
                <a:gd name="T17" fmla="*/ 374 h 553"/>
                <a:gd name="T18" fmla="*/ 365 h 553"/>
                <a:gd name="T19" fmla="*/ 354 h 553"/>
                <a:gd name="T20" fmla="*/ 345 h 553"/>
                <a:gd name="T21" fmla="*/ 334 h 553"/>
                <a:gd name="T22" fmla="*/ 325 h 553"/>
                <a:gd name="T23" fmla="*/ 314 h 553"/>
                <a:gd name="T24" fmla="*/ 305 h 553"/>
                <a:gd name="T25" fmla="*/ 294 h 553"/>
                <a:gd name="T26" fmla="*/ 285 h 553"/>
                <a:gd name="T27" fmla="*/ 274 h 553"/>
                <a:gd name="T28" fmla="*/ 265 h 553"/>
                <a:gd name="T29" fmla="*/ 254 h 553"/>
                <a:gd name="T30" fmla="*/ 245 h 553"/>
                <a:gd name="T31" fmla="*/ 234 h 553"/>
                <a:gd name="T32" fmla="*/ 225 h 553"/>
                <a:gd name="T33" fmla="*/ 214 h 553"/>
                <a:gd name="T34" fmla="*/ 205 h 553"/>
                <a:gd name="T35" fmla="*/ 194 h 553"/>
                <a:gd name="T36" fmla="*/ 185 h 553"/>
                <a:gd name="T37" fmla="*/ 174 h 553"/>
                <a:gd name="T38" fmla="*/ 165 h 553"/>
                <a:gd name="T39" fmla="*/ 154 h 553"/>
                <a:gd name="T40" fmla="*/ 145 h 553"/>
                <a:gd name="T41" fmla="*/ 134 h 553"/>
                <a:gd name="T42" fmla="*/ 125 h 553"/>
                <a:gd name="T43" fmla="*/ 114 h 553"/>
                <a:gd name="T44" fmla="*/ 105 h 553"/>
                <a:gd name="T45" fmla="*/ 94 h 553"/>
                <a:gd name="T46" fmla="*/ 85 h 553"/>
                <a:gd name="T47" fmla="*/ 74 h 553"/>
                <a:gd name="T48" fmla="*/ 65 h 553"/>
                <a:gd name="T49" fmla="*/ 54 h 553"/>
                <a:gd name="T50" fmla="*/ 45 h 553"/>
                <a:gd name="T51" fmla="*/ 34 h 553"/>
                <a:gd name="T52" fmla="*/ 25 h 553"/>
                <a:gd name="T53" fmla="*/ 14 h 553"/>
                <a:gd name="T54" fmla="*/ 5 h 5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  <a:cxn ang="0">
                  <a:pos x="0" y="T53"/>
                </a:cxn>
                <a:cxn ang="0">
                  <a:pos x="0" y="T54"/>
                </a:cxn>
              </a:cxnLst>
              <a:rect l="0" t="0" r="r" b="b"/>
              <a:pathLst>
                <a:path h="553">
                  <a:moveTo>
                    <a:pt x="0" y="550"/>
                  </a:moveTo>
                  <a:lnTo>
                    <a:pt x="0" y="549"/>
                  </a:lnTo>
                  <a:moveTo>
                    <a:pt x="0" y="546"/>
                  </a:moveTo>
                  <a:lnTo>
                    <a:pt x="0" y="545"/>
                  </a:lnTo>
                  <a:moveTo>
                    <a:pt x="0" y="542"/>
                  </a:moveTo>
                  <a:lnTo>
                    <a:pt x="0" y="541"/>
                  </a:lnTo>
                  <a:moveTo>
                    <a:pt x="0" y="538"/>
                  </a:moveTo>
                  <a:lnTo>
                    <a:pt x="0" y="537"/>
                  </a:lnTo>
                  <a:moveTo>
                    <a:pt x="0" y="534"/>
                  </a:moveTo>
                  <a:lnTo>
                    <a:pt x="0" y="533"/>
                  </a:lnTo>
                  <a:moveTo>
                    <a:pt x="0" y="530"/>
                  </a:moveTo>
                  <a:lnTo>
                    <a:pt x="0" y="529"/>
                  </a:lnTo>
                  <a:moveTo>
                    <a:pt x="0" y="526"/>
                  </a:moveTo>
                  <a:lnTo>
                    <a:pt x="0" y="525"/>
                  </a:lnTo>
                  <a:moveTo>
                    <a:pt x="0" y="522"/>
                  </a:moveTo>
                  <a:lnTo>
                    <a:pt x="0" y="521"/>
                  </a:lnTo>
                  <a:moveTo>
                    <a:pt x="0" y="518"/>
                  </a:moveTo>
                  <a:lnTo>
                    <a:pt x="0" y="517"/>
                  </a:lnTo>
                  <a:moveTo>
                    <a:pt x="0" y="514"/>
                  </a:moveTo>
                  <a:lnTo>
                    <a:pt x="0" y="513"/>
                  </a:lnTo>
                  <a:moveTo>
                    <a:pt x="0" y="510"/>
                  </a:moveTo>
                  <a:lnTo>
                    <a:pt x="0" y="509"/>
                  </a:lnTo>
                  <a:moveTo>
                    <a:pt x="0" y="506"/>
                  </a:moveTo>
                  <a:lnTo>
                    <a:pt x="0" y="505"/>
                  </a:lnTo>
                  <a:moveTo>
                    <a:pt x="0" y="502"/>
                  </a:moveTo>
                  <a:lnTo>
                    <a:pt x="0" y="501"/>
                  </a:lnTo>
                  <a:moveTo>
                    <a:pt x="0" y="498"/>
                  </a:moveTo>
                  <a:lnTo>
                    <a:pt x="0" y="497"/>
                  </a:lnTo>
                  <a:moveTo>
                    <a:pt x="0" y="494"/>
                  </a:moveTo>
                  <a:lnTo>
                    <a:pt x="0" y="493"/>
                  </a:lnTo>
                  <a:moveTo>
                    <a:pt x="0" y="490"/>
                  </a:moveTo>
                  <a:lnTo>
                    <a:pt x="0" y="489"/>
                  </a:lnTo>
                  <a:moveTo>
                    <a:pt x="0" y="486"/>
                  </a:moveTo>
                  <a:lnTo>
                    <a:pt x="0" y="485"/>
                  </a:lnTo>
                  <a:moveTo>
                    <a:pt x="0" y="482"/>
                  </a:moveTo>
                  <a:lnTo>
                    <a:pt x="0" y="481"/>
                  </a:lnTo>
                  <a:moveTo>
                    <a:pt x="0" y="478"/>
                  </a:moveTo>
                  <a:lnTo>
                    <a:pt x="0" y="477"/>
                  </a:lnTo>
                  <a:moveTo>
                    <a:pt x="0" y="474"/>
                  </a:moveTo>
                  <a:lnTo>
                    <a:pt x="0" y="473"/>
                  </a:lnTo>
                  <a:moveTo>
                    <a:pt x="0" y="470"/>
                  </a:moveTo>
                  <a:lnTo>
                    <a:pt x="0" y="469"/>
                  </a:lnTo>
                  <a:moveTo>
                    <a:pt x="0" y="466"/>
                  </a:moveTo>
                  <a:lnTo>
                    <a:pt x="0" y="465"/>
                  </a:lnTo>
                  <a:moveTo>
                    <a:pt x="0" y="462"/>
                  </a:moveTo>
                  <a:lnTo>
                    <a:pt x="0" y="461"/>
                  </a:lnTo>
                  <a:moveTo>
                    <a:pt x="0" y="458"/>
                  </a:moveTo>
                  <a:lnTo>
                    <a:pt x="0" y="457"/>
                  </a:lnTo>
                  <a:moveTo>
                    <a:pt x="0" y="454"/>
                  </a:moveTo>
                  <a:lnTo>
                    <a:pt x="0" y="453"/>
                  </a:lnTo>
                  <a:moveTo>
                    <a:pt x="0" y="450"/>
                  </a:moveTo>
                  <a:lnTo>
                    <a:pt x="0" y="449"/>
                  </a:lnTo>
                  <a:moveTo>
                    <a:pt x="0" y="446"/>
                  </a:moveTo>
                  <a:lnTo>
                    <a:pt x="0" y="445"/>
                  </a:lnTo>
                  <a:moveTo>
                    <a:pt x="0" y="442"/>
                  </a:moveTo>
                  <a:lnTo>
                    <a:pt x="0" y="441"/>
                  </a:lnTo>
                  <a:moveTo>
                    <a:pt x="0" y="438"/>
                  </a:moveTo>
                  <a:lnTo>
                    <a:pt x="0" y="437"/>
                  </a:lnTo>
                  <a:moveTo>
                    <a:pt x="0" y="434"/>
                  </a:moveTo>
                  <a:lnTo>
                    <a:pt x="0" y="433"/>
                  </a:lnTo>
                  <a:moveTo>
                    <a:pt x="0" y="430"/>
                  </a:moveTo>
                  <a:lnTo>
                    <a:pt x="0" y="429"/>
                  </a:lnTo>
                  <a:moveTo>
                    <a:pt x="0" y="426"/>
                  </a:moveTo>
                  <a:lnTo>
                    <a:pt x="0" y="425"/>
                  </a:lnTo>
                  <a:moveTo>
                    <a:pt x="0" y="422"/>
                  </a:moveTo>
                  <a:lnTo>
                    <a:pt x="0" y="421"/>
                  </a:lnTo>
                  <a:moveTo>
                    <a:pt x="0" y="418"/>
                  </a:moveTo>
                  <a:lnTo>
                    <a:pt x="0" y="417"/>
                  </a:lnTo>
                  <a:moveTo>
                    <a:pt x="0" y="414"/>
                  </a:moveTo>
                  <a:lnTo>
                    <a:pt x="0" y="413"/>
                  </a:lnTo>
                  <a:moveTo>
                    <a:pt x="0" y="410"/>
                  </a:moveTo>
                  <a:lnTo>
                    <a:pt x="0" y="409"/>
                  </a:lnTo>
                  <a:moveTo>
                    <a:pt x="0" y="406"/>
                  </a:moveTo>
                  <a:lnTo>
                    <a:pt x="0" y="405"/>
                  </a:lnTo>
                  <a:moveTo>
                    <a:pt x="0" y="402"/>
                  </a:moveTo>
                  <a:lnTo>
                    <a:pt x="0" y="401"/>
                  </a:lnTo>
                  <a:moveTo>
                    <a:pt x="0" y="398"/>
                  </a:moveTo>
                  <a:lnTo>
                    <a:pt x="0" y="397"/>
                  </a:lnTo>
                  <a:moveTo>
                    <a:pt x="0" y="394"/>
                  </a:moveTo>
                  <a:lnTo>
                    <a:pt x="0" y="393"/>
                  </a:lnTo>
                  <a:moveTo>
                    <a:pt x="0" y="390"/>
                  </a:moveTo>
                  <a:lnTo>
                    <a:pt x="0" y="389"/>
                  </a:lnTo>
                  <a:moveTo>
                    <a:pt x="0" y="386"/>
                  </a:moveTo>
                  <a:lnTo>
                    <a:pt x="0" y="385"/>
                  </a:lnTo>
                  <a:moveTo>
                    <a:pt x="0" y="382"/>
                  </a:moveTo>
                  <a:lnTo>
                    <a:pt x="0" y="381"/>
                  </a:lnTo>
                  <a:moveTo>
                    <a:pt x="0" y="378"/>
                  </a:moveTo>
                  <a:lnTo>
                    <a:pt x="0" y="377"/>
                  </a:lnTo>
                  <a:moveTo>
                    <a:pt x="0" y="374"/>
                  </a:moveTo>
                  <a:lnTo>
                    <a:pt x="0" y="373"/>
                  </a:lnTo>
                  <a:moveTo>
                    <a:pt x="0" y="370"/>
                  </a:moveTo>
                  <a:lnTo>
                    <a:pt x="0" y="369"/>
                  </a:lnTo>
                  <a:moveTo>
                    <a:pt x="0" y="366"/>
                  </a:moveTo>
                  <a:lnTo>
                    <a:pt x="0" y="365"/>
                  </a:lnTo>
                  <a:moveTo>
                    <a:pt x="0" y="362"/>
                  </a:moveTo>
                  <a:lnTo>
                    <a:pt x="0" y="361"/>
                  </a:lnTo>
                  <a:moveTo>
                    <a:pt x="0" y="358"/>
                  </a:moveTo>
                  <a:lnTo>
                    <a:pt x="0" y="357"/>
                  </a:lnTo>
                  <a:moveTo>
                    <a:pt x="0" y="354"/>
                  </a:moveTo>
                  <a:lnTo>
                    <a:pt x="0" y="353"/>
                  </a:lnTo>
                  <a:moveTo>
                    <a:pt x="0" y="350"/>
                  </a:moveTo>
                  <a:lnTo>
                    <a:pt x="0" y="349"/>
                  </a:lnTo>
                  <a:moveTo>
                    <a:pt x="0" y="346"/>
                  </a:moveTo>
                  <a:lnTo>
                    <a:pt x="0" y="345"/>
                  </a:lnTo>
                  <a:moveTo>
                    <a:pt x="0" y="342"/>
                  </a:moveTo>
                  <a:lnTo>
                    <a:pt x="0" y="341"/>
                  </a:lnTo>
                  <a:moveTo>
                    <a:pt x="0" y="338"/>
                  </a:moveTo>
                  <a:lnTo>
                    <a:pt x="0" y="337"/>
                  </a:lnTo>
                  <a:moveTo>
                    <a:pt x="0" y="334"/>
                  </a:moveTo>
                  <a:lnTo>
                    <a:pt x="0" y="333"/>
                  </a:lnTo>
                  <a:moveTo>
                    <a:pt x="0" y="330"/>
                  </a:moveTo>
                  <a:lnTo>
                    <a:pt x="0" y="329"/>
                  </a:lnTo>
                  <a:moveTo>
                    <a:pt x="0" y="326"/>
                  </a:moveTo>
                  <a:lnTo>
                    <a:pt x="0" y="325"/>
                  </a:lnTo>
                  <a:moveTo>
                    <a:pt x="0" y="322"/>
                  </a:moveTo>
                  <a:lnTo>
                    <a:pt x="0" y="321"/>
                  </a:lnTo>
                  <a:moveTo>
                    <a:pt x="0" y="318"/>
                  </a:moveTo>
                  <a:lnTo>
                    <a:pt x="0" y="317"/>
                  </a:lnTo>
                  <a:moveTo>
                    <a:pt x="0" y="314"/>
                  </a:moveTo>
                  <a:lnTo>
                    <a:pt x="0" y="313"/>
                  </a:lnTo>
                  <a:moveTo>
                    <a:pt x="0" y="310"/>
                  </a:moveTo>
                  <a:lnTo>
                    <a:pt x="0" y="309"/>
                  </a:lnTo>
                  <a:moveTo>
                    <a:pt x="0" y="306"/>
                  </a:moveTo>
                  <a:lnTo>
                    <a:pt x="0" y="305"/>
                  </a:lnTo>
                  <a:moveTo>
                    <a:pt x="0" y="302"/>
                  </a:moveTo>
                  <a:lnTo>
                    <a:pt x="0" y="301"/>
                  </a:lnTo>
                  <a:moveTo>
                    <a:pt x="0" y="298"/>
                  </a:moveTo>
                  <a:lnTo>
                    <a:pt x="0" y="297"/>
                  </a:lnTo>
                  <a:moveTo>
                    <a:pt x="0" y="294"/>
                  </a:moveTo>
                  <a:lnTo>
                    <a:pt x="0" y="293"/>
                  </a:lnTo>
                  <a:moveTo>
                    <a:pt x="0" y="290"/>
                  </a:moveTo>
                  <a:lnTo>
                    <a:pt x="0" y="289"/>
                  </a:lnTo>
                  <a:moveTo>
                    <a:pt x="0" y="286"/>
                  </a:moveTo>
                  <a:lnTo>
                    <a:pt x="0" y="285"/>
                  </a:lnTo>
                  <a:moveTo>
                    <a:pt x="0" y="282"/>
                  </a:moveTo>
                  <a:lnTo>
                    <a:pt x="0" y="281"/>
                  </a:lnTo>
                  <a:moveTo>
                    <a:pt x="0" y="278"/>
                  </a:moveTo>
                  <a:lnTo>
                    <a:pt x="0" y="277"/>
                  </a:lnTo>
                  <a:moveTo>
                    <a:pt x="0" y="274"/>
                  </a:moveTo>
                  <a:lnTo>
                    <a:pt x="0" y="273"/>
                  </a:lnTo>
                  <a:moveTo>
                    <a:pt x="0" y="270"/>
                  </a:moveTo>
                  <a:lnTo>
                    <a:pt x="0" y="269"/>
                  </a:lnTo>
                  <a:moveTo>
                    <a:pt x="0" y="266"/>
                  </a:moveTo>
                  <a:lnTo>
                    <a:pt x="0" y="265"/>
                  </a:lnTo>
                  <a:moveTo>
                    <a:pt x="0" y="262"/>
                  </a:moveTo>
                  <a:lnTo>
                    <a:pt x="0" y="261"/>
                  </a:lnTo>
                  <a:moveTo>
                    <a:pt x="0" y="258"/>
                  </a:moveTo>
                  <a:lnTo>
                    <a:pt x="0" y="257"/>
                  </a:lnTo>
                  <a:moveTo>
                    <a:pt x="0" y="254"/>
                  </a:moveTo>
                  <a:lnTo>
                    <a:pt x="0" y="253"/>
                  </a:lnTo>
                  <a:moveTo>
                    <a:pt x="0" y="250"/>
                  </a:moveTo>
                  <a:lnTo>
                    <a:pt x="0" y="249"/>
                  </a:lnTo>
                  <a:moveTo>
                    <a:pt x="0" y="246"/>
                  </a:moveTo>
                  <a:lnTo>
                    <a:pt x="0" y="245"/>
                  </a:lnTo>
                  <a:moveTo>
                    <a:pt x="0" y="242"/>
                  </a:moveTo>
                  <a:lnTo>
                    <a:pt x="0" y="241"/>
                  </a:lnTo>
                  <a:moveTo>
                    <a:pt x="0" y="238"/>
                  </a:moveTo>
                  <a:lnTo>
                    <a:pt x="0" y="237"/>
                  </a:lnTo>
                  <a:moveTo>
                    <a:pt x="0" y="234"/>
                  </a:moveTo>
                  <a:lnTo>
                    <a:pt x="0" y="233"/>
                  </a:lnTo>
                  <a:moveTo>
                    <a:pt x="0" y="230"/>
                  </a:moveTo>
                  <a:lnTo>
                    <a:pt x="0" y="229"/>
                  </a:lnTo>
                  <a:moveTo>
                    <a:pt x="0" y="226"/>
                  </a:moveTo>
                  <a:lnTo>
                    <a:pt x="0" y="225"/>
                  </a:lnTo>
                  <a:moveTo>
                    <a:pt x="0" y="222"/>
                  </a:moveTo>
                  <a:lnTo>
                    <a:pt x="0" y="221"/>
                  </a:lnTo>
                  <a:moveTo>
                    <a:pt x="0" y="218"/>
                  </a:moveTo>
                  <a:lnTo>
                    <a:pt x="0" y="217"/>
                  </a:lnTo>
                  <a:moveTo>
                    <a:pt x="0" y="214"/>
                  </a:moveTo>
                  <a:lnTo>
                    <a:pt x="0" y="213"/>
                  </a:lnTo>
                  <a:moveTo>
                    <a:pt x="0" y="210"/>
                  </a:moveTo>
                  <a:lnTo>
                    <a:pt x="0" y="209"/>
                  </a:lnTo>
                  <a:moveTo>
                    <a:pt x="0" y="206"/>
                  </a:moveTo>
                  <a:lnTo>
                    <a:pt x="0" y="205"/>
                  </a:lnTo>
                  <a:moveTo>
                    <a:pt x="0" y="202"/>
                  </a:moveTo>
                  <a:lnTo>
                    <a:pt x="0" y="201"/>
                  </a:lnTo>
                  <a:moveTo>
                    <a:pt x="0" y="198"/>
                  </a:moveTo>
                  <a:lnTo>
                    <a:pt x="0" y="197"/>
                  </a:lnTo>
                  <a:moveTo>
                    <a:pt x="0" y="194"/>
                  </a:moveTo>
                  <a:lnTo>
                    <a:pt x="0" y="193"/>
                  </a:lnTo>
                  <a:moveTo>
                    <a:pt x="0" y="190"/>
                  </a:moveTo>
                  <a:lnTo>
                    <a:pt x="0" y="189"/>
                  </a:lnTo>
                  <a:moveTo>
                    <a:pt x="0" y="186"/>
                  </a:moveTo>
                  <a:lnTo>
                    <a:pt x="0" y="185"/>
                  </a:lnTo>
                  <a:moveTo>
                    <a:pt x="0" y="182"/>
                  </a:moveTo>
                  <a:lnTo>
                    <a:pt x="0" y="181"/>
                  </a:lnTo>
                  <a:moveTo>
                    <a:pt x="0" y="178"/>
                  </a:moveTo>
                  <a:lnTo>
                    <a:pt x="0" y="177"/>
                  </a:lnTo>
                  <a:moveTo>
                    <a:pt x="0" y="174"/>
                  </a:moveTo>
                  <a:lnTo>
                    <a:pt x="0" y="173"/>
                  </a:lnTo>
                  <a:moveTo>
                    <a:pt x="0" y="170"/>
                  </a:moveTo>
                  <a:lnTo>
                    <a:pt x="0" y="169"/>
                  </a:lnTo>
                  <a:moveTo>
                    <a:pt x="0" y="166"/>
                  </a:moveTo>
                  <a:lnTo>
                    <a:pt x="0" y="165"/>
                  </a:lnTo>
                  <a:moveTo>
                    <a:pt x="0" y="162"/>
                  </a:moveTo>
                  <a:lnTo>
                    <a:pt x="0" y="161"/>
                  </a:lnTo>
                  <a:moveTo>
                    <a:pt x="0" y="158"/>
                  </a:moveTo>
                  <a:lnTo>
                    <a:pt x="0" y="157"/>
                  </a:lnTo>
                  <a:moveTo>
                    <a:pt x="0" y="154"/>
                  </a:moveTo>
                  <a:lnTo>
                    <a:pt x="0" y="153"/>
                  </a:lnTo>
                  <a:moveTo>
                    <a:pt x="0" y="150"/>
                  </a:moveTo>
                  <a:lnTo>
                    <a:pt x="0" y="149"/>
                  </a:lnTo>
                  <a:moveTo>
                    <a:pt x="0" y="146"/>
                  </a:moveTo>
                  <a:lnTo>
                    <a:pt x="0" y="145"/>
                  </a:lnTo>
                  <a:moveTo>
                    <a:pt x="0" y="142"/>
                  </a:moveTo>
                  <a:lnTo>
                    <a:pt x="0" y="141"/>
                  </a:lnTo>
                  <a:moveTo>
                    <a:pt x="0" y="138"/>
                  </a:moveTo>
                  <a:lnTo>
                    <a:pt x="0" y="137"/>
                  </a:lnTo>
                  <a:moveTo>
                    <a:pt x="0" y="134"/>
                  </a:moveTo>
                  <a:lnTo>
                    <a:pt x="0" y="133"/>
                  </a:lnTo>
                  <a:moveTo>
                    <a:pt x="0" y="130"/>
                  </a:moveTo>
                  <a:lnTo>
                    <a:pt x="0" y="129"/>
                  </a:lnTo>
                  <a:moveTo>
                    <a:pt x="0" y="126"/>
                  </a:moveTo>
                  <a:lnTo>
                    <a:pt x="0" y="125"/>
                  </a:lnTo>
                  <a:moveTo>
                    <a:pt x="0" y="122"/>
                  </a:moveTo>
                  <a:lnTo>
                    <a:pt x="0" y="121"/>
                  </a:lnTo>
                  <a:moveTo>
                    <a:pt x="0" y="118"/>
                  </a:moveTo>
                  <a:lnTo>
                    <a:pt x="0" y="117"/>
                  </a:lnTo>
                  <a:moveTo>
                    <a:pt x="0" y="114"/>
                  </a:moveTo>
                  <a:lnTo>
                    <a:pt x="0" y="113"/>
                  </a:lnTo>
                  <a:moveTo>
                    <a:pt x="0" y="110"/>
                  </a:moveTo>
                  <a:lnTo>
                    <a:pt x="0" y="109"/>
                  </a:lnTo>
                  <a:moveTo>
                    <a:pt x="0" y="106"/>
                  </a:moveTo>
                  <a:lnTo>
                    <a:pt x="0" y="105"/>
                  </a:lnTo>
                  <a:moveTo>
                    <a:pt x="0" y="102"/>
                  </a:moveTo>
                  <a:lnTo>
                    <a:pt x="0" y="101"/>
                  </a:lnTo>
                  <a:moveTo>
                    <a:pt x="0" y="98"/>
                  </a:moveTo>
                  <a:lnTo>
                    <a:pt x="0" y="97"/>
                  </a:lnTo>
                  <a:moveTo>
                    <a:pt x="0" y="94"/>
                  </a:moveTo>
                  <a:lnTo>
                    <a:pt x="0" y="93"/>
                  </a:lnTo>
                  <a:moveTo>
                    <a:pt x="0" y="90"/>
                  </a:moveTo>
                  <a:lnTo>
                    <a:pt x="0" y="89"/>
                  </a:lnTo>
                  <a:moveTo>
                    <a:pt x="0" y="86"/>
                  </a:moveTo>
                  <a:lnTo>
                    <a:pt x="0" y="85"/>
                  </a:lnTo>
                  <a:moveTo>
                    <a:pt x="0" y="82"/>
                  </a:moveTo>
                  <a:lnTo>
                    <a:pt x="0" y="81"/>
                  </a:lnTo>
                  <a:moveTo>
                    <a:pt x="0" y="78"/>
                  </a:moveTo>
                  <a:lnTo>
                    <a:pt x="0" y="77"/>
                  </a:lnTo>
                  <a:moveTo>
                    <a:pt x="0" y="74"/>
                  </a:moveTo>
                  <a:lnTo>
                    <a:pt x="0" y="73"/>
                  </a:lnTo>
                  <a:moveTo>
                    <a:pt x="0" y="70"/>
                  </a:moveTo>
                  <a:lnTo>
                    <a:pt x="0" y="69"/>
                  </a:lnTo>
                  <a:moveTo>
                    <a:pt x="0" y="66"/>
                  </a:moveTo>
                  <a:lnTo>
                    <a:pt x="0" y="65"/>
                  </a:lnTo>
                  <a:moveTo>
                    <a:pt x="0" y="62"/>
                  </a:moveTo>
                  <a:lnTo>
                    <a:pt x="0" y="61"/>
                  </a:lnTo>
                  <a:moveTo>
                    <a:pt x="0" y="58"/>
                  </a:moveTo>
                  <a:lnTo>
                    <a:pt x="0" y="57"/>
                  </a:lnTo>
                  <a:moveTo>
                    <a:pt x="0" y="54"/>
                  </a:moveTo>
                  <a:lnTo>
                    <a:pt x="0" y="53"/>
                  </a:lnTo>
                  <a:moveTo>
                    <a:pt x="0" y="50"/>
                  </a:moveTo>
                  <a:lnTo>
                    <a:pt x="0" y="49"/>
                  </a:lnTo>
                  <a:moveTo>
                    <a:pt x="0" y="46"/>
                  </a:moveTo>
                  <a:lnTo>
                    <a:pt x="0" y="45"/>
                  </a:lnTo>
                  <a:moveTo>
                    <a:pt x="0" y="42"/>
                  </a:moveTo>
                  <a:lnTo>
                    <a:pt x="0" y="41"/>
                  </a:lnTo>
                  <a:moveTo>
                    <a:pt x="0" y="38"/>
                  </a:moveTo>
                  <a:lnTo>
                    <a:pt x="0" y="37"/>
                  </a:lnTo>
                  <a:moveTo>
                    <a:pt x="0" y="34"/>
                  </a:moveTo>
                  <a:lnTo>
                    <a:pt x="0" y="33"/>
                  </a:lnTo>
                  <a:moveTo>
                    <a:pt x="0" y="30"/>
                  </a:moveTo>
                  <a:lnTo>
                    <a:pt x="0" y="29"/>
                  </a:lnTo>
                  <a:moveTo>
                    <a:pt x="0" y="26"/>
                  </a:moveTo>
                  <a:lnTo>
                    <a:pt x="0" y="25"/>
                  </a:lnTo>
                  <a:moveTo>
                    <a:pt x="0" y="22"/>
                  </a:moveTo>
                  <a:lnTo>
                    <a:pt x="0" y="21"/>
                  </a:lnTo>
                  <a:moveTo>
                    <a:pt x="0" y="18"/>
                  </a:moveTo>
                  <a:lnTo>
                    <a:pt x="0" y="17"/>
                  </a:lnTo>
                  <a:moveTo>
                    <a:pt x="0" y="14"/>
                  </a:moveTo>
                  <a:lnTo>
                    <a:pt x="0" y="13"/>
                  </a:lnTo>
                  <a:moveTo>
                    <a:pt x="0" y="10"/>
                  </a:moveTo>
                  <a:lnTo>
                    <a:pt x="0" y="9"/>
                  </a:lnTo>
                  <a:moveTo>
                    <a:pt x="0" y="6"/>
                  </a:moveTo>
                  <a:lnTo>
                    <a:pt x="0" y="5"/>
                  </a:lnTo>
                  <a:moveTo>
                    <a:pt x="0" y="2"/>
                  </a:moveTo>
                  <a:lnTo>
                    <a:pt x="0" y="1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Freeform 45">
              <a:extLst>
                <a:ext uri="{FF2B5EF4-FFF2-40B4-BE49-F238E27FC236}">
                  <a16:creationId xmlns:a16="http://schemas.microsoft.com/office/drawing/2014/main" id="{45C06CA5-8344-4F31-9B60-DC98FD47F90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762785" y="4684000"/>
              <a:ext cx="358140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Freeform 46">
              <a:extLst>
                <a:ext uri="{FF2B5EF4-FFF2-40B4-BE49-F238E27FC236}">
                  <a16:creationId xmlns:a16="http://schemas.microsoft.com/office/drawing/2014/main" id="{BE460062-9571-4A1A-823A-15A51310D85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762785" y="4353800"/>
              <a:ext cx="358140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Freeform 47">
              <a:extLst>
                <a:ext uri="{FF2B5EF4-FFF2-40B4-BE49-F238E27FC236}">
                  <a16:creationId xmlns:a16="http://schemas.microsoft.com/office/drawing/2014/main" id="{7908EF89-2001-40EE-A663-4D9E8C7A7A7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762785" y="4023600"/>
              <a:ext cx="358140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Freeform 48">
              <a:extLst>
                <a:ext uri="{FF2B5EF4-FFF2-40B4-BE49-F238E27FC236}">
                  <a16:creationId xmlns:a16="http://schemas.microsoft.com/office/drawing/2014/main" id="{31F0CB9C-B427-4B03-882A-9C7269603AA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762785" y="3687050"/>
              <a:ext cx="358140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Freeform 49">
              <a:extLst>
                <a:ext uri="{FF2B5EF4-FFF2-40B4-BE49-F238E27FC236}">
                  <a16:creationId xmlns:a16="http://schemas.microsoft.com/office/drawing/2014/main" id="{7E038C01-E289-4F06-8727-B186A9184D3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762785" y="3356850"/>
              <a:ext cx="358140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Freeform 50">
              <a:extLst>
                <a:ext uri="{FF2B5EF4-FFF2-40B4-BE49-F238E27FC236}">
                  <a16:creationId xmlns:a16="http://schemas.microsoft.com/office/drawing/2014/main" id="{32DA4383-AA29-42DA-8305-5F0A541C885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762785" y="3026650"/>
              <a:ext cx="358140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Freeform 51">
              <a:extLst>
                <a:ext uri="{FF2B5EF4-FFF2-40B4-BE49-F238E27FC236}">
                  <a16:creationId xmlns:a16="http://schemas.microsoft.com/office/drawing/2014/main" id="{019CAEEA-016C-433C-BD80-EA806C789A8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762785" y="2696450"/>
              <a:ext cx="358140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Freeform 52">
              <a:extLst>
                <a:ext uri="{FF2B5EF4-FFF2-40B4-BE49-F238E27FC236}">
                  <a16:creationId xmlns:a16="http://schemas.microsoft.com/office/drawing/2014/main" id="{54B94368-0EE3-4D1D-A834-4CAFDBE4F46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762785" y="2359900"/>
              <a:ext cx="358140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Freeform 53">
              <a:extLst>
                <a:ext uri="{FF2B5EF4-FFF2-40B4-BE49-F238E27FC236}">
                  <a16:creationId xmlns:a16="http://schemas.microsoft.com/office/drawing/2014/main" id="{0649BA82-95F2-4C4F-A6EB-CC1C1182E32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762785" y="2029700"/>
              <a:ext cx="358140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9" name="Freeform 54">
              <a:extLst>
                <a:ext uri="{FF2B5EF4-FFF2-40B4-BE49-F238E27FC236}">
                  <a16:creationId xmlns:a16="http://schemas.microsoft.com/office/drawing/2014/main" id="{272EB7CC-FC0A-4DA2-BCC5-A2DC5F544CC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762785" y="1699500"/>
              <a:ext cx="358140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0" name="Freeform 55">
              <a:extLst>
                <a:ext uri="{FF2B5EF4-FFF2-40B4-BE49-F238E27FC236}">
                  <a16:creationId xmlns:a16="http://schemas.microsoft.com/office/drawing/2014/main" id="{D3B1015D-EE4C-4BB3-ABDE-B3BF92AB886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762785" y="1362950"/>
              <a:ext cx="3581400" cy="0"/>
            </a:xfrm>
            <a:custGeom>
              <a:avLst/>
              <a:gdLst>
                <a:gd name="T0" fmla="*/ 8 w 553"/>
                <a:gd name="T1" fmla="*/ 19 w 553"/>
                <a:gd name="T2" fmla="*/ 28 w 553"/>
                <a:gd name="T3" fmla="*/ 39 w 553"/>
                <a:gd name="T4" fmla="*/ 48 w 553"/>
                <a:gd name="T5" fmla="*/ 59 w 553"/>
                <a:gd name="T6" fmla="*/ 68 w 553"/>
                <a:gd name="T7" fmla="*/ 79 w 553"/>
                <a:gd name="T8" fmla="*/ 88 w 553"/>
                <a:gd name="T9" fmla="*/ 99 w 553"/>
                <a:gd name="T10" fmla="*/ 108 w 553"/>
                <a:gd name="T11" fmla="*/ 119 w 553"/>
                <a:gd name="T12" fmla="*/ 128 w 553"/>
                <a:gd name="T13" fmla="*/ 139 w 553"/>
                <a:gd name="T14" fmla="*/ 148 w 553"/>
                <a:gd name="T15" fmla="*/ 159 w 553"/>
                <a:gd name="T16" fmla="*/ 168 w 553"/>
                <a:gd name="T17" fmla="*/ 179 w 553"/>
                <a:gd name="T18" fmla="*/ 188 w 553"/>
                <a:gd name="T19" fmla="*/ 199 w 553"/>
                <a:gd name="T20" fmla="*/ 208 w 553"/>
                <a:gd name="T21" fmla="*/ 219 w 553"/>
                <a:gd name="T22" fmla="*/ 228 w 553"/>
                <a:gd name="T23" fmla="*/ 239 w 553"/>
                <a:gd name="T24" fmla="*/ 248 w 553"/>
                <a:gd name="T25" fmla="*/ 259 w 553"/>
                <a:gd name="T26" fmla="*/ 268 w 553"/>
                <a:gd name="T27" fmla="*/ 279 w 553"/>
                <a:gd name="T28" fmla="*/ 288 w 553"/>
                <a:gd name="T29" fmla="*/ 299 w 553"/>
                <a:gd name="T30" fmla="*/ 308 w 553"/>
                <a:gd name="T31" fmla="*/ 319 w 553"/>
                <a:gd name="T32" fmla="*/ 328 w 553"/>
                <a:gd name="T33" fmla="*/ 339 w 553"/>
                <a:gd name="T34" fmla="*/ 348 w 553"/>
                <a:gd name="T35" fmla="*/ 359 w 553"/>
                <a:gd name="T36" fmla="*/ 368 w 553"/>
                <a:gd name="T37" fmla="*/ 379 w 553"/>
                <a:gd name="T38" fmla="*/ 388 w 553"/>
                <a:gd name="T39" fmla="*/ 399 w 553"/>
                <a:gd name="T40" fmla="*/ 408 w 553"/>
                <a:gd name="T41" fmla="*/ 419 w 553"/>
                <a:gd name="T42" fmla="*/ 428 w 553"/>
                <a:gd name="T43" fmla="*/ 439 w 553"/>
                <a:gd name="T44" fmla="*/ 448 w 553"/>
                <a:gd name="T45" fmla="*/ 459 w 553"/>
                <a:gd name="T46" fmla="*/ 468 w 553"/>
                <a:gd name="T47" fmla="*/ 479 w 553"/>
                <a:gd name="T48" fmla="*/ 488 w 553"/>
                <a:gd name="T49" fmla="*/ 499 w 553"/>
                <a:gd name="T50" fmla="*/ 508 w 553"/>
                <a:gd name="T51" fmla="*/ 519 w 553"/>
                <a:gd name="T52" fmla="*/ 528 w 553"/>
                <a:gd name="T53" fmla="*/ 539 w 553"/>
                <a:gd name="T54" fmla="*/ 548 w 55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</a:cxnLst>
              <a:rect l="0" t="0" r="r" b="b"/>
              <a:pathLst>
                <a:path w="553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5" y="0"/>
                  </a:moveTo>
                  <a:lnTo>
                    <a:pt x="156" y="0"/>
                  </a:lnTo>
                  <a:moveTo>
                    <a:pt x="159" y="0"/>
                  </a:moveTo>
                  <a:lnTo>
                    <a:pt x="160" y="0"/>
                  </a:lnTo>
                  <a:moveTo>
                    <a:pt x="163" y="0"/>
                  </a:moveTo>
                  <a:lnTo>
                    <a:pt x="164" y="0"/>
                  </a:lnTo>
                  <a:moveTo>
                    <a:pt x="167" y="0"/>
                  </a:moveTo>
                  <a:lnTo>
                    <a:pt x="168" y="0"/>
                  </a:lnTo>
                  <a:moveTo>
                    <a:pt x="171" y="0"/>
                  </a:moveTo>
                  <a:lnTo>
                    <a:pt x="172" y="0"/>
                  </a:lnTo>
                  <a:moveTo>
                    <a:pt x="175" y="0"/>
                  </a:moveTo>
                  <a:lnTo>
                    <a:pt x="176" y="0"/>
                  </a:lnTo>
                  <a:moveTo>
                    <a:pt x="179" y="0"/>
                  </a:moveTo>
                  <a:lnTo>
                    <a:pt x="180" y="0"/>
                  </a:lnTo>
                  <a:moveTo>
                    <a:pt x="183" y="0"/>
                  </a:moveTo>
                  <a:lnTo>
                    <a:pt x="184" y="0"/>
                  </a:lnTo>
                  <a:moveTo>
                    <a:pt x="187" y="0"/>
                  </a:moveTo>
                  <a:lnTo>
                    <a:pt x="188" y="0"/>
                  </a:lnTo>
                  <a:moveTo>
                    <a:pt x="191" y="0"/>
                  </a:moveTo>
                  <a:lnTo>
                    <a:pt x="192" y="0"/>
                  </a:lnTo>
                  <a:moveTo>
                    <a:pt x="195" y="0"/>
                  </a:moveTo>
                  <a:lnTo>
                    <a:pt x="196" y="0"/>
                  </a:lnTo>
                  <a:moveTo>
                    <a:pt x="199" y="0"/>
                  </a:moveTo>
                  <a:lnTo>
                    <a:pt x="200" y="0"/>
                  </a:lnTo>
                  <a:moveTo>
                    <a:pt x="203" y="0"/>
                  </a:moveTo>
                  <a:lnTo>
                    <a:pt x="204" y="0"/>
                  </a:lnTo>
                  <a:moveTo>
                    <a:pt x="207" y="0"/>
                  </a:moveTo>
                  <a:lnTo>
                    <a:pt x="208" y="0"/>
                  </a:lnTo>
                  <a:moveTo>
                    <a:pt x="211" y="0"/>
                  </a:moveTo>
                  <a:lnTo>
                    <a:pt x="212" y="0"/>
                  </a:lnTo>
                  <a:moveTo>
                    <a:pt x="215" y="0"/>
                  </a:moveTo>
                  <a:lnTo>
                    <a:pt x="216" y="0"/>
                  </a:lnTo>
                  <a:moveTo>
                    <a:pt x="219" y="0"/>
                  </a:moveTo>
                  <a:lnTo>
                    <a:pt x="220" y="0"/>
                  </a:lnTo>
                  <a:moveTo>
                    <a:pt x="223" y="0"/>
                  </a:moveTo>
                  <a:lnTo>
                    <a:pt x="224" y="0"/>
                  </a:lnTo>
                  <a:moveTo>
                    <a:pt x="227" y="0"/>
                  </a:moveTo>
                  <a:lnTo>
                    <a:pt x="228" y="0"/>
                  </a:lnTo>
                  <a:moveTo>
                    <a:pt x="231" y="0"/>
                  </a:moveTo>
                  <a:lnTo>
                    <a:pt x="232" y="0"/>
                  </a:lnTo>
                  <a:moveTo>
                    <a:pt x="235" y="0"/>
                  </a:moveTo>
                  <a:lnTo>
                    <a:pt x="236" y="0"/>
                  </a:lnTo>
                  <a:moveTo>
                    <a:pt x="239" y="0"/>
                  </a:moveTo>
                  <a:lnTo>
                    <a:pt x="240" y="0"/>
                  </a:lnTo>
                  <a:moveTo>
                    <a:pt x="243" y="0"/>
                  </a:moveTo>
                  <a:lnTo>
                    <a:pt x="244" y="0"/>
                  </a:lnTo>
                  <a:moveTo>
                    <a:pt x="247" y="0"/>
                  </a:moveTo>
                  <a:lnTo>
                    <a:pt x="248" y="0"/>
                  </a:lnTo>
                  <a:moveTo>
                    <a:pt x="251" y="0"/>
                  </a:moveTo>
                  <a:lnTo>
                    <a:pt x="252" y="0"/>
                  </a:lnTo>
                  <a:moveTo>
                    <a:pt x="255" y="0"/>
                  </a:moveTo>
                  <a:lnTo>
                    <a:pt x="256" y="0"/>
                  </a:lnTo>
                  <a:moveTo>
                    <a:pt x="259" y="0"/>
                  </a:moveTo>
                  <a:lnTo>
                    <a:pt x="260" y="0"/>
                  </a:lnTo>
                  <a:moveTo>
                    <a:pt x="263" y="0"/>
                  </a:moveTo>
                  <a:lnTo>
                    <a:pt x="264" y="0"/>
                  </a:lnTo>
                  <a:moveTo>
                    <a:pt x="267" y="0"/>
                  </a:moveTo>
                  <a:lnTo>
                    <a:pt x="268" y="0"/>
                  </a:lnTo>
                  <a:moveTo>
                    <a:pt x="271" y="0"/>
                  </a:moveTo>
                  <a:lnTo>
                    <a:pt x="272" y="0"/>
                  </a:lnTo>
                  <a:moveTo>
                    <a:pt x="275" y="0"/>
                  </a:moveTo>
                  <a:lnTo>
                    <a:pt x="276" y="0"/>
                  </a:lnTo>
                  <a:moveTo>
                    <a:pt x="279" y="0"/>
                  </a:moveTo>
                  <a:lnTo>
                    <a:pt x="280" y="0"/>
                  </a:lnTo>
                  <a:moveTo>
                    <a:pt x="283" y="0"/>
                  </a:moveTo>
                  <a:lnTo>
                    <a:pt x="284" y="0"/>
                  </a:lnTo>
                  <a:moveTo>
                    <a:pt x="287" y="0"/>
                  </a:moveTo>
                  <a:lnTo>
                    <a:pt x="288" y="0"/>
                  </a:lnTo>
                  <a:moveTo>
                    <a:pt x="291" y="0"/>
                  </a:moveTo>
                  <a:lnTo>
                    <a:pt x="292" y="0"/>
                  </a:lnTo>
                  <a:moveTo>
                    <a:pt x="295" y="0"/>
                  </a:moveTo>
                  <a:lnTo>
                    <a:pt x="296" y="0"/>
                  </a:lnTo>
                  <a:moveTo>
                    <a:pt x="299" y="0"/>
                  </a:moveTo>
                  <a:lnTo>
                    <a:pt x="300" y="0"/>
                  </a:lnTo>
                  <a:moveTo>
                    <a:pt x="303" y="0"/>
                  </a:moveTo>
                  <a:lnTo>
                    <a:pt x="304" y="0"/>
                  </a:lnTo>
                  <a:moveTo>
                    <a:pt x="307" y="0"/>
                  </a:moveTo>
                  <a:lnTo>
                    <a:pt x="308" y="0"/>
                  </a:lnTo>
                  <a:moveTo>
                    <a:pt x="311" y="0"/>
                  </a:moveTo>
                  <a:lnTo>
                    <a:pt x="312" y="0"/>
                  </a:lnTo>
                  <a:moveTo>
                    <a:pt x="315" y="0"/>
                  </a:moveTo>
                  <a:lnTo>
                    <a:pt x="316" y="0"/>
                  </a:lnTo>
                  <a:moveTo>
                    <a:pt x="319" y="0"/>
                  </a:moveTo>
                  <a:lnTo>
                    <a:pt x="320" y="0"/>
                  </a:lnTo>
                  <a:moveTo>
                    <a:pt x="323" y="0"/>
                  </a:moveTo>
                  <a:lnTo>
                    <a:pt x="324" y="0"/>
                  </a:lnTo>
                  <a:moveTo>
                    <a:pt x="327" y="0"/>
                  </a:moveTo>
                  <a:lnTo>
                    <a:pt x="328" y="0"/>
                  </a:lnTo>
                  <a:moveTo>
                    <a:pt x="331" y="0"/>
                  </a:moveTo>
                  <a:lnTo>
                    <a:pt x="332" y="0"/>
                  </a:lnTo>
                  <a:moveTo>
                    <a:pt x="335" y="0"/>
                  </a:moveTo>
                  <a:lnTo>
                    <a:pt x="336" y="0"/>
                  </a:lnTo>
                  <a:moveTo>
                    <a:pt x="339" y="0"/>
                  </a:moveTo>
                  <a:lnTo>
                    <a:pt x="340" y="0"/>
                  </a:lnTo>
                  <a:moveTo>
                    <a:pt x="343" y="0"/>
                  </a:moveTo>
                  <a:lnTo>
                    <a:pt x="344" y="0"/>
                  </a:lnTo>
                  <a:moveTo>
                    <a:pt x="347" y="0"/>
                  </a:moveTo>
                  <a:lnTo>
                    <a:pt x="348" y="0"/>
                  </a:lnTo>
                  <a:moveTo>
                    <a:pt x="351" y="0"/>
                  </a:moveTo>
                  <a:lnTo>
                    <a:pt x="352" y="0"/>
                  </a:lnTo>
                  <a:moveTo>
                    <a:pt x="355" y="0"/>
                  </a:moveTo>
                  <a:lnTo>
                    <a:pt x="356" y="0"/>
                  </a:lnTo>
                  <a:moveTo>
                    <a:pt x="359" y="0"/>
                  </a:moveTo>
                  <a:lnTo>
                    <a:pt x="360" y="0"/>
                  </a:lnTo>
                  <a:moveTo>
                    <a:pt x="363" y="0"/>
                  </a:moveTo>
                  <a:lnTo>
                    <a:pt x="364" y="0"/>
                  </a:lnTo>
                  <a:moveTo>
                    <a:pt x="367" y="0"/>
                  </a:moveTo>
                  <a:lnTo>
                    <a:pt x="368" y="0"/>
                  </a:lnTo>
                  <a:moveTo>
                    <a:pt x="371" y="0"/>
                  </a:moveTo>
                  <a:lnTo>
                    <a:pt x="372" y="0"/>
                  </a:lnTo>
                  <a:moveTo>
                    <a:pt x="375" y="0"/>
                  </a:moveTo>
                  <a:lnTo>
                    <a:pt x="376" y="0"/>
                  </a:lnTo>
                  <a:moveTo>
                    <a:pt x="379" y="0"/>
                  </a:moveTo>
                  <a:lnTo>
                    <a:pt x="380" y="0"/>
                  </a:lnTo>
                  <a:moveTo>
                    <a:pt x="383" y="0"/>
                  </a:moveTo>
                  <a:lnTo>
                    <a:pt x="384" y="0"/>
                  </a:lnTo>
                  <a:moveTo>
                    <a:pt x="387" y="0"/>
                  </a:moveTo>
                  <a:lnTo>
                    <a:pt x="388" y="0"/>
                  </a:lnTo>
                  <a:moveTo>
                    <a:pt x="391" y="0"/>
                  </a:moveTo>
                  <a:lnTo>
                    <a:pt x="392" y="0"/>
                  </a:lnTo>
                  <a:moveTo>
                    <a:pt x="395" y="0"/>
                  </a:moveTo>
                  <a:lnTo>
                    <a:pt x="396" y="0"/>
                  </a:lnTo>
                  <a:moveTo>
                    <a:pt x="399" y="0"/>
                  </a:moveTo>
                  <a:lnTo>
                    <a:pt x="400" y="0"/>
                  </a:lnTo>
                  <a:moveTo>
                    <a:pt x="403" y="0"/>
                  </a:moveTo>
                  <a:lnTo>
                    <a:pt x="404" y="0"/>
                  </a:lnTo>
                  <a:moveTo>
                    <a:pt x="407" y="0"/>
                  </a:moveTo>
                  <a:lnTo>
                    <a:pt x="408" y="0"/>
                  </a:lnTo>
                  <a:moveTo>
                    <a:pt x="411" y="0"/>
                  </a:moveTo>
                  <a:lnTo>
                    <a:pt x="412" y="0"/>
                  </a:lnTo>
                  <a:moveTo>
                    <a:pt x="415" y="0"/>
                  </a:moveTo>
                  <a:lnTo>
                    <a:pt x="416" y="0"/>
                  </a:lnTo>
                  <a:moveTo>
                    <a:pt x="419" y="0"/>
                  </a:moveTo>
                  <a:lnTo>
                    <a:pt x="420" y="0"/>
                  </a:lnTo>
                  <a:moveTo>
                    <a:pt x="423" y="0"/>
                  </a:moveTo>
                  <a:lnTo>
                    <a:pt x="424" y="0"/>
                  </a:lnTo>
                  <a:moveTo>
                    <a:pt x="427" y="0"/>
                  </a:moveTo>
                  <a:lnTo>
                    <a:pt x="428" y="0"/>
                  </a:lnTo>
                  <a:moveTo>
                    <a:pt x="431" y="0"/>
                  </a:moveTo>
                  <a:lnTo>
                    <a:pt x="432" y="0"/>
                  </a:lnTo>
                  <a:moveTo>
                    <a:pt x="435" y="0"/>
                  </a:moveTo>
                  <a:lnTo>
                    <a:pt x="436" y="0"/>
                  </a:lnTo>
                  <a:moveTo>
                    <a:pt x="439" y="0"/>
                  </a:moveTo>
                  <a:lnTo>
                    <a:pt x="440" y="0"/>
                  </a:lnTo>
                  <a:moveTo>
                    <a:pt x="443" y="0"/>
                  </a:moveTo>
                  <a:lnTo>
                    <a:pt x="444" y="0"/>
                  </a:lnTo>
                  <a:moveTo>
                    <a:pt x="447" y="0"/>
                  </a:moveTo>
                  <a:lnTo>
                    <a:pt x="448" y="0"/>
                  </a:lnTo>
                  <a:moveTo>
                    <a:pt x="451" y="0"/>
                  </a:moveTo>
                  <a:lnTo>
                    <a:pt x="452" y="0"/>
                  </a:lnTo>
                  <a:moveTo>
                    <a:pt x="455" y="0"/>
                  </a:moveTo>
                  <a:lnTo>
                    <a:pt x="456" y="0"/>
                  </a:lnTo>
                  <a:moveTo>
                    <a:pt x="459" y="0"/>
                  </a:moveTo>
                  <a:lnTo>
                    <a:pt x="460" y="0"/>
                  </a:lnTo>
                  <a:moveTo>
                    <a:pt x="463" y="0"/>
                  </a:moveTo>
                  <a:lnTo>
                    <a:pt x="464" y="0"/>
                  </a:lnTo>
                  <a:moveTo>
                    <a:pt x="467" y="0"/>
                  </a:moveTo>
                  <a:lnTo>
                    <a:pt x="468" y="0"/>
                  </a:lnTo>
                  <a:moveTo>
                    <a:pt x="471" y="0"/>
                  </a:moveTo>
                  <a:lnTo>
                    <a:pt x="472" y="0"/>
                  </a:lnTo>
                  <a:moveTo>
                    <a:pt x="475" y="0"/>
                  </a:moveTo>
                  <a:lnTo>
                    <a:pt x="476" y="0"/>
                  </a:lnTo>
                  <a:moveTo>
                    <a:pt x="479" y="0"/>
                  </a:moveTo>
                  <a:lnTo>
                    <a:pt x="480" y="0"/>
                  </a:lnTo>
                  <a:moveTo>
                    <a:pt x="483" y="0"/>
                  </a:moveTo>
                  <a:lnTo>
                    <a:pt x="484" y="0"/>
                  </a:lnTo>
                  <a:moveTo>
                    <a:pt x="487" y="0"/>
                  </a:moveTo>
                  <a:lnTo>
                    <a:pt x="488" y="0"/>
                  </a:lnTo>
                  <a:moveTo>
                    <a:pt x="491" y="0"/>
                  </a:moveTo>
                  <a:lnTo>
                    <a:pt x="492" y="0"/>
                  </a:lnTo>
                  <a:moveTo>
                    <a:pt x="495" y="0"/>
                  </a:moveTo>
                  <a:lnTo>
                    <a:pt x="496" y="0"/>
                  </a:lnTo>
                  <a:moveTo>
                    <a:pt x="499" y="0"/>
                  </a:moveTo>
                  <a:lnTo>
                    <a:pt x="500" y="0"/>
                  </a:lnTo>
                  <a:moveTo>
                    <a:pt x="503" y="0"/>
                  </a:moveTo>
                  <a:lnTo>
                    <a:pt x="504" y="0"/>
                  </a:lnTo>
                  <a:moveTo>
                    <a:pt x="507" y="0"/>
                  </a:moveTo>
                  <a:lnTo>
                    <a:pt x="508" y="0"/>
                  </a:lnTo>
                  <a:moveTo>
                    <a:pt x="511" y="0"/>
                  </a:moveTo>
                  <a:lnTo>
                    <a:pt x="512" y="0"/>
                  </a:lnTo>
                  <a:moveTo>
                    <a:pt x="515" y="0"/>
                  </a:moveTo>
                  <a:lnTo>
                    <a:pt x="516" y="0"/>
                  </a:lnTo>
                  <a:moveTo>
                    <a:pt x="519" y="0"/>
                  </a:moveTo>
                  <a:lnTo>
                    <a:pt x="520" y="0"/>
                  </a:lnTo>
                  <a:moveTo>
                    <a:pt x="523" y="0"/>
                  </a:moveTo>
                  <a:lnTo>
                    <a:pt x="524" y="0"/>
                  </a:lnTo>
                  <a:moveTo>
                    <a:pt x="527" y="0"/>
                  </a:moveTo>
                  <a:lnTo>
                    <a:pt x="528" y="0"/>
                  </a:lnTo>
                  <a:moveTo>
                    <a:pt x="531" y="0"/>
                  </a:moveTo>
                  <a:lnTo>
                    <a:pt x="532" y="0"/>
                  </a:lnTo>
                  <a:moveTo>
                    <a:pt x="535" y="0"/>
                  </a:moveTo>
                  <a:lnTo>
                    <a:pt x="536" y="0"/>
                  </a:lnTo>
                  <a:moveTo>
                    <a:pt x="539" y="0"/>
                  </a:moveTo>
                  <a:lnTo>
                    <a:pt x="540" y="0"/>
                  </a:lnTo>
                  <a:moveTo>
                    <a:pt x="543" y="0"/>
                  </a:moveTo>
                  <a:lnTo>
                    <a:pt x="544" y="0"/>
                  </a:lnTo>
                  <a:moveTo>
                    <a:pt x="547" y="0"/>
                  </a:moveTo>
                  <a:lnTo>
                    <a:pt x="548" y="0"/>
                  </a:lnTo>
                  <a:moveTo>
                    <a:pt x="551" y="0"/>
                  </a:moveTo>
                  <a:lnTo>
                    <a:pt x="552" y="0"/>
                  </a:lnTo>
                </a:path>
              </a:pathLst>
            </a:custGeom>
            <a:noFill/>
            <a:ln w="6350" cap="rnd">
              <a:solidFill>
                <a:srgbClr val="DDDD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Line 56">
              <a:extLst>
                <a:ext uri="{FF2B5EF4-FFF2-40B4-BE49-F238E27FC236}">
                  <a16:creationId xmlns:a16="http://schemas.microsoft.com/office/drawing/2014/main" id="{7DB27FC8-AD6A-4A1D-9BD0-EF1142A287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56435" y="1232775"/>
              <a:ext cx="3587750" cy="3587750"/>
            </a:xfrm>
            <a:prstGeom prst="line">
              <a:avLst/>
            </a:prstGeom>
            <a:noFill/>
            <a:ln w="6350" cap="rnd">
              <a:solidFill>
                <a:srgbClr val="A9A9A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Freeform 57">
              <a:extLst>
                <a:ext uri="{FF2B5EF4-FFF2-40B4-BE49-F238E27FC236}">
                  <a16:creationId xmlns:a16="http://schemas.microsoft.com/office/drawing/2014/main" id="{B5F80852-23B2-408B-8F14-F38402125327}"/>
                </a:ext>
              </a:extLst>
            </p:cNvPr>
            <p:cNvSpPr>
              <a:spLocks/>
            </p:cNvSpPr>
            <p:nvPr/>
          </p:nvSpPr>
          <p:spPr bwMode="auto">
            <a:xfrm>
              <a:off x="6892960" y="1362950"/>
              <a:ext cx="3321050" cy="3321050"/>
            </a:xfrm>
            <a:custGeom>
              <a:avLst/>
              <a:gdLst>
                <a:gd name="T0" fmla="*/ 513 w 513"/>
                <a:gd name="T1" fmla="*/ 0 h 513"/>
                <a:gd name="T2" fmla="*/ 500 w 513"/>
                <a:gd name="T3" fmla="*/ 0 h 513"/>
                <a:gd name="T4" fmla="*/ 487 w 513"/>
                <a:gd name="T5" fmla="*/ 0 h 513"/>
                <a:gd name="T6" fmla="*/ 461 w 513"/>
                <a:gd name="T7" fmla="*/ 0 h 513"/>
                <a:gd name="T8" fmla="*/ 461 w 513"/>
                <a:gd name="T9" fmla="*/ 21 h 513"/>
                <a:gd name="T10" fmla="*/ 449 w 513"/>
                <a:gd name="T11" fmla="*/ 21 h 513"/>
                <a:gd name="T12" fmla="*/ 436 w 513"/>
                <a:gd name="T13" fmla="*/ 41 h 513"/>
                <a:gd name="T14" fmla="*/ 423 w 513"/>
                <a:gd name="T15" fmla="*/ 41 h 513"/>
                <a:gd name="T16" fmla="*/ 397 w 513"/>
                <a:gd name="T17" fmla="*/ 41 h 513"/>
                <a:gd name="T18" fmla="*/ 397 w 513"/>
                <a:gd name="T19" fmla="*/ 62 h 513"/>
                <a:gd name="T20" fmla="*/ 384 w 513"/>
                <a:gd name="T21" fmla="*/ 62 h 513"/>
                <a:gd name="T22" fmla="*/ 372 w 513"/>
                <a:gd name="T23" fmla="*/ 62 h 513"/>
                <a:gd name="T24" fmla="*/ 372 w 513"/>
                <a:gd name="T25" fmla="*/ 82 h 513"/>
                <a:gd name="T26" fmla="*/ 359 w 513"/>
                <a:gd name="T27" fmla="*/ 82 h 513"/>
                <a:gd name="T28" fmla="*/ 346 w 513"/>
                <a:gd name="T29" fmla="*/ 82 h 513"/>
                <a:gd name="T30" fmla="*/ 333 w 513"/>
                <a:gd name="T31" fmla="*/ 82 h 513"/>
                <a:gd name="T32" fmla="*/ 320 w 513"/>
                <a:gd name="T33" fmla="*/ 82 h 513"/>
                <a:gd name="T34" fmla="*/ 307 w 513"/>
                <a:gd name="T35" fmla="*/ 82 h 513"/>
                <a:gd name="T36" fmla="*/ 282 w 513"/>
                <a:gd name="T37" fmla="*/ 82 h 513"/>
                <a:gd name="T38" fmla="*/ 269 w 513"/>
                <a:gd name="T39" fmla="*/ 82 h 513"/>
                <a:gd name="T40" fmla="*/ 256 w 513"/>
                <a:gd name="T41" fmla="*/ 82 h 513"/>
                <a:gd name="T42" fmla="*/ 243 w 513"/>
                <a:gd name="T43" fmla="*/ 123 h 513"/>
                <a:gd name="T44" fmla="*/ 243 w 513"/>
                <a:gd name="T45" fmla="*/ 144 h 513"/>
                <a:gd name="T46" fmla="*/ 231 w 513"/>
                <a:gd name="T47" fmla="*/ 144 h 513"/>
                <a:gd name="T48" fmla="*/ 218 w 513"/>
                <a:gd name="T49" fmla="*/ 144 h 513"/>
                <a:gd name="T50" fmla="*/ 218 w 513"/>
                <a:gd name="T51" fmla="*/ 185 h 513"/>
                <a:gd name="T52" fmla="*/ 205 w 513"/>
                <a:gd name="T53" fmla="*/ 185 h 513"/>
                <a:gd name="T54" fmla="*/ 179 w 513"/>
                <a:gd name="T55" fmla="*/ 185 h 513"/>
                <a:gd name="T56" fmla="*/ 166 w 513"/>
                <a:gd name="T57" fmla="*/ 185 h 513"/>
                <a:gd name="T58" fmla="*/ 166 w 513"/>
                <a:gd name="T59" fmla="*/ 206 h 513"/>
                <a:gd name="T60" fmla="*/ 154 w 513"/>
                <a:gd name="T61" fmla="*/ 226 h 513"/>
                <a:gd name="T62" fmla="*/ 154 w 513"/>
                <a:gd name="T63" fmla="*/ 247 h 513"/>
                <a:gd name="T64" fmla="*/ 141 w 513"/>
                <a:gd name="T65" fmla="*/ 267 h 513"/>
                <a:gd name="T66" fmla="*/ 128 w 513"/>
                <a:gd name="T67" fmla="*/ 267 h 513"/>
                <a:gd name="T68" fmla="*/ 102 w 513"/>
                <a:gd name="T69" fmla="*/ 267 h 513"/>
                <a:gd name="T70" fmla="*/ 89 w 513"/>
                <a:gd name="T71" fmla="*/ 267 h 513"/>
                <a:gd name="T72" fmla="*/ 77 w 513"/>
                <a:gd name="T73" fmla="*/ 267 h 513"/>
                <a:gd name="T74" fmla="*/ 64 w 513"/>
                <a:gd name="T75" fmla="*/ 267 h 513"/>
                <a:gd name="T76" fmla="*/ 64 w 513"/>
                <a:gd name="T77" fmla="*/ 288 h 513"/>
                <a:gd name="T78" fmla="*/ 51 w 513"/>
                <a:gd name="T79" fmla="*/ 308 h 513"/>
                <a:gd name="T80" fmla="*/ 51 w 513"/>
                <a:gd name="T81" fmla="*/ 329 h 513"/>
                <a:gd name="T82" fmla="*/ 38 w 513"/>
                <a:gd name="T83" fmla="*/ 329 h 513"/>
                <a:gd name="T84" fmla="*/ 25 w 513"/>
                <a:gd name="T85" fmla="*/ 329 h 513"/>
                <a:gd name="T86" fmla="*/ 25 w 513"/>
                <a:gd name="T87" fmla="*/ 349 h 513"/>
                <a:gd name="T88" fmla="*/ 25 w 513"/>
                <a:gd name="T89" fmla="*/ 370 h 513"/>
                <a:gd name="T90" fmla="*/ 25 w 513"/>
                <a:gd name="T91" fmla="*/ 390 h 513"/>
                <a:gd name="T92" fmla="*/ 25 w 513"/>
                <a:gd name="T93" fmla="*/ 411 h 513"/>
                <a:gd name="T94" fmla="*/ 25 w 513"/>
                <a:gd name="T95" fmla="*/ 452 h 513"/>
                <a:gd name="T96" fmla="*/ 13 w 513"/>
                <a:gd name="T97" fmla="*/ 452 h 513"/>
                <a:gd name="T98" fmla="*/ 13 w 513"/>
                <a:gd name="T99" fmla="*/ 472 h 513"/>
                <a:gd name="T100" fmla="*/ 13 w 513"/>
                <a:gd name="T101" fmla="*/ 493 h 513"/>
                <a:gd name="T102" fmla="*/ 0 w 513"/>
                <a:gd name="T103" fmla="*/ 493 h 513"/>
                <a:gd name="T104" fmla="*/ 0 w 513"/>
                <a:gd name="T105" fmla="*/ 513 h 5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</a:cxnLst>
              <a:rect l="0" t="0" r="r" b="b"/>
              <a:pathLst>
                <a:path w="513" h="513">
                  <a:moveTo>
                    <a:pt x="513" y="0"/>
                  </a:moveTo>
                  <a:lnTo>
                    <a:pt x="500" y="0"/>
                  </a:lnTo>
                  <a:lnTo>
                    <a:pt x="487" y="0"/>
                  </a:lnTo>
                  <a:lnTo>
                    <a:pt x="461" y="0"/>
                  </a:lnTo>
                  <a:lnTo>
                    <a:pt x="461" y="21"/>
                  </a:lnTo>
                  <a:lnTo>
                    <a:pt x="449" y="21"/>
                  </a:lnTo>
                  <a:lnTo>
                    <a:pt x="436" y="41"/>
                  </a:lnTo>
                  <a:lnTo>
                    <a:pt x="423" y="41"/>
                  </a:lnTo>
                  <a:lnTo>
                    <a:pt x="397" y="41"/>
                  </a:lnTo>
                  <a:lnTo>
                    <a:pt x="397" y="62"/>
                  </a:lnTo>
                  <a:lnTo>
                    <a:pt x="384" y="62"/>
                  </a:lnTo>
                  <a:lnTo>
                    <a:pt x="372" y="62"/>
                  </a:lnTo>
                  <a:lnTo>
                    <a:pt x="372" y="82"/>
                  </a:lnTo>
                  <a:lnTo>
                    <a:pt x="359" y="82"/>
                  </a:lnTo>
                  <a:lnTo>
                    <a:pt x="346" y="82"/>
                  </a:lnTo>
                  <a:lnTo>
                    <a:pt x="333" y="82"/>
                  </a:lnTo>
                  <a:lnTo>
                    <a:pt x="320" y="82"/>
                  </a:lnTo>
                  <a:lnTo>
                    <a:pt x="307" y="82"/>
                  </a:lnTo>
                  <a:lnTo>
                    <a:pt x="282" y="82"/>
                  </a:lnTo>
                  <a:lnTo>
                    <a:pt x="269" y="82"/>
                  </a:lnTo>
                  <a:lnTo>
                    <a:pt x="256" y="82"/>
                  </a:lnTo>
                  <a:lnTo>
                    <a:pt x="243" y="123"/>
                  </a:lnTo>
                  <a:lnTo>
                    <a:pt x="243" y="144"/>
                  </a:lnTo>
                  <a:lnTo>
                    <a:pt x="231" y="144"/>
                  </a:lnTo>
                  <a:lnTo>
                    <a:pt x="218" y="144"/>
                  </a:lnTo>
                  <a:lnTo>
                    <a:pt x="218" y="185"/>
                  </a:lnTo>
                  <a:lnTo>
                    <a:pt x="205" y="185"/>
                  </a:lnTo>
                  <a:lnTo>
                    <a:pt x="179" y="185"/>
                  </a:lnTo>
                  <a:lnTo>
                    <a:pt x="166" y="185"/>
                  </a:lnTo>
                  <a:lnTo>
                    <a:pt x="166" y="206"/>
                  </a:lnTo>
                  <a:lnTo>
                    <a:pt x="154" y="226"/>
                  </a:lnTo>
                  <a:lnTo>
                    <a:pt x="154" y="247"/>
                  </a:lnTo>
                  <a:lnTo>
                    <a:pt x="141" y="267"/>
                  </a:lnTo>
                  <a:lnTo>
                    <a:pt x="128" y="267"/>
                  </a:lnTo>
                  <a:lnTo>
                    <a:pt x="102" y="267"/>
                  </a:lnTo>
                  <a:lnTo>
                    <a:pt x="89" y="267"/>
                  </a:lnTo>
                  <a:lnTo>
                    <a:pt x="77" y="267"/>
                  </a:lnTo>
                  <a:lnTo>
                    <a:pt x="64" y="267"/>
                  </a:lnTo>
                  <a:lnTo>
                    <a:pt x="64" y="288"/>
                  </a:lnTo>
                  <a:lnTo>
                    <a:pt x="51" y="308"/>
                  </a:lnTo>
                  <a:lnTo>
                    <a:pt x="51" y="329"/>
                  </a:lnTo>
                  <a:lnTo>
                    <a:pt x="38" y="329"/>
                  </a:lnTo>
                  <a:lnTo>
                    <a:pt x="25" y="329"/>
                  </a:lnTo>
                  <a:lnTo>
                    <a:pt x="25" y="349"/>
                  </a:lnTo>
                  <a:lnTo>
                    <a:pt x="25" y="370"/>
                  </a:lnTo>
                  <a:lnTo>
                    <a:pt x="25" y="390"/>
                  </a:lnTo>
                  <a:lnTo>
                    <a:pt x="25" y="411"/>
                  </a:lnTo>
                  <a:lnTo>
                    <a:pt x="25" y="452"/>
                  </a:lnTo>
                  <a:lnTo>
                    <a:pt x="13" y="452"/>
                  </a:lnTo>
                  <a:lnTo>
                    <a:pt x="13" y="472"/>
                  </a:lnTo>
                  <a:lnTo>
                    <a:pt x="13" y="493"/>
                  </a:lnTo>
                  <a:lnTo>
                    <a:pt x="0" y="493"/>
                  </a:lnTo>
                  <a:lnTo>
                    <a:pt x="0" y="513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Rectangle 58">
              <a:extLst>
                <a:ext uri="{FF2B5EF4-FFF2-40B4-BE49-F238E27FC236}">
                  <a16:creationId xmlns:a16="http://schemas.microsoft.com/office/drawing/2014/main" id="{4802D169-2E9C-488F-9D27-3B62F17F77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00948" y="3079037"/>
              <a:ext cx="19050" cy="63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Rectangle 59">
              <a:extLst>
                <a:ext uri="{FF2B5EF4-FFF2-40B4-BE49-F238E27FC236}">
                  <a16:creationId xmlns:a16="http://schemas.microsoft.com/office/drawing/2014/main" id="{64BC5D59-0680-4840-9083-0BDBD716EE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00948" y="3104437"/>
              <a:ext cx="19050" cy="63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Rectangle 60">
              <a:extLst>
                <a:ext uri="{FF2B5EF4-FFF2-40B4-BE49-F238E27FC236}">
                  <a16:creationId xmlns:a16="http://schemas.microsoft.com/office/drawing/2014/main" id="{71D644F2-23AF-408A-A9A9-93AC6670CC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94598" y="3085387"/>
              <a:ext cx="31750" cy="63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Rectangle 61">
              <a:extLst>
                <a:ext uri="{FF2B5EF4-FFF2-40B4-BE49-F238E27FC236}">
                  <a16:creationId xmlns:a16="http://schemas.microsoft.com/office/drawing/2014/main" id="{7144D710-4B08-4768-955F-15EBA39F46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94598" y="3098087"/>
              <a:ext cx="31750" cy="63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Rectangle 62">
              <a:extLst>
                <a:ext uri="{FF2B5EF4-FFF2-40B4-BE49-F238E27FC236}">
                  <a16:creationId xmlns:a16="http://schemas.microsoft.com/office/drawing/2014/main" id="{C89E99BB-1962-43D9-8B4E-76CC5F065F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94598" y="3091737"/>
              <a:ext cx="31750" cy="63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Rectangle 63">
              <a:extLst>
                <a:ext uri="{FF2B5EF4-FFF2-40B4-BE49-F238E27FC236}">
                  <a16:creationId xmlns:a16="http://schemas.microsoft.com/office/drawing/2014/main" id="{55677B12-E082-4E11-8F0F-CBAE698A2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94598" y="3091737"/>
              <a:ext cx="31750" cy="63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Oval 64">
              <a:extLst>
                <a:ext uri="{FF2B5EF4-FFF2-40B4-BE49-F238E27FC236}">
                  <a16:creationId xmlns:a16="http://schemas.microsoft.com/office/drawing/2014/main" id="{789A7B3F-9A90-42C9-8DF3-4FE0A9AF56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94598" y="3079037"/>
              <a:ext cx="25400" cy="25400"/>
            </a:xfrm>
            <a:prstGeom prst="ellips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0" name="Rectangle 65">
              <a:extLst>
                <a:ext uri="{FF2B5EF4-FFF2-40B4-BE49-F238E27FC236}">
                  <a16:creationId xmlns:a16="http://schemas.microsoft.com/office/drawing/2014/main" id="{5B4D9FF7-FB53-40DD-91BD-1B6EAAA8B4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51748" y="3110786"/>
              <a:ext cx="1635732" cy="2460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.500 (0.875, 0.480)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91" name="グループ化 190">
            <a:extLst>
              <a:ext uri="{FF2B5EF4-FFF2-40B4-BE49-F238E27FC236}">
                <a16:creationId xmlns:a16="http://schemas.microsoft.com/office/drawing/2014/main" id="{2C63D7CB-30AC-4230-929B-69DD179DC965}"/>
              </a:ext>
            </a:extLst>
          </p:cNvPr>
          <p:cNvGrpSpPr/>
          <p:nvPr/>
        </p:nvGrpSpPr>
        <p:grpSpPr>
          <a:xfrm>
            <a:off x="4455146" y="3636335"/>
            <a:ext cx="3845771" cy="3165972"/>
            <a:chOff x="1001971" y="1322388"/>
            <a:chExt cx="4719018" cy="3764746"/>
          </a:xfrm>
        </p:grpSpPr>
        <p:sp>
          <p:nvSpPr>
            <p:cNvPr id="192" name="Freeform 5">
              <a:extLst>
                <a:ext uri="{FF2B5EF4-FFF2-40B4-BE49-F238E27FC236}">
                  <a16:creationId xmlns:a16="http://schemas.microsoft.com/office/drawing/2014/main" id="{22577FBA-7CBB-4FAF-8CDB-4E0BB9287E09}"/>
                </a:ext>
              </a:extLst>
            </p:cNvPr>
            <p:cNvSpPr>
              <a:spLocks/>
            </p:cNvSpPr>
            <p:nvPr/>
          </p:nvSpPr>
          <p:spPr bwMode="auto">
            <a:xfrm>
              <a:off x="1749425" y="1446213"/>
              <a:ext cx="3322638" cy="2854325"/>
            </a:xfrm>
            <a:custGeom>
              <a:avLst/>
              <a:gdLst>
                <a:gd name="T0" fmla="*/ 0 w 513"/>
                <a:gd name="T1" fmla="*/ 0 h 441"/>
                <a:gd name="T2" fmla="*/ 1 w 513"/>
                <a:gd name="T3" fmla="*/ 0 h 441"/>
                <a:gd name="T4" fmla="*/ 11 w 513"/>
                <a:gd name="T5" fmla="*/ 0 h 441"/>
                <a:gd name="T6" fmla="*/ 12 w 513"/>
                <a:gd name="T7" fmla="*/ 0 h 441"/>
                <a:gd name="T8" fmla="*/ 14 w 513"/>
                <a:gd name="T9" fmla="*/ 18 h 441"/>
                <a:gd name="T10" fmla="*/ 17 w 513"/>
                <a:gd name="T11" fmla="*/ 18 h 441"/>
                <a:gd name="T12" fmla="*/ 22 w 513"/>
                <a:gd name="T13" fmla="*/ 36 h 441"/>
                <a:gd name="T14" fmla="*/ 25 w 513"/>
                <a:gd name="T15" fmla="*/ 36 h 441"/>
                <a:gd name="T16" fmla="*/ 28 w 513"/>
                <a:gd name="T17" fmla="*/ 36 h 441"/>
                <a:gd name="T18" fmla="*/ 29 w 513"/>
                <a:gd name="T19" fmla="*/ 55 h 441"/>
                <a:gd name="T20" fmla="*/ 30 w 513"/>
                <a:gd name="T21" fmla="*/ 55 h 441"/>
                <a:gd name="T22" fmla="*/ 34 w 513"/>
                <a:gd name="T23" fmla="*/ 55 h 441"/>
                <a:gd name="T24" fmla="*/ 35 w 513"/>
                <a:gd name="T25" fmla="*/ 73 h 441"/>
                <a:gd name="T26" fmla="*/ 36 w 513"/>
                <a:gd name="T27" fmla="*/ 73 h 441"/>
                <a:gd name="T28" fmla="*/ 38 w 513"/>
                <a:gd name="T29" fmla="*/ 73 h 441"/>
                <a:gd name="T30" fmla="*/ 39 w 513"/>
                <a:gd name="T31" fmla="*/ 73 h 441"/>
                <a:gd name="T32" fmla="*/ 40 w 513"/>
                <a:gd name="T33" fmla="*/ 73 h 441"/>
                <a:gd name="T34" fmla="*/ 48 w 513"/>
                <a:gd name="T35" fmla="*/ 73 h 441"/>
                <a:gd name="T36" fmla="*/ 49 w 513"/>
                <a:gd name="T37" fmla="*/ 73 h 441"/>
                <a:gd name="T38" fmla="*/ 53 w 513"/>
                <a:gd name="T39" fmla="*/ 73 h 441"/>
                <a:gd name="T40" fmla="*/ 54 w 513"/>
                <a:gd name="T41" fmla="*/ 73 h 441"/>
                <a:gd name="T42" fmla="*/ 58 w 513"/>
                <a:gd name="T43" fmla="*/ 110 h 441"/>
                <a:gd name="T44" fmla="*/ 62 w 513"/>
                <a:gd name="T45" fmla="*/ 128 h 441"/>
                <a:gd name="T46" fmla="*/ 64 w 513"/>
                <a:gd name="T47" fmla="*/ 128 h 441"/>
                <a:gd name="T48" fmla="*/ 67 w 513"/>
                <a:gd name="T49" fmla="*/ 128 h 441"/>
                <a:gd name="T50" fmla="*/ 68 w 513"/>
                <a:gd name="T51" fmla="*/ 165 h 441"/>
                <a:gd name="T52" fmla="*/ 69 w 513"/>
                <a:gd name="T53" fmla="*/ 165 h 441"/>
                <a:gd name="T54" fmla="*/ 70 w 513"/>
                <a:gd name="T55" fmla="*/ 165 h 441"/>
                <a:gd name="T56" fmla="*/ 73 w 513"/>
                <a:gd name="T57" fmla="*/ 165 h 441"/>
                <a:gd name="T58" fmla="*/ 76 w 513"/>
                <a:gd name="T59" fmla="*/ 183 h 441"/>
                <a:gd name="T60" fmla="*/ 82 w 513"/>
                <a:gd name="T61" fmla="*/ 202 h 441"/>
                <a:gd name="T62" fmla="*/ 91 w 513"/>
                <a:gd name="T63" fmla="*/ 220 h 441"/>
                <a:gd name="T64" fmla="*/ 94 w 513"/>
                <a:gd name="T65" fmla="*/ 239 h 441"/>
                <a:gd name="T66" fmla="*/ 98 w 513"/>
                <a:gd name="T67" fmla="*/ 239 h 441"/>
                <a:gd name="T68" fmla="*/ 106 w 513"/>
                <a:gd name="T69" fmla="*/ 239 h 441"/>
                <a:gd name="T70" fmla="*/ 110 w 513"/>
                <a:gd name="T71" fmla="*/ 239 h 441"/>
                <a:gd name="T72" fmla="*/ 125 w 513"/>
                <a:gd name="T73" fmla="*/ 239 h 441"/>
                <a:gd name="T74" fmla="*/ 130 w 513"/>
                <a:gd name="T75" fmla="*/ 239 h 441"/>
                <a:gd name="T76" fmla="*/ 141 w 513"/>
                <a:gd name="T77" fmla="*/ 257 h 441"/>
                <a:gd name="T78" fmla="*/ 144 w 513"/>
                <a:gd name="T79" fmla="*/ 275 h 441"/>
                <a:gd name="T80" fmla="*/ 149 w 513"/>
                <a:gd name="T81" fmla="*/ 294 h 441"/>
                <a:gd name="T82" fmla="*/ 155 w 513"/>
                <a:gd name="T83" fmla="*/ 294 h 441"/>
                <a:gd name="T84" fmla="*/ 179 w 513"/>
                <a:gd name="T85" fmla="*/ 294 h 441"/>
                <a:gd name="T86" fmla="*/ 198 w 513"/>
                <a:gd name="T87" fmla="*/ 312 h 441"/>
                <a:gd name="T88" fmla="*/ 222 w 513"/>
                <a:gd name="T89" fmla="*/ 331 h 441"/>
                <a:gd name="T90" fmla="*/ 231 w 513"/>
                <a:gd name="T91" fmla="*/ 349 h 441"/>
                <a:gd name="T92" fmla="*/ 247 w 513"/>
                <a:gd name="T93" fmla="*/ 367 h 441"/>
                <a:gd name="T94" fmla="*/ 275 w 513"/>
                <a:gd name="T95" fmla="*/ 404 h 441"/>
                <a:gd name="T96" fmla="*/ 288 w 513"/>
                <a:gd name="T97" fmla="*/ 404 h 441"/>
                <a:gd name="T98" fmla="*/ 317 w 513"/>
                <a:gd name="T99" fmla="*/ 422 h 441"/>
                <a:gd name="T100" fmla="*/ 427 w 513"/>
                <a:gd name="T101" fmla="*/ 441 h 441"/>
                <a:gd name="T102" fmla="*/ 513 w 513"/>
                <a:gd name="T103" fmla="*/ 441 h 4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513" h="441">
                  <a:moveTo>
                    <a:pt x="0" y="0"/>
                  </a:moveTo>
                  <a:lnTo>
                    <a:pt x="1" y="0"/>
                  </a:lnTo>
                  <a:lnTo>
                    <a:pt x="11" y="0"/>
                  </a:lnTo>
                  <a:lnTo>
                    <a:pt x="12" y="0"/>
                  </a:lnTo>
                  <a:lnTo>
                    <a:pt x="14" y="18"/>
                  </a:lnTo>
                  <a:lnTo>
                    <a:pt x="17" y="18"/>
                  </a:lnTo>
                  <a:lnTo>
                    <a:pt x="22" y="36"/>
                  </a:lnTo>
                  <a:lnTo>
                    <a:pt x="25" y="36"/>
                  </a:lnTo>
                  <a:lnTo>
                    <a:pt x="28" y="36"/>
                  </a:lnTo>
                  <a:lnTo>
                    <a:pt x="29" y="55"/>
                  </a:lnTo>
                  <a:lnTo>
                    <a:pt x="30" y="55"/>
                  </a:lnTo>
                  <a:lnTo>
                    <a:pt x="34" y="55"/>
                  </a:lnTo>
                  <a:lnTo>
                    <a:pt x="35" y="73"/>
                  </a:lnTo>
                  <a:lnTo>
                    <a:pt x="36" y="73"/>
                  </a:lnTo>
                  <a:lnTo>
                    <a:pt x="38" y="73"/>
                  </a:lnTo>
                  <a:lnTo>
                    <a:pt x="39" y="73"/>
                  </a:lnTo>
                  <a:lnTo>
                    <a:pt x="40" y="73"/>
                  </a:lnTo>
                  <a:lnTo>
                    <a:pt x="48" y="73"/>
                  </a:lnTo>
                  <a:lnTo>
                    <a:pt x="49" y="73"/>
                  </a:lnTo>
                  <a:lnTo>
                    <a:pt x="53" y="73"/>
                  </a:lnTo>
                  <a:lnTo>
                    <a:pt x="54" y="73"/>
                  </a:lnTo>
                  <a:lnTo>
                    <a:pt x="58" y="110"/>
                  </a:lnTo>
                  <a:lnTo>
                    <a:pt x="62" y="128"/>
                  </a:lnTo>
                  <a:lnTo>
                    <a:pt x="64" y="128"/>
                  </a:lnTo>
                  <a:lnTo>
                    <a:pt x="67" y="128"/>
                  </a:lnTo>
                  <a:lnTo>
                    <a:pt x="68" y="165"/>
                  </a:lnTo>
                  <a:lnTo>
                    <a:pt x="69" y="165"/>
                  </a:lnTo>
                  <a:lnTo>
                    <a:pt x="70" y="165"/>
                  </a:lnTo>
                  <a:lnTo>
                    <a:pt x="73" y="165"/>
                  </a:lnTo>
                  <a:lnTo>
                    <a:pt x="76" y="183"/>
                  </a:lnTo>
                  <a:lnTo>
                    <a:pt x="82" y="202"/>
                  </a:lnTo>
                  <a:lnTo>
                    <a:pt x="91" y="220"/>
                  </a:lnTo>
                  <a:lnTo>
                    <a:pt x="94" y="239"/>
                  </a:lnTo>
                  <a:lnTo>
                    <a:pt x="98" y="239"/>
                  </a:lnTo>
                  <a:lnTo>
                    <a:pt x="106" y="239"/>
                  </a:lnTo>
                  <a:lnTo>
                    <a:pt x="110" y="239"/>
                  </a:lnTo>
                  <a:lnTo>
                    <a:pt x="125" y="239"/>
                  </a:lnTo>
                  <a:lnTo>
                    <a:pt x="130" y="239"/>
                  </a:lnTo>
                  <a:lnTo>
                    <a:pt x="141" y="257"/>
                  </a:lnTo>
                  <a:lnTo>
                    <a:pt x="144" y="275"/>
                  </a:lnTo>
                  <a:lnTo>
                    <a:pt x="149" y="294"/>
                  </a:lnTo>
                  <a:lnTo>
                    <a:pt x="155" y="294"/>
                  </a:lnTo>
                  <a:lnTo>
                    <a:pt x="179" y="294"/>
                  </a:lnTo>
                  <a:lnTo>
                    <a:pt x="198" y="312"/>
                  </a:lnTo>
                  <a:lnTo>
                    <a:pt x="222" y="331"/>
                  </a:lnTo>
                  <a:lnTo>
                    <a:pt x="231" y="349"/>
                  </a:lnTo>
                  <a:lnTo>
                    <a:pt x="247" y="367"/>
                  </a:lnTo>
                  <a:lnTo>
                    <a:pt x="275" y="404"/>
                  </a:lnTo>
                  <a:lnTo>
                    <a:pt x="288" y="404"/>
                  </a:lnTo>
                  <a:lnTo>
                    <a:pt x="317" y="422"/>
                  </a:lnTo>
                  <a:lnTo>
                    <a:pt x="427" y="441"/>
                  </a:lnTo>
                  <a:lnTo>
                    <a:pt x="513" y="441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3" name="Line 6">
              <a:extLst>
                <a:ext uri="{FF2B5EF4-FFF2-40B4-BE49-F238E27FC236}">
                  <a16:creationId xmlns:a16="http://schemas.microsoft.com/office/drawing/2014/main" id="{535E466D-0252-4D0C-9B34-FDD4E511E6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30375" y="4540251"/>
              <a:ext cx="327660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4" name="Line 7">
              <a:extLst>
                <a:ext uri="{FF2B5EF4-FFF2-40B4-BE49-F238E27FC236}">
                  <a16:creationId xmlns:a16="http://schemas.microsoft.com/office/drawing/2014/main" id="{B33A5323-6ACC-4D8F-842E-0FB0224668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30375" y="4540251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5" name="Line 8">
              <a:extLst>
                <a:ext uri="{FF2B5EF4-FFF2-40B4-BE49-F238E27FC236}">
                  <a16:creationId xmlns:a16="http://schemas.microsoft.com/office/drawing/2014/main" id="{0358B143-877F-4492-BE89-65F2FD455C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52700" y="4540251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6" name="Line 9">
              <a:extLst>
                <a:ext uri="{FF2B5EF4-FFF2-40B4-BE49-F238E27FC236}">
                  <a16:creationId xmlns:a16="http://schemas.microsoft.com/office/drawing/2014/main" id="{720D3FEB-9824-4D73-8BB4-57992F274DB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68675" y="4540251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7" name="Line 10">
              <a:extLst>
                <a:ext uri="{FF2B5EF4-FFF2-40B4-BE49-F238E27FC236}">
                  <a16:creationId xmlns:a16="http://schemas.microsoft.com/office/drawing/2014/main" id="{0D4AA73C-33B0-45D4-8261-51CB3995154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84650" y="4540251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8" name="Line 11">
              <a:extLst>
                <a:ext uri="{FF2B5EF4-FFF2-40B4-BE49-F238E27FC236}">
                  <a16:creationId xmlns:a16="http://schemas.microsoft.com/office/drawing/2014/main" id="{64961415-9A38-49F2-BB10-27F6E521A2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06975" y="4540251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9" name="Rectangle 12">
              <a:extLst>
                <a:ext uri="{FF2B5EF4-FFF2-40B4-BE49-F238E27FC236}">
                  <a16:creationId xmlns:a16="http://schemas.microsoft.com/office/drawing/2014/main" id="{87776E55-9F40-4E23-BC77-23AC041455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3225" y="4676776"/>
              <a:ext cx="94415" cy="2195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0" name="Rectangle 13">
              <a:extLst>
                <a:ext uri="{FF2B5EF4-FFF2-40B4-BE49-F238E27FC236}">
                  <a16:creationId xmlns:a16="http://schemas.microsoft.com/office/drawing/2014/main" id="{DC037943-8B28-454B-B668-6046CCE200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2213" y="4676776"/>
              <a:ext cx="188831" cy="2195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" name="Rectangle 14">
              <a:extLst>
                <a:ext uri="{FF2B5EF4-FFF2-40B4-BE49-F238E27FC236}">
                  <a16:creationId xmlns:a16="http://schemas.microsoft.com/office/drawing/2014/main" id="{15CDCF86-0D1A-4375-8E82-02A3B0DA8F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78189" y="4676776"/>
              <a:ext cx="188831" cy="2195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" name="Rectangle 15">
              <a:extLst>
                <a:ext uri="{FF2B5EF4-FFF2-40B4-BE49-F238E27FC236}">
                  <a16:creationId xmlns:a16="http://schemas.microsoft.com/office/drawing/2014/main" id="{C91FA1AC-30F8-48F2-B3DB-9019700E7A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94163" y="4676776"/>
              <a:ext cx="188831" cy="2195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" name="Rectangle 16">
              <a:extLst>
                <a:ext uri="{FF2B5EF4-FFF2-40B4-BE49-F238E27FC236}">
                  <a16:creationId xmlns:a16="http://schemas.microsoft.com/office/drawing/2014/main" id="{E5DAF285-FB4E-423C-B20C-CF0849209D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6488" y="4676776"/>
              <a:ext cx="188831" cy="2195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" name="Line 17">
              <a:extLst>
                <a:ext uri="{FF2B5EF4-FFF2-40B4-BE49-F238E27FC236}">
                  <a16:creationId xmlns:a16="http://schemas.microsoft.com/office/drawing/2014/main" id="{C7729B0D-1105-42C9-8AD3-A1881AE4247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12900" y="1446213"/>
              <a:ext cx="0" cy="297180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" name="Line 18">
              <a:extLst>
                <a:ext uri="{FF2B5EF4-FFF2-40B4-BE49-F238E27FC236}">
                  <a16:creationId xmlns:a16="http://schemas.microsoft.com/office/drawing/2014/main" id="{501ADADF-69B0-4F82-86D1-CEF8BCB332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55750" y="4418013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" name="Line 19">
              <a:extLst>
                <a:ext uri="{FF2B5EF4-FFF2-40B4-BE49-F238E27FC236}">
                  <a16:creationId xmlns:a16="http://schemas.microsoft.com/office/drawing/2014/main" id="{2DC11C28-E7A9-4759-AFB3-D4EC404A46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55750" y="3822701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" name="Line 20">
              <a:extLst>
                <a:ext uri="{FF2B5EF4-FFF2-40B4-BE49-F238E27FC236}">
                  <a16:creationId xmlns:a16="http://schemas.microsoft.com/office/drawing/2014/main" id="{A9B72125-0CC4-42D7-9757-838ED1E37D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55750" y="3225801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8" name="Line 21">
              <a:extLst>
                <a:ext uri="{FF2B5EF4-FFF2-40B4-BE49-F238E27FC236}">
                  <a16:creationId xmlns:a16="http://schemas.microsoft.com/office/drawing/2014/main" id="{FCF44E47-2CA7-4E70-B288-07E1116803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55750" y="2630488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9" name="Line 22">
              <a:extLst>
                <a:ext uri="{FF2B5EF4-FFF2-40B4-BE49-F238E27FC236}">
                  <a16:creationId xmlns:a16="http://schemas.microsoft.com/office/drawing/2014/main" id="{2796392E-F14E-431D-B1BA-EB207F9511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55750" y="2041526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0" name="Line 23">
              <a:extLst>
                <a:ext uri="{FF2B5EF4-FFF2-40B4-BE49-F238E27FC236}">
                  <a16:creationId xmlns:a16="http://schemas.microsoft.com/office/drawing/2014/main" id="{56299C18-BA77-4F20-91AF-608278904A3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55750" y="1446213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1" name="Rectangle 24">
              <a:extLst>
                <a:ext uri="{FF2B5EF4-FFF2-40B4-BE49-F238E27FC236}">
                  <a16:creationId xmlns:a16="http://schemas.microsoft.com/office/drawing/2014/main" id="{98C17597-1B03-446F-A302-58E9F58BC9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6350" y="4378325"/>
              <a:ext cx="236039" cy="2195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" name="Rectangle 25">
              <a:extLst>
                <a:ext uri="{FF2B5EF4-FFF2-40B4-BE49-F238E27FC236}">
                  <a16:creationId xmlns:a16="http://schemas.microsoft.com/office/drawing/2014/main" id="{392C5665-9863-4E9A-9860-FC0B0B95E6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6350" y="3783014"/>
              <a:ext cx="236039" cy="2195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" name="Rectangle 26">
              <a:extLst>
                <a:ext uri="{FF2B5EF4-FFF2-40B4-BE49-F238E27FC236}">
                  <a16:creationId xmlns:a16="http://schemas.microsoft.com/office/drawing/2014/main" id="{2E3D647A-01DF-4BCC-A3BE-33FBD3F4E3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6350" y="3187700"/>
              <a:ext cx="236039" cy="2195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4" name="Rectangle 27">
              <a:extLst>
                <a:ext uri="{FF2B5EF4-FFF2-40B4-BE49-F238E27FC236}">
                  <a16:creationId xmlns:a16="http://schemas.microsoft.com/office/drawing/2014/main" id="{A046ECC7-CBFA-4FF6-87D3-F4DF203072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6350" y="2592389"/>
              <a:ext cx="236039" cy="2195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5" name="Rectangle 28">
              <a:extLst>
                <a:ext uri="{FF2B5EF4-FFF2-40B4-BE49-F238E27FC236}">
                  <a16:creationId xmlns:a16="http://schemas.microsoft.com/office/drawing/2014/main" id="{F327F949-81AE-4C56-BC48-C40EA5D78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6350" y="1995488"/>
              <a:ext cx="236039" cy="2195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6" name="Rectangle 29">
              <a:extLst>
                <a:ext uri="{FF2B5EF4-FFF2-40B4-BE49-F238E27FC236}">
                  <a16:creationId xmlns:a16="http://schemas.microsoft.com/office/drawing/2014/main" id="{CC0CF480-8C01-4D65-BDBD-9965B204D8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6350" y="1400176"/>
              <a:ext cx="236039" cy="2195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7" name="Rectangle 30">
              <a:extLst>
                <a:ext uri="{FF2B5EF4-FFF2-40B4-BE49-F238E27FC236}">
                  <a16:creationId xmlns:a16="http://schemas.microsoft.com/office/drawing/2014/main" id="{6260C545-BF1C-4E57-8875-AC58993257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2900" y="1322388"/>
              <a:ext cx="3589338" cy="3217863"/>
            </a:xfrm>
            <a:prstGeom prst="rect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8" name="Rectangle 31">
              <a:extLst>
                <a:ext uri="{FF2B5EF4-FFF2-40B4-BE49-F238E27FC236}">
                  <a16:creationId xmlns:a16="http://schemas.microsoft.com/office/drawing/2014/main" id="{40340490-7335-4C3F-8AAF-B5B110598F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9049" y="4867543"/>
              <a:ext cx="767126" cy="2195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hreshold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" name="Rectangle 32">
              <a:extLst>
                <a:ext uri="{FF2B5EF4-FFF2-40B4-BE49-F238E27FC236}">
                  <a16:creationId xmlns:a16="http://schemas.microsoft.com/office/drawing/2014/main" id="{ABFD2318-C8F7-4544-88D2-9D249DD329F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98473" y="2839266"/>
              <a:ext cx="1633593" cy="2265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ensitivity/Specificity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" name="Freeform 33">
              <a:extLst>
                <a:ext uri="{FF2B5EF4-FFF2-40B4-BE49-F238E27FC236}">
                  <a16:creationId xmlns:a16="http://schemas.microsoft.com/office/drawing/2014/main" id="{F9282952-C801-453F-B620-5A3F2AC2762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749425" y="1446213"/>
              <a:ext cx="3322638" cy="2946400"/>
            </a:xfrm>
            <a:custGeom>
              <a:avLst/>
              <a:gdLst>
                <a:gd name="T0" fmla="*/ 2 w 513"/>
                <a:gd name="T1" fmla="*/ 447 h 455"/>
                <a:gd name="T2" fmla="*/ 11 w 513"/>
                <a:gd name="T3" fmla="*/ 431 h 455"/>
                <a:gd name="T4" fmla="*/ 12 w 513"/>
                <a:gd name="T5" fmla="*/ 415 h 455"/>
                <a:gd name="T6" fmla="*/ 17 w 513"/>
                <a:gd name="T7" fmla="*/ 402 h 455"/>
                <a:gd name="T8" fmla="*/ 22 w 513"/>
                <a:gd name="T9" fmla="*/ 390 h 455"/>
                <a:gd name="T10" fmla="*/ 25 w 513"/>
                <a:gd name="T11" fmla="*/ 379 h 455"/>
                <a:gd name="T12" fmla="*/ 27 w 513"/>
                <a:gd name="T13" fmla="*/ 363 h 455"/>
                <a:gd name="T14" fmla="*/ 29 w 513"/>
                <a:gd name="T15" fmla="*/ 356 h 455"/>
                <a:gd name="T16" fmla="*/ 31 w 513"/>
                <a:gd name="T17" fmla="*/ 340 h 455"/>
                <a:gd name="T18" fmla="*/ 35 w 513"/>
                <a:gd name="T19" fmla="*/ 330 h 455"/>
                <a:gd name="T20" fmla="*/ 37 w 513"/>
                <a:gd name="T21" fmla="*/ 318 h 455"/>
                <a:gd name="T22" fmla="*/ 38 w 513"/>
                <a:gd name="T23" fmla="*/ 306 h 455"/>
                <a:gd name="T24" fmla="*/ 40 w 513"/>
                <a:gd name="T25" fmla="*/ 290 h 455"/>
                <a:gd name="T26" fmla="*/ 46 w 513"/>
                <a:gd name="T27" fmla="*/ 278 h 455"/>
                <a:gd name="T28" fmla="*/ 49 w 513"/>
                <a:gd name="T29" fmla="*/ 263 h 455"/>
                <a:gd name="T30" fmla="*/ 51 w 513"/>
                <a:gd name="T31" fmla="*/ 247 h 455"/>
                <a:gd name="T32" fmla="*/ 53 w 513"/>
                <a:gd name="T33" fmla="*/ 235 h 455"/>
                <a:gd name="T34" fmla="*/ 58 w 513"/>
                <a:gd name="T35" fmla="*/ 219 h 455"/>
                <a:gd name="T36" fmla="*/ 63 w 513"/>
                <a:gd name="T37" fmla="*/ 211 h 455"/>
                <a:gd name="T38" fmla="*/ 66 w 513"/>
                <a:gd name="T39" fmla="*/ 199 h 455"/>
                <a:gd name="T40" fmla="*/ 69 w 513"/>
                <a:gd name="T41" fmla="*/ 188 h 455"/>
                <a:gd name="T42" fmla="*/ 69 w 513"/>
                <a:gd name="T43" fmla="*/ 176 h 455"/>
                <a:gd name="T44" fmla="*/ 70 w 513"/>
                <a:gd name="T45" fmla="*/ 160 h 455"/>
                <a:gd name="T46" fmla="*/ 73 w 513"/>
                <a:gd name="T47" fmla="*/ 149 h 455"/>
                <a:gd name="T48" fmla="*/ 82 w 513"/>
                <a:gd name="T49" fmla="*/ 137 h 455"/>
                <a:gd name="T50" fmla="*/ 92 w 513"/>
                <a:gd name="T51" fmla="*/ 134 h 455"/>
                <a:gd name="T52" fmla="*/ 97 w 513"/>
                <a:gd name="T53" fmla="*/ 118 h 455"/>
                <a:gd name="T54" fmla="*/ 101 w 513"/>
                <a:gd name="T55" fmla="*/ 107 h 455"/>
                <a:gd name="T56" fmla="*/ 106 w 513"/>
                <a:gd name="T57" fmla="*/ 92 h 455"/>
                <a:gd name="T58" fmla="*/ 110 w 513"/>
                <a:gd name="T59" fmla="*/ 80 h 455"/>
                <a:gd name="T60" fmla="*/ 125 w 513"/>
                <a:gd name="T61" fmla="*/ 69 h 455"/>
                <a:gd name="T62" fmla="*/ 130 w 513"/>
                <a:gd name="T63" fmla="*/ 57 h 455"/>
                <a:gd name="T64" fmla="*/ 142 w 513"/>
                <a:gd name="T65" fmla="*/ 52 h 455"/>
                <a:gd name="T66" fmla="*/ 149 w 513"/>
                <a:gd name="T67" fmla="*/ 45 h 455"/>
                <a:gd name="T68" fmla="*/ 155 w 513"/>
                <a:gd name="T69" fmla="*/ 34 h 455"/>
                <a:gd name="T70" fmla="*/ 171 w 513"/>
                <a:gd name="T71" fmla="*/ 27 h 455"/>
                <a:gd name="T72" fmla="*/ 183 w 513"/>
                <a:gd name="T73" fmla="*/ 23 h 455"/>
                <a:gd name="T74" fmla="*/ 199 w 513"/>
                <a:gd name="T75" fmla="*/ 23 h 455"/>
                <a:gd name="T76" fmla="*/ 215 w 513"/>
                <a:gd name="T77" fmla="*/ 23 h 455"/>
                <a:gd name="T78" fmla="*/ 231 w 513"/>
                <a:gd name="T79" fmla="*/ 23 h 455"/>
                <a:gd name="T80" fmla="*/ 247 w 513"/>
                <a:gd name="T81" fmla="*/ 23 h 455"/>
                <a:gd name="T82" fmla="*/ 263 w 513"/>
                <a:gd name="T83" fmla="*/ 23 h 455"/>
                <a:gd name="T84" fmla="*/ 275 w 513"/>
                <a:gd name="T85" fmla="*/ 23 h 455"/>
                <a:gd name="T86" fmla="*/ 288 w 513"/>
                <a:gd name="T87" fmla="*/ 11 h 455"/>
                <a:gd name="T88" fmla="*/ 300 w 513"/>
                <a:gd name="T89" fmla="*/ 11 h 455"/>
                <a:gd name="T90" fmla="*/ 316 w 513"/>
                <a:gd name="T91" fmla="*/ 11 h 455"/>
                <a:gd name="T92" fmla="*/ 328 w 513"/>
                <a:gd name="T93" fmla="*/ 11 h 455"/>
                <a:gd name="T94" fmla="*/ 344 w 513"/>
                <a:gd name="T95" fmla="*/ 11 h 455"/>
                <a:gd name="T96" fmla="*/ 360 w 513"/>
                <a:gd name="T97" fmla="*/ 11 h 455"/>
                <a:gd name="T98" fmla="*/ 376 w 513"/>
                <a:gd name="T99" fmla="*/ 11 h 455"/>
                <a:gd name="T100" fmla="*/ 392 w 513"/>
                <a:gd name="T101" fmla="*/ 11 h 455"/>
                <a:gd name="T102" fmla="*/ 408 w 513"/>
                <a:gd name="T103" fmla="*/ 11 h 455"/>
                <a:gd name="T104" fmla="*/ 424 w 513"/>
                <a:gd name="T105" fmla="*/ 11 h 455"/>
                <a:gd name="T106" fmla="*/ 440 w 513"/>
                <a:gd name="T107" fmla="*/ 9 h 455"/>
                <a:gd name="T108" fmla="*/ 456 w 513"/>
                <a:gd name="T109" fmla="*/ 7 h 455"/>
                <a:gd name="T110" fmla="*/ 472 w 513"/>
                <a:gd name="T111" fmla="*/ 5 h 455"/>
                <a:gd name="T112" fmla="*/ 488 w 513"/>
                <a:gd name="T113" fmla="*/ 3 h 455"/>
                <a:gd name="T114" fmla="*/ 504 w 513"/>
                <a:gd name="T115" fmla="*/ 1 h 4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</a:cxnLst>
              <a:rect l="0" t="0" r="r" b="b"/>
              <a:pathLst>
                <a:path w="513" h="455">
                  <a:moveTo>
                    <a:pt x="1" y="451"/>
                  </a:moveTo>
                  <a:lnTo>
                    <a:pt x="1" y="448"/>
                  </a:lnTo>
                  <a:lnTo>
                    <a:pt x="2" y="447"/>
                  </a:lnTo>
                  <a:moveTo>
                    <a:pt x="5" y="443"/>
                  </a:moveTo>
                  <a:lnTo>
                    <a:pt x="8" y="440"/>
                  </a:lnTo>
                  <a:moveTo>
                    <a:pt x="11" y="435"/>
                  </a:moveTo>
                  <a:lnTo>
                    <a:pt x="11" y="431"/>
                  </a:lnTo>
                  <a:moveTo>
                    <a:pt x="11" y="427"/>
                  </a:moveTo>
                  <a:lnTo>
                    <a:pt x="12" y="423"/>
                  </a:lnTo>
                  <a:moveTo>
                    <a:pt x="12" y="419"/>
                  </a:moveTo>
                  <a:lnTo>
                    <a:pt x="12" y="415"/>
                  </a:lnTo>
                  <a:moveTo>
                    <a:pt x="14" y="413"/>
                  </a:moveTo>
                  <a:lnTo>
                    <a:pt x="15" y="409"/>
                  </a:lnTo>
                  <a:moveTo>
                    <a:pt x="16" y="405"/>
                  </a:moveTo>
                  <a:lnTo>
                    <a:pt x="17" y="402"/>
                  </a:lnTo>
                  <a:lnTo>
                    <a:pt x="17" y="402"/>
                  </a:lnTo>
                  <a:moveTo>
                    <a:pt x="19" y="398"/>
                  </a:moveTo>
                  <a:lnTo>
                    <a:pt x="20" y="394"/>
                  </a:lnTo>
                  <a:moveTo>
                    <a:pt x="22" y="390"/>
                  </a:moveTo>
                  <a:lnTo>
                    <a:pt x="23" y="386"/>
                  </a:lnTo>
                  <a:moveTo>
                    <a:pt x="24" y="382"/>
                  </a:moveTo>
                  <a:lnTo>
                    <a:pt x="25" y="379"/>
                  </a:lnTo>
                  <a:lnTo>
                    <a:pt x="25" y="379"/>
                  </a:lnTo>
                  <a:moveTo>
                    <a:pt x="26" y="375"/>
                  </a:moveTo>
                  <a:lnTo>
                    <a:pt x="26" y="371"/>
                  </a:lnTo>
                  <a:moveTo>
                    <a:pt x="27" y="367"/>
                  </a:moveTo>
                  <a:lnTo>
                    <a:pt x="27" y="363"/>
                  </a:lnTo>
                  <a:moveTo>
                    <a:pt x="28" y="359"/>
                  </a:moveTo>
                  <a:lnTo>
                    <a:pt x="28" y="356"/>
                  </a:lnTo>
                  <a:lnTo>
                    <a:pt x="29" y="356"/>
                  </a:lnTo>
                  <a:lnTo>
                    <a:pt x="29" y="356"/>
                  </a:lnTo>
                  <a:moveTo>
                    <a:pt x="29" y="352"/>
                  </a:moveTo>
                  <a:lnTo>
                    <a:pt x="30" y="348"/>
                  </a:lnTo>
                  <a:moveTo>
                    <a:pt x="30" y="344"/>
                  </a:moveTo>
                  <a:lnTo>
                    <a:pt x="31" y="340"/>
                  </a:lnTo>
                  <a:moveTo>
                    <a:pt x="33" y="336"/>
                  </a:moveTo>
                  <a:lnTo>
                    <a:pt x="34" y="333"/>
                  </a:lnTo>
                  <a:lnTo>
                    <a:pt x="34" y="333"/>
                  </a:lnTo>
                  <a:moveTo>
                    <a:pt x="35" y="330"/>
                  </a:moveTo>
                  <a:lnTo>
                    <a:pt x="36" y="326"/>
                  </a:lnTo>
                  <a:moveTo>
                    <a:pt x="36" y="322"/>
                  </a:moveTo>
                  <a:lnTo>
                    <a:pt x="36" y="321"/>
                  </a:lnTo>
                  <a:lnTo>
                    <a:pt x="37" y="318"/>
                  </a:lnTo>
                  <a:moveTo>
                    <a:pt x="37" y="314"/>
                  </a:moveTo>
                  <a:lnTo>
                    <a:pt x="38" y="310"/>
                  </a:lnTo>
                  <a:lnTo>
                    <a:pt x="38" y="310"/>
                  </a:lnTo>
                  <a:moveTo>
                    <a:pt x="38" y="306"/>
                  </a:moveTo>
                  <a:lnTo>
                    <a:pt x="39" y="302"/>
                  </a:lnTo>
                  <a:moveTo>
                    <a:pt x="39" y="298"/>
                  </a:moveTo>
                  <a:lnTo>
                    <a:pt x="39" y="294"/>
                  </a:lnTo>
                  <a:moveTo>
                    <a:pt x="40" y="290"/>
                  </a:moveTo>
                  <a:lnTo>
                    <a:pt x="40" y="287"/>
                  </a:lnTo>
                  <a:lnTo>
                    <a:pt x="41" y="286"/>
                  </a:lnTo>
                  <a:moveTo>
                    <a:pt x="43" y="282"/>
                  </a:moveTo>
                  <a:lnTo>
                    <a:pt x="46" y="278"/>
                  </a:lnTo>
                  <a:moveTo>
                    <a:pt x="48" y="275"/>
                  </a:moveTo>
                  <a:lnTo>
                    <a:pt x="48" y="271"/>
                  </a:lnTo>
                  <a:moveTo>
                    <a:pt x="48" y="267"/>
                  </a:moveTo>
                  <a:lnTo>
                    <a:pt x="49" y="263"/>
                  </a:lnTo>
                  <a:moveTo>
                    <a:pt x="49" y="259"/>
                  </a:moveTo>
                  <a:lnTo>
                    <a:pt x="49" y="255"/>
                  </a:lnTo>
                  <a:moveTo>
                    <a:pt x="49" y="251"/>
                  </a:moveTo>
                  <a:lnTo>
                    <a:pt x="51" y="247"/>
                  </a:lnTo>
                  <a:moveTo>
                    <a:pt x="52" y="243"/>
                  </a:moveTo>
                  <a:lnTo>
                    <a:pt x="53" y="241"/>
                  </a:lnTo>
                  <a:lnTo>
                    <a:pt x="53" y="239"/>
                  </a:lnTo>
                  <a:moveTo>
                    <a:pt x="53" y="235"/>
                  </a:moveTo>
                  <a:lnTo>
                    <a:pt x="54" y="231"/>
                  </a:lnTo>
                  <a:moveTo>
                    <a:pt x="55" y="227"/>
                  </a:moveTo>
                  <a:lnTo>
                    <a:pt x="56" y="223"/>
                  </a:lnTo>
                  <a:moveTo>
                    <a:pt x="58" y="219"/>
                  </a:moveTo>
                  <a:lnTo>
                    <a:pt x="58" y="218"/>
                  </a:lnTo>
                  <a:lnTo>
                    <a:pt x="61" y="218"/>
                  </a:lnTo>
                  <a:moveTo>
                    <a:pt x="62" y="215"/>
                  </a:moveTo>
                  <a:lnTo>
                    <a:pt x="63" y="211"/>
                  </a:lnTo>
                  <a:moveTo>
                    <a:pt x="64" y="207"/>
                  </a:moveTo>
                  <a:lnTo>
                    <a:pt x="64" y="206"/>
                  </a:lnTo>
                  <a:lnTo>
                    <a:pt x="65" y="203"/>
                  </a:lnTo>
                  <a:moveTo>
                    <a:pt x="66" y="199"/>
                  </a:moveTo>
                  <a:lnTo>
                    <a:pt x="67" y="195"/>
                  </a:lnTo>
                  <a:lnTo>
                    <a:pt x="67" y="195"/>
                  </a:lnTo>
                  <a:moveTo>
                    <a:pt x="68" y="192"/>
                  </a:moveTo>
                  <a:lnTo>
                    <a:pt x="69" y="188"/>
                  </a:lnTo>
                  <a:moveTo>
                    <a:pt x="69" y="184"/>
                  </a:moveTo>
                  <a:lnTo>
                    <a:pt x="69" y="183"/>
                  </a:lnTo>
                  <a:lnTo>
                    <a:pt x="69" y="180"/>
                  </a:lnTo>
                  <a:moveTo>
                    <a:pt x="69" y="176"/>
                  </a:moveTo>
                  <a:lnTo>
                    <a:pt x="69" y="172"/>
                  </a:lnTo>
                  <a:moveTo>
                    <a:pt x="70" y="168"/>
                  </a:moveTo>
                  <a:lnTo>
                    <a:pt x="70" y="164"/>
                  </a:lnTo>
                  <a:moveTo>
                    <a:pt x="70" y="160"/>
                  </a:moveTo>
                  <a:lnTo>
                    <a:pt x="71" y="156"/>
                  </a:lnTo>
                  <a:moveTo>
                    <a:pt x="72" y="152"/>
                  </a:moveTo>
                  <a:lnTo>
                    <a:pt x="73" y="149"/>
                  </a:lnTo>
                  <a:lnTo>
                    <a:pt x="73" y="149"/>
                  </a:lnTo>
                  <a:moveTo>
                    <a:pt x="76" y="148"/>
                  </a:moveTo>
                  <a:lnTo>
                    <a:pt x="78" y="144"/>
                  </a:lnTo>
                  <a:moveTo>
                    <a:pt x="80" y="140"/>
                  </a:moveTo>
                  <a:lnTo>
                    <a:pt x="82" y="137"/>
                  </a:lnTo>
                  <a:lnTo>
                    <a:pt x="82" y="137"/>
                  </a:lnTo>
                  <a:moveTo>
                    <a:pt x="86" y="137"/>
                  </a:moveTo>
                  <a:lnTo>
                    <a:pt x="90" y="137"/>
                  </a:lnTo>
                  <a:moveTo>
                    <a:pt x="92" y="134"/>
                  </a:moveTo>
                  <a:lnTo>
                    <a:pt x="93" y="130"/>
                  </a:lnTo>
                  <a:moveTo>
                    <a:pt x="94" y="126"/>
                  </a:moveTo>
                  <a:lnTo>
                    <a:pt x="95" y="122"/>
                  </a:lnTo>
                  <a:moveTo>
                    <a:pt x="97" y="118"/>
                  </a:moveTo>
                  <a:lnTo>
                    <a:pt x="98" y="115"/>
                  </a:lnTo>
                  <a:lnTo>
                    <a:pt x="98" y="115"/>
                  </a:lnTo>
                  <a:moveTo>
                    <a:pt x="99" y="111"/>
                  </a:moveTo>
                  <a:lnTo>
                    <a:pt x="101" y="107"/>
                  </a:lnTo>
                  <a:moveTo>
                    <a:pt x="102" y="103"/>
                  </a:moveTo>
                  <a:lnTo>
                    <a:pt x="104" y="99"/>
                  </a:lnTo>
                  <a:moveTo>
                    <a:pt x="105" y="95"/>
                  </a:moveTo>
                  <a:lnTo>
                    <a:pt x="106" y="92"/>
                  </a:lnTo>
                  <a:lnTo>
                    <a:pt x="106" y="92"/>
                  </a:lnTo>
                  <a:moveTo>
                    <a:pt x="107" y="88"/>
                  </a:moveTo>
                  <a:lnTo>
                    <a:pt x="109" y="84"/>
                  </a:lnTo>
                  <a:moveTo>
                    <a:pt x="110" y="80"/>
                  </a:moveTo>
                  <a:lnTo>
                    <a:pt x="114" y="77"/>
                  </a:lnTo>
                  <a:moveTo>
                    <a:pt x="118" y="74"/>
                  </a:moveTo>
                  <a:lnTo>
                    <a:pt x="122" y="71"/>
                  </a:lnTo>
                  <a:moveTo>
                    <a:pt x="125" y="69"/>
                  </a:moveTo>
                  <a:lnTo>
                    <a:pt x="127" y="65"/>
                  </a:lnTo>
                  <a:moveTo>
                    <a:pt x="128" y="61"/>
                  </a:moveTo>
                  <a:lnTo>
                    <a:pt x="130" y="57"/>
                  </a:lnTo>
                  <a:lnTo>
                    <a:pt x="130" y="57"/>
                  </a:lnTo>
                  <a:moveTo>
                    <a:pt x="134" y="57"/>
                  </a:moveTo>
                  <a:lnTo>
                    <a:pt x="138" y="57"/>
                  </a:lnTo>
                  <a:moveTo>
                    <a:pt x="141" y="56"/>
                  </a:moveTo>
                  <a:lnTo>
                    <a:pt x="142" y="52"/>
                  </a:lnTo>
                  <a:moveTo>
                    <a:pt x="143" y="48"/>
                  </a:moveTo>
                  <a:lnTo>
                    <a:pt x="144" y="46"/>
                  </a:lnTo>
                  <a:lnTo>
                    <a:pt x="146" y="46"/>
                  </a:lnTo>
                  <a:moveTo>
                    <a:pt x="149" y="45"/>
                  </a:moveTo>
                  <a:lnTo>
                    <a:pt x="151" y="41"/>
                  </a:lnTo>
                  <a:moveTo>
                    <a:pt x="153" y="37"/>
                  </a:moveTo>
                  <a:lnTo>
                    <a:pt x="155" y="34"/>
                  </a:lnTo>
                  <a:lnTo>
                    <a:pt x="155" y="34"/>
                  </a:lnTo>
                  <a:moveTo>
                    <a:pt x="159" y="32"/>
                  </a:moveTo>
                  <a:lnTo>
                    <a:pt x="163" y="30"/>
                  </a:lnTo>
                  <a:moveTo>
                    <a:pt x="167" y="29"/>
                  </a:moveTo>
                  <a:lnTo>
                    <a:pt x="171" y="27"/>
                  </a:lnTo>
                  <a:moveTo>
                    <a:pt x="175" y="25"/>
                  </a:moveTo>
                  <a:lnTo>
                    <a:pt x="179" y="23"/>
                  </a:lnTo>
                  <a:lnTo>
                    <a:pt x="179" y="23"/>
                  </a:lnTo>
                  <a:moveTo>
                    <a:pt x="183" y="23"/>
                  </a:moveTo>
                  <a:lnTo>
                    <a:pt x="187" y="23"/>
                  </a:lnTo>
                  <a:moveTo>
                    <a:pt x="191" y="23"/>
                  </a:moveTo>
                  <a:lnTo>
                    <a:pt x="195" y="23"/>
                  </a:lnTo>
                  <a:moveTo>
                    <a:pt x="199" y="23"/>
                  </a:moveTo>
                  <a:lnTo>
                    <a:pt x="203" y="23"/>
                  </a:lnTo>
                  <a:moveTo>
                    <a:pt x="207" y="23"/>
                  </a:moveTo>
                  <a:lnTo>
                    <a:pt x="211" y="23"/>
                  </a:lnTo>
                  <a:moveTo>
                    <a:pt x="215" y="23"/>
                  </a:moveTo>
                  <a:lnTo>
                    <a:pt x="219" y="23"/>
                  </a:lnTo>
                  <a:moveTo>
                    <a:pt x="223" y="23"/>
                  </a:moveTo>
                  <a:lnTo>
                    <a:pt x="227" y="23"/>
                  </a:lnTo>
                  <a:moveTo>
                    <a:pt x="231" y="23"/>
                  </a:moveTo>
                  <a:lnTo>
                    <a:pt x="235" y="23"/>
                  </a:lnTo>
                  <a:moveTo>
                    <a:pt x="239" y="23"/>
                  </a:moveTo>
                  <a:lnTo>
                    <a:pt x="243" y="23"/>
                  </a:lnTo>
                  <a:moveTo>
                    <a:pt x="247" y="23"/>
                  </a:moveTo>
                  <a:lnTo>
                    <a:pt x="251" y="23"/>
                  </a:lnTo>
                  <a:moveTo>
                    <a:pt x="255" y="23"/>
                  </a:moveTo>
                  <a:lnTo>
                    <a:pt x="259" y="23"/>
                  </a:lnTo>
                  <a:moveTo>
                    <a:pt x="263" y="23"/>
                  </a:moveTo>
                  <a:lnTo>
                    <a:pt x="267" y="23"/>
                  </a:lnTo>
                  <a:moveTo>
                    <a:pt x="271" y="23"/>
                  </a:moveTo>
                  <a:lnTo>
                    <a:pt x="275" y="23"/>
                  </a:lnTo>
                  <a:lnTo>
                    <a:pt x="275" y="23"/>
                  </a:lnTo>
                  <a:moveTo>
                    <a:pt x="278" y="20"/>
                  </a:moveTo>
                  <a:lnTo>
                    <a:pt x="281" y="17"/>
                  </a:lnTo>
                  <a:moveTo>
                    <a:pt x="285" y="14"/>
                  </a:moveTo>
                  <a:lnTo>
                    <a:pt x="288" y="11"/>
                  </a:lnTo>
                  <a:lnTo>
                    <a:pt x="288" y="11"/>
                  </a:lnTo>
                  <a:moveTo>
                    <a:pt x="292" y="11"/>
                  </a:moveTo>
                  <a:lnTo>
                    <a:pt x="296" y="11"/>
                  </a:lnTo>
                  <a:moveTo>
                    <a:pt x="300" y="11"/>
                  </a:moveTo>
                  <a:lnTo>
                    <a:pt x="304" y="11"/>
                  </a:lnTo>
                  <a:moveTo>
                    <a:pt x="308" y="11"/>
                  </a:moveTo>
                  <a:lnTo>
                    <a:pt x="312" y="11"/>
                  </a:lnTo>
                  <a:moveTo>
                    <a:pt x="316" y="11"/>
                  </a:moveTo>
                  <a:lnTo>
                    <a:pt x="317" y="11"/>
                  </a:lnTo>
                  <a:lnTo>
                    <a:pt x="320" y="11"/>
                  </a:lnTo>
                  <a:moveTo>
                    <a:pt x="324" y="11"/>
                  </a:moveTo>
                  <a:lnTo>
                    <a:pt x="328" y="11"/>
                  </a:lnTo>
                  <a:moveTo>
                    <a:pt x="332" y="11"/>
                  </a:moveTo>
                  <a:lnTo>
                    <a:pt x="336" y="11"/>
                  </a:lnTo>
                  <a:moveTo>
                    <a:pt x="340" y="11"/>
                  </a:moveTo>
                  <a:lnTo>
                    <a:pt x="344" y="11"/>
                  </a:lnTo>
                  <a:moveTo>
                    <a:pt x="348" y="11"/>
                  </a:moveTo>
                  <a:lnTo>
                    <a:pt x="352" y="11"/>
                  </a:lnTo>
                  <a:moveTo>
                    <a:pt x="356" y="11"/>
                  </a:moveTo>
                  <a:lnTo>
                    <a:pt x="360" y="11"/>
                  </a:lnTo>
                  <a:moveTo>
                    <a:pt x="364" y="11"/>
                  </a:moveTo>
                  <a:lnTo>
                    <a:pt x="368" y="11"/>
                  </a:lnTo>
                  <a:moveTo>
                    <a:pt x="372" y="11"/>
                  </a:moveTo>
                  <a:lnTo>
                    <a:pt x="376" y="11"/>
                  </a:lnTo>
                  <a:moveTo>
                    <a:pt x="380" y="11"/>
                  </a:moveTo>
                  <a:lnTo>
                    <a:pt x="384" y="11"/>
                  </a:lnTo>
                  <a:moveTo>
                    <a:pt x="388" y="11"/>
                  </a:moveTo>
                  <a:lnTo>
                    <a:pt x="392" y="11"/>
                  </a:lnTo>
                  <a:moveTo>
                    <a:pt x="396" y="11"/>
                  </a:moveTo>
                  <a:lnTo>
                    <a:pt x="400" y="11"/>
                  </a:lnTo>
                  <a:moveTo>
                    <a:pt x="404" y="11"/>
                  </a:moveTo>
                  <a:lnTo>
                    <a:pt x="408" y="11"/>
                  </a:lnTo>
                  <a:moveTo>
                    <a:pt x="412" y="11"/>
                  </a:moveTo>
                  <a:lnTo>
                    <a:pt x="416" y="11"/>
                  </a:lnTo>
                  <a:moveTo>
                    <a:pt x="420" y="11"/>
                  </a:moveTo>
                  <a:lnTo>
                    <a:pt x="424" y="11"/>
                  </a:lnTo>
                  <a:moveTo>
                    <a:pt x="428" y="11"/>
                  </a:moveTo>
                  <a:lnTo>
                    <a:pt x="432" y="10"/>
                  </a:lnTo>
                  <a:moveTo>
                    <a:pt x="436" y="10"/>
                  </a:moveTo>
                  <a:lnTo>
                    <a:pt x="440" y="9"/>
                  </a:lnTo>
                  <a:moveTo>
                    <a:pt x="444" y="9"/>
                  </a:moveTo>
                  <a:lnTo>
                    <a:pt x="448" y="8"/>
                  </a:lnTo>
                  <a:moveTo>
                    <a:pt x="452" y="8"/>
                  </a:moveTo>
                  <a:lnTo>
                    <a:pt x="456" y="7"/>
                  </a:lnTo>
                  <a:moveTo>
                    <a:pt x="460" y="7"/>
                  </a:moveTo>
                  <a:lnTo>
                    <a:pt x="464" y="6"/>
                  </a:lnTo>
                  <a:moveTo>
                    <a:pt x="468" y="6"/>
                  </a:moveTo>
                  <a:lnTo>
                    <a:pt x="472" y="5"/>
                  </a:lnTo>
                  <a:moveTo>
                    <a:pt x="476" y="5"/>
                  </a:moveTo>
                  <a:lnTo>
                    <a:pt x="480" y="4"/>
                  </a:lnTo>
                  <a:moveTo>
                    <a:pt x="484" y="4"/>
                  </a:moveTo>
                  <a:lnTo>
                    <a:pt x="488" y="3"/>
                  </a:lnTo>
                  <a:moveTo>
                    <a:pt x="492" y="3"/>
                  </a:moveTo>
                  <a:lnTo>
                    <a:pt x="496" y="2"/>
                  </a:lnTo>
                  <a:moveTo>
                    <a:pt x="500" y="2"/>
                  </a:moveTo>
                  <a:lnTo>
                    <a:pt x="504" y="1"/>
                  </a:lnTo>
                  <a:moveTo>
                    <a:pt x="508" y="1"/>
                  </a:moveTo>
                  <a:lnTo>
                    <a:pt x="512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" name="Line 34">
              <a:extLst>
                <a:ext uri="{FF2B5EF4-FFF2-40B4-BE49-F238E27FC236}">
                  <a16:creationId xmlns:a16="http://schemas.microsoft.com/office/drawing/2014/main" id="{5ED61C0B-CA3C-4FDB-AFDB-F864169A25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30375" y="4540251"/>
              <a:ext cx="327660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" name="Line 35">
              <a:extLst>
                <a:ext uri="{FF2B5EF4-FFF2-40B4-BE49-F238E27FC236}">
                  <a16:creationId xmlns:a16="http://schemas.microsoft.com/office/drawing/2014/main" id="{02A6B45D-757D-4946-8786-A455B7A648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30375" y="4540251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" name="Line 36">
              <a:extLst>
                <a:ext uri="{FF2B5EF4-FFF2-40B4-BE49-F238E27FC236}">
                  <a16:creationId xmlns:a16="http://schemas.microsoft.com/office/drawing/2014/main" id="{A71CF0BB-D6B2-430A-92C3-7DD8144026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52700" y="4540251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" name="Line 37">
              <a:extLst>
                <a:ext uri="{FF2B5EF4-FFF2-40B4-BE49-F238E27FC236}">
                  <a16:creationId xmlns:a16="http://schemas.microsoft.com/office/drawing/2014/main" id="{58557F9A-8FFA-44CE-81AE-854FFFF4F6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68675" y="4540251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" name="Line 38">
              <a:extLst>
                <a:ext uri="{FF2B5EF4-FFF2-40B4-BE49-F238E27FC236}">
                  <a16:creationId xmlns:a16="http://schemas.microsoft.com/office/drawing/2014/main" id="{099B2088-183D-4A8C-B2F3-AC0874D7951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84650" y="4540251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" name="Line 39">
              <a:extLst>
                <a:ext uri="{FF2B5EF4-FFF2-40B4-BE49-F238E27FC236}">
                  <a16:creationId xmlns:a16="http://schemas.microsoft.com/office/drawing/2014/main" id="{2177D844-8CDE-4DAE-B087-F7B03778AD2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06975" y="4540251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" name="Rectangle 40">
              <a:extLst>
                <a:ext uri="{FF2B5EF4-FFF2-40B4-BE49-F238E27FC236}">
                  <a16:creationId xmlns:a16="http://schemas.microsoft.com/office/drawing/2014/main" id="{A40F1400-77DC-45BE-86F9-279D50429C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3226" y="4676775"/>
              <a:ext cx="94415" cy="219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" name="Rectangle 41">
              <a:extLst>
                <a:ext uri="{FF2B5EF4-FFF2-40B4-BE49-F238E27FC236}">
                  <a16:creationId xmlns:a16="http://schemas.microsoft.com/office/drawing/2014/main" id="{CFE7AFE9-76E7-434C-8245-5F05D1161C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2213" y="4676775"/>
              <a:ext cx="188831" cy="219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" name="Rectangle 42">
              <a:extLst>
                <a:ext uri="{FF2B5EF4-FFF2-40B4-BE49-F238E27FC236}">
                  <a16:creationId xmlns:a16="http://schemas.microsoft.com/office/drawing/2014/main" id="{1235CB73-4621-4805-91B7-F4B2F2B018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78188" y="4676775"/>
              <a:ext cx="188831" cy="219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" name="Rectangle 43">
              <a:extLst>
                <a:ext uri="{FF2B5EF4-FFF2-40B4-BE49-F238E27FC236}">
                  <a16:creationId xmlns:a16="http://schemas.microsoft.com/office/drawing/2014/main" id="{68C9BBE1-C356-41D1-96BD-9FA580D937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94163" y="4676775"/>
              <a:ext cx="188831" cy="219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Rectangle 44">
              <a:extLst>
                <a:ext uri="{FF2B5EF4-FFF2-40B4-BE49-F238E27FC236}">
                  <a16:creationId xmlns:a16="http://schemas.microsoft.com/office/drawing/2014/main" id="{EDEA3FCA-4E73-44E3-B422-2AA07DF470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6488" y="4676775"/>
              <a:ext cx="804501" cy="219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r>
                <a:rPr kumimoji="0" lang="ja-JP" alt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mg/dl)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2" name="Line 45">
              <a:extLst>
                <a:ext uri="{FF2B5EF4-FFF2-40B4-BE49-F238E27FC236}">
                  <a16:creationId xmlns:a16="http://schemas.microsoft.com/office/drawing/2014/main" id="{57A30EF0-5A21-4616-A83C-6DAD3ED17F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12900" y="1446213"/>
              <a:ext cx="0" cy="297180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3" name="Line 46">
              <a:extLst>
                <a:ext uri="{FF2B5EF4-FFF2-40B4-BE49-F238E27FC236}">
                  <a16:creationId xmlns:a16="http://schemas.microsoft.com/office/drawing/2014/main" id="{ECD25F24-9AA5-4E88-A01D-98A49EF4C7A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55750" y="4418013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4" name="Line 47">
              <a:extLst>
                <a:ext uri="{FF2B5EF4-FFF2-40B4-BE49-F238E27FC236}">
                  <a16:creationId xmlns:a16="http://schemas.microsoft.com/office/drawing/2014/main" id="{0ACAF919-128F-4F3E-8D41-5AC45F70C7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55750" y="3822701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5" name="Line 48">
              <a:extLst>
                <a:ext uri="{FF2B5EF4-FFF2-40B4-BE49-F238E27FC236}">
                  <a16:creationId xmlns:a16="http://schemas.microsoft.com/office/drawing/2014/main" id="{3768230A-E3CF-41FC-A27C-E5433D7AA1F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55750" y="3225801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6" name="Line 49">
              <a:extLst>
                <a:ext uri="{FF2B5EF4-FFF2-40B4-BE49-F238E27FC236}">
                  <a16:creationId xmlns:a16="http://schemas.microsoft.com/office/drawing/2014/main" id="{0967430D-7A99-4DCD-8942-8649EA7E3E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55750" y="2630488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7" name="Line 50">
              <a:extLst>
                <a:ext uri="{FF2B5EF4-FFF2-40B4-BE49-F238E27FC236}">
                  <a16:creationId xmlns:a16="http://schemas.microsoft.com/office/drawing/2014/main" id="{011DC5B6-3952-4F7F-A01C-49E7514D1D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55750" y="2041526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8" name="Line 51">
              <a:extLst>
                <a:ext uri="{FF2B5EF4-FFF2-40B4-BE49-F238E27FC236}">
                  <a16:creationId xmlns:a16="http://schemas.microsoft.com/office/drawing/2014/main" id="{31D607D8-0405-45A4-A23A-E81B628277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55750" y="1446213"/>
              <a:ext cx="5715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9" name="Rectangle 52">
              <a:extLst>
                <a:ext uri="{FF2B5EF4-FFF2-40B4-BE49-F238E27FC236}">
                  <a16:creationId xmlns:a16="http://schemas.microsoft.com/office/drawing/2014/main" id="{1056591F-8B1E-4F41-A3A2-45766B7226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6351" y="4378326"/>
              <a:ext cx="236039" cy="219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0" name="Rectangle 53">
              <a:extLst>
                <a:ext uri="{FF2B5EF4-FFF2-40B4-BE49-F238E27FC236}">
                  <a16:creationId xmlns:a16="http://schemas.microsoft.com/office/drawing/2014/main" id="{63FB58E2-3D02-40F9-8784-EC858BF10D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6351" y="3783013"/>
              <a:ext cx="236039" cy="219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1" name="Rectangle 54">
              <a:extLst>
                <a:ext uri="{FF2B5EF4-FFF2-40B4-BE49-F238E27FC236}">
                  <a16:creationId xmlns:a16="http://schemas.microsoft.com/office/drawing/2014/main" id="{E349A022-4651-4D33-9591-A0947CDF04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6351" y="3187701"/>
              <a:ext cx="236039" cy="219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2" name="Rectangle 55">
              <a:extLst>
                <a:ext uri="{FF2B5EF4-FFF2-40B4-BE49-F238E27FC236}">
                  <a16:creationId xmlns:a16="http://schemas.microsoft.com/office/drawing/2014/main" id="{095435D3-5DF4-46B1-9F7E-BD9709DB95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6351" y="2592387"/>
              <a:ext cx="236039" cy="219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3" name="Rectangle 56">
              <a:extLst>
                <a:ext uri="{FF2B5EF4-FFF2-40B4-BE49-F238E27FC236}">
                  <a16:creationId xmlns:a16="http://schemas.microsoft.com/office/drawing/2014/main" id="{7BBB7D74-E4D6-40CB-9E41-364CC2169E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6351" y="1995488"/>
              <a:ext cx="236039" cy="219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" name="Rectangle 57">
              <a:extLst>
                <a:ext uri="{FF2B5EF4-FFF2-40B4-BE49-F238E27FC236}">
                  <a16:creationId xmlns:a16="http://schemas.microsoft.com/office/drawing/2014/main" id="{477E84C9-486F-4CFE-B3DA-06EB4CCCD6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6351" y="1400176"/>
              <a:ext cx="236039" cy="219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" name="Rectangle 58">
              <a:extLst>
                <a:ext uri="{FF2B5EF4-FFF2-40B4-BE49-F238E27FC236}">
                  <a16:creationId xmlns:a16="http://schemas.microsoft.com/office/drawing/2014/main" id="{633F97A4-7DD3-4492-9260-96C23801F3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2900" y="1322388"/>
              <a:ext cx="3589338" cy="3217863"/>
            </a:xfrm>
            <a:prstGeom prst="rect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" name="Line 59">
              <a:extLst>
                <a:ext uri="{FF2B5EF4-FFF2-40B4-BE49-F238E27FC236}">
                  <a16:creationId xmlns:a16="http://schemas.microsoft.com/office/drawing/2014/main" id="{73B9F9BC-61F7-46B1-899D-F7C03AFAAC2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03047" y="4432211"/>
              <a:ext cx="18732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" name="Freeform 60">
              <a:extLst>
                <a:ext uri="{FF2B5EF4-FFF2-40B4-BE49-F238E27FC236}">
                  <a16:creationId xmlns:a16="http://schemas.microsoft.com/office/drawing/2014/main" id="{A43CC6CB-2164-47B8-9361-B653A63AD6AC}"/>
                </a:ext>
              </a:extLst>
            </p:cNvPr>
            <p:cNvSpPr>
              <a:spLocks noEditPoints="1"/>
            </p:cNvSpPr>
            <p:nvPr/>
          </p:nvSpPr>
          <p:spPr bwMode="auto">
            <a:xfrm flipV="1">
              <a:off x="3053137" y="4386493"/>
              <a:ext cx="193497" cy="45719"/>
            </a:xfrm>
            <a:custGeom>
              <a:avLst/>
              <a:gdLst>
                <a:gd name="T0" fmla="*/ 0 w 25"/>
                <a:gd name="T1" fmla="*/ 4 w 25"/>
                <a:gd name="T2" fmla="*/ 8 w 25"/>
                <a:gd name="T3" fmla="*/ 12 w 25"/>
                <a:gd name="T4" fmla="*/ 16 w 25"/>
                <a:gd name="T5" fmla="*/ 20 w 25"/>
                <a:gd name="T6" fmla="*/ 24 w 2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</a:cxnLst>
              <a:rect l="0" t="0" r="r" b="b"/>
              <a:pathLst>
                <a:path w="25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" name="Rectangle 61">
              <a:extLst>
                <a:ext uri="{FF2B5EF4-FFF2-40B4-BE49-F238E27FC236}">
                  <a16:creationId xmlns:a16="http://schemas.microsoft.com/office/drawing/2014/main" id="{2008E0AC-16BE-40C3-9ED7-C5011B055A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7905" y="4341154"/>
              <a:ext cx="810400" cy="219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ensitivity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" name="Rectangle 62">
              <a:extLst>
                <a:ext uri="{FF2B5EF4-FFF2-40B4-BE49-F238E27FC236}">
                  <a16:creationId xmlns:a16="http://schemas.microsoft.com/office/drawing/2014/main" id="{A47AE0C3-9741-4A0D-A61E-793F1646D1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1028" y="4330879"/>
              <a:ext cx="822202" cy="219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ecificity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50" name="テキスト ボックス 249">
            <a:extLst>
              <a:ext uri="{FF2B5EF4-FFF2-40B4-BE49-F238E27FC236}">
                <a16:creationId xmlns:a16="http://schemas.microsoft.com/office/drawing/2014/main" id="{1DF1CC7D-5463-4BB1-ADDB-0620595A8376}"/>
              </a:ext>
            </a:extLst>
          </p:cNvPr>
          <p:cNvSpPr txBox="1"/>
          <p:nvPr/>
        </p:nvSpPr>
        <p:spPr>
          <a:xfrm>
            <a:off x="575035" y="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1" name="テキスト ボックス 250">
            <a:extLst>
              <a:ext uri="{FF2B5EF4-FFF2-40B4-BE49-F238E27FC236}">
                <a16:creationId xmlns:a16="http://schemas.microsoft.com/office/drawing/2014/main" id="{C324AE66-FC39-469A-84A6-D98498347746}"/>
              </a:ext>
            </a:extLst>
          </p:cNvPr>
          <p:cNvSpPr txBox="1"/>
          <p:nvPr/>
        </p:nvSpPr>
        <p:spPr>
          <a:xfrm>
            <a:off x="4337900" y="0"/>
            <a:ext cx="393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2" name="テキスト ボックス 251">
            <a:extLst>
              <a:ext uri="{FF2B5EF4-FFF2-40B4-BE49-F238E27FC236}">
                <a16:creationId xmlns:a16="http://schemas.microsoft.com/office/drawing/2014/main" id="{0A6B1FE5-FAF7-49C7-B95B-9A00B3123C20}"/>
              </a:ext>
            </a:extLst>
          </p:cNvPr>
          <p:cNvSpPr txBox="1"/>
          <p:nvPr/>
        </p:nvSpPr>
        <p:spPr>
          <a:xfrm>
            <a:off x="672446" y="333562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3" name="テキスト ボックス 252">
            <a:extLst>
              <a:ext uri="{FF2B5EF4-FFF2-40B4-BE49-F238E27FC236}">
                <a16:creationId xmlns:a16="http://schemas.microsoft.com/office/drawing/2014/main" id="{4D269802-83BE-4161-8FF8-03BA1BE58D15}"/>
              </a:ext>
            </a:extLst>
          </p:cNvPr>
          <p:cNvSpPr txBox="1"/>
          <p:nvPr/>
        </p:nvSpPr>
        <p:spPr>
          <a:xfrm>
            <a:off x="4347328" y="3337676"/>
            <a:ext cx="393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48178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</TotalTime>
  <Words>120</Words>
  <Application>Microsoft Office PowerPoint</Application>
  <PresentationFormat>画面に合わせる (4:3)</PresentationFormat>
  <Paragraphs>8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関谷紀貴</dc:creator>
  <cp:lastModifiedBy>関谷紀貴</cp:lastModifiedBy>
  <cp:revision>3</cp:revision>
  <dcterms:created xsi:type="dcterms:W3CDTF">2017-08-02T06:07:13Z</dcterms:created>
  <dcterms:modified xsi:type="dcterms:W3CDTF">2017-09-13T05:17:48Z</dcterms:modified>
</cp:coreProperties>
</file>